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9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649778C-4075-5D2B-6ED3-1134E6C6BB9A}" v="85" dt="2023-12-19T02:34:34.988"/>
    <p1510:client id="{319986E6-B82C-F8E0-F9B1-F9D4B4D0119D}" v="229" vWet="244" dt="2023-12-19T02:42:44.034"/>
    <p1510:client id="{64256F12-2289-5549-81F4-B77BBE3D9D97}" v="456" dt="2023-12-19T02:58:16.414"/>
    <p1510:client id="{67A63A88-7D7A-7647-9E34-31F962E7FC9C}" v="1327" dt="2023-12-19T02:05:28.801"/>
    <p1510:client id="{7473EA1C-E13E-A350-69BC-470D0ADE5241}" v="61" dt="2023-12-18T23:13:07.904"/>
    <p1510:client id="{88860C14-5978-FDB5-18B7-B1720FE417D7}" v="2" dt="2023-12-19T02:26:38.138"/>
    <p1510:client id="{9B6D1C0C-DC95-057C-039A-6F5E2DF5C2B9}" v="1" dt="2023-12-19T01:15:10.5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a Ochoa" userId="S::locho016@fiu.edu::59124860-347a-40b0-a9d2-c7a2e55c2f94" providerId="AD" clId="Web-{88860C14-5978-FDB5-18B7-B1720FE417D7}"/>
    <pc:docChg chg="delSld">
      <pc:chgData name="Laura Ochoa" userId="S::locho016@fiu.edu::59124860-347a-40b0-a9d2-c7a2e55c2f94" providerId="AD" clId="Web-{88860C14-5978-FDB5-18B7-B1720FE417D7}" dt="2023-12-19T02:26:38.138" v="1"/>
      <pc:docMkLst>
        <pc:docMk/>
      </pc:docMkLst>
      <pc:sldChg chg="del">
        <pc:chgData name="Laura Ochoa" userId="S::locho016@fiu.edu::59124860-347a-40b0-a9d2-c7a2e55c2f94" providerId="AD" clId="Web-{88860C14-5978-FDB5-18B7-B1720FE417D7}" dt="2023-12-19T02:26:38.138" v="1"/>
        <pc:sldMkLst>
          <pc:docMk/>
          <pc:sldMk cId="3958759317" sldId="265"/>
        </pc:sldMkLst>
      </pc:sldChg>
      <pc:sldChg chg="del">
        <pc:chgData name="Laura Ochoa" userId="S::locho016@fiu.edu::59124860-347a-40b0-a9d2-c7a2e55c2f94" providerId="AD" clId="Web-{88860C14-5978-FDB5-18B7-B1720FE417D7}" dt="2023-12-19T02:26:36.388" v="0"/>
        <pc:sldMkLst>
          <pc:docMk/>
          <pc:sldMk cId="2920808942" sldId="267"/>
        </pc:sldMkLst>
      </pc:sldChg>
    </pc:docChg>
  </pc:docChgLst>
  <pc:docChgLst>
    <pc:chgData name="Laura Ochoa" userId="S::locho016@fiu.edu::59124860-347a-40b0-a9d2-c7a2e55c2f94" providerId="AD" clId="Web-{9B6D1C0C-DC95-057C-039A-6F5E2DF5C2B9}"/>
    <pc:docChg chg="delSld">
      <pc:chgData name="Laura Ochoa" userId="S::locho016@fiu.edu::59124860-347a-40b0-a9d2-c7a2e55c2f94" providerId="AD" clId="Web-{9B6D1C0C-DC95-057C-039A-6F5E2DF5C2B9}" dt="2023-12-19T01:15:10.574" v="0"/>
      <pc:docMkLst>
        <pc:docMk/>
      </pc:docMkLst>
      <pc:sldChg chg="del">
        <pc:chgData name="Laura Ochoa" userId="S::locho016@fiu.edu::59124860-347a-40b0-a9d2-c7a2e55c2f94" providerId="AD" clId="Web-{9B6D1C0C-DC95-057C-039A-6F5E2DF5C2B9}" dt="2023-12-19T01:15:10.574" v="0"/>
        <pc:sldMkLst>
          <pc:docMk/>
          <pc:sldMk cId="150878583" sldId="262"/>
        </pc:sldMkLst>
      </pc:sldChg>
    </pc:docChg>
  </pc:docChgLst>
  <pc:docChgLst>
    <pc:chgData name="Laura Ochoa" userId="S::locho016@fiu.edu::59124860-347a-40b0-a9d2-c7a2e55c2f94" providerId="AD" clId="Web-{667CA004-9172-61C7-64BE-2ADCBD492E47}"/>
    <pc:docChg chg="modSld">
      <pc:chgData name="Laura Ochoa" userId="S::locho016@fiu.edu::59124860-347a-40b0-a9d2-c7a2e55c2f94" providerId="AD" clId="Web-{667CA004-9172-61C7-64BE-2ADCBD492E47}" dt="2023-12-17T13:10:23.981" v="6"/>
      <pc:docMkLst>
        <pc:docMk/>
      </pc:docMkLst>
      <pc:sldChg chg="delSp modSp">
        <pc:chgData name="Laura Ochoa" userId="S::locho016@fiu.edu::59124860-347a-40b0-a9d2-c7a2e55c2f94" providerId="AD" clId="Web-{667CA004-9172-61C7-64BE-2ADCBD492E47}" dt="2023-12-17T13:10:23.981" v="6"/>
        <pc:sldMkLst>
          <pc:docMk/>
          <pc:sldMk cId="3958759317" sldId="265"/>
        </pc:sldMkLst>
        <pc:spChg chg="del">
          <ac:chgData name="Laura Ochoa" userId="S::locho016@fiu.edu::59124860-347a-40b0-a9d2-c7a2e55c2f94" providerId="AD" clId="Web-{667CA004-9172-61C7-64BE-2ADCBD492E47}" dt="2023-12-17T13:09:16.447" v="0"/>
          <ac:spMkLst>
            <pc:docMk/>
            <pc:sldMk cId="3958759317" sldId="265"/>
            <ac:spMk id="42" creationId="{04ECB370-4819-C43E-55CD-B39995B2EF02}"/>
          </ac:spMkLst>
        </pc:spChg>
        <pc:spChg chg="topLvl">
          <ac:chgData name="Laura Ochoa" userId="S::locho016@fiu.edu::59124860-347a-40b0-a9d2-c7a2e55c2f94" providerId="AD" clId="Web-{667CA004-9172-61C7-64BE-2ADCBD492E47}" dt="2023-12-17T13:10:23.981" v="6"/>
          <ac:spMkLst>
            <pc:docMk/>
            <pc:sldMk cId="3958759317" sldId="265"/>
            <ac:spMk id="91" creationId="{46C20E16-3BF8-7929-E8BF-38F946271306}"/>
          </ac:spMkLst>
        </pc:spChg>
        <pc:grpChg chg="mod">
          <ac:chgData name="Laura Ochoa" userId="S::locho016@fiu.edu::59124860-347a-40b0-a9d2-c7a2e55c2f94" providerId="AD" clId="Web-{667CA004-9172-61C7-64BE-2ADCBD492E47}" dt="2023-12-17T13:09:40.433" v="2" actId="1076"/>
          <ac:grpSpMkLst>
            <pc:docMk/>
            <pc:sldMk cId="3958759317" sldId="265"/>
            <ac:grpSpMk id="76" creationId="{B9F3A558-3284-190E-4EEB-A841BEE02096}"/>
          </ac:grpSpMkLst>
        </pc:grpChg>
        <pc:grpChg chg="topLvl">
          <ac:chgData name="Laura Ochoa" userId="S::locho016@fiu.edu::59124860-347a-40b0-a9d2-c7a2e55c2f94" providerId="AD" clId="Web-{667CA004-9172-61C7-64BE-2ADCBD492E47}" dt="2023-12-17T13:10:23.981" v="6"/>
          <ac:grpSpMkLst>
            <pc:docMk/>
            <pc:sldMk cId="3958759317" sldId="265"/>
            <ac:grpSpMk id="99" creationId="{DF8677DB-AE28-F937-D3E0-FF663E2FCC66}"/>
          </ac:grpSpMkLst>
        </pc:grpChg>
        <pc:grpChg chg="del mod">
          <ac:chgData name="Laura Ochoa" userId="S::locho016@fiu.edu::59124860-347a-40b0-a9d2-c7a2e55c2f94" providerId="AD" clId="Web-{667CA004-9172-61C7-64BE-2ADCBD492E47}" dt="2023-12-17T13:10:23.981" v="6"/>
          <ac:grpSpMkLst>
            <pc:docMk/>
            <pc:sldMk cId="3958759317" sldId="265"/>
            <ac:grpSpMk id="100" creationId="{28A19D92-2FA3-6EAA-1070-90038E1D8E71}"/>
          </ac:grpSpMkLst>
        </pc:grpChg>
      </pc:sldChg>
    </pc:docChg>
  </pc:docChgLst>
  <pc:docChgLst>
    <pc:chgData name="Laura Ochoa" userId="S::locho016@fiu.edu::59124860-347a-40b0-a9d2-c7a2e55c2f94" providerId="AD" clId="Web-{47506DA8-55C8-2284-C920-4A685517F760}"/>
    <pc:docChg chg="modSld">
      <pc:chgData name="Laura Ochoa" userId="S::locho016@fiu.edu::59124860-347a-40b0-a9d2-c7a2e55c2f94" providerId="AD" clId="Web-{47506DA8-55C8-2284-C920-4A685517F760}" dt="2023-12-15T16:26:41.118" v="44"/>
      <pc:docMkLst>
        <pc:docMk/>
      </pc:docMkLst>
      <pc:sldChg chg="delSp">
        <pc:chgData name="Laura Ochoa" userId="S::locho016@fiu.edu::59124860-347a-40b0-a9d2-c7a2e55c2f94" providerId="AD" clId="Web-{47506DA8-55C8-2284-C920-4A685517F760}" dt="2023-12-15T16:24:42.817" v="3"/>
        <pc:sldMkLst>
          <pc:docMk/>
          <pc:sldMk cId="150878583" sldId="262"/>
        </pc:sldMkLst>
        <pc:spChg chg="del">
          <ac:chgData name="Laura Ochoa" userId="S::locho016@fiu.edu::59124860-347a-40b0-a9d2-c7a2e55c2f94" providerId="AD" clId="Web-{47506DA8-55C8-2284-C920-4A685517F760}" dt="2023-12-15T16:24:42.817" v="3"/>
          <ac:spMkLst>
            <pc:docMk/>
            <pc:sldMk cId="150878583" sldId="262"/>
            <ac:spMk id="42" creationId="{AD176EA5-17C9-8191-0A8F-33320033CE85}"/>
          </ac:spMkLst>
        </pc:spChg>
      </pc:sldChg>
      <pc:sldChg chg="modSp">
        <pc:chgData name="Laura Ochoa" userId="S::locho016@fiu.edu::59124860-347a-40b0-a9d2-c7a2e55c2f94" providerId="AD" clId="Web-{47506DA8-55C8-2284-C920-4A685517F760}" dt="2023-12-15T16:26:41.118" v="44"/>
        <pc:sldMkLst>
          <pc:docMk/>
          <pc:sldMk cId="2904938040" sldId="263"/>
        </pc:sldMkLst>
        <pc:spChg chg="mod">
          <ac:chgData name="Laura Ochoa" userId="S::locho016@fiu.edu::59124860-347a-40b0-a9d2-c7a2e55c2f94" providerId="AD" clId="Web-{47506DA8-55C8-2284-C920-4A685517F760}" dt="2023-12-15T16:26:10.211" v="31"/>
          <ac:spMkLst>
            <pc:docMk/>
            <pc:sldMk cId="2904938040" sldId="263"/>
            <ac:spMk id="8" creationId="{53EFAF5B-9FDB-395D-FC60-F8C85117D7A5}"/>
          </ac:spMkLst>
        </pc:spChg>
        <pc:spChg chg="mod">
          <ac:chgData name="Laura Ochoa" userId="S::locho016@fiu.edu::59124860-347a-40b0-a9d2-c7a2e55c2f94" providerId="AD" clId="Web-{47506DA8-55C8-2284-C920-4A685517F760}" dt="2023-12-15T16:26:40.665" v="40"/>
          <ac:spMkLst>
            <pc:docMk/>
            <pc:sldMk cId="2904938040" sldId="263"/>
            <ac:spMk id="10" creationId="{D29A028B-592A-C4CA-C163-A709F681AFB9}"/>
          </ac:spMkLst>
        </pc:spChg>
        <pc:spChg chg="mod">
          <ac:chgData name="Laura Ochoa" userId="S::locho016@fiu.edu::59124860-347a-40b0-a9d2-c7a2e55c2f94" providerId="AD" clId="Web-{47506DA8-55C8-2284-C920-4A685517F760}" dt="2023-12-15T16:26:40.790" v="41"/>
          <ac:spMkLst>
            <pc:docMk/>
            <pc:sldMk cId="2904938040" sldId="263"/>
            <ac:spMk id="13" creationId="{5C13716D-11EC-6B59-6B18-156875A27984}"/>
          </ac:spMkLst>
        </pc:spChg>
        <pc:spChg chg="mod">
          <ac:chgData name="Laura Ochoa" userId="S::locho016@fiu.edu::59124860-347a-40b0-a9d2-c7a2e55c2f94" providerId="AD" clId="Web-{47506DA8-55C8-2284-C920-4A685517F760}" dt="2023-12-15T16:26:40.899" v="42"/>
          <ac:spMkLst>
            <pc:docMk/>
            <pc:sldMk cId="2904938040" sldId="263"/>
            <ac:spMk id="16" creationId="{3C21EA54-C91D-82BF-4D0D-874C09E174D7}"/>
          </ac:spMkLst>
        </pc:spChg>
        <pc:spChg chg="mod">
          <ac:chgData name="Laura Ochoa" userId="S::locho016@fiu.edu::59124860-347a-40b0-a9d2-c7a2e55c2f94" providerId="AD" clId="Web-{47506DA8-55C8-2284-C920-4A685517F760}" dt="2023-12-15T16:26:41.009" v="43"/>
          <ac:spMkLst>
            <pc:docMk/>
            <pc:sldMk cId="2904938040" sldId="263"/>
            <ac:spMk id="19" creationId="{E26975EC-F0C8-270E-9F18-B808D8DCD256}"/>
          </ac:spMkLst>
        </pc:spChg>
        <pc:spChg chg="mod">
          <ac:chgData name="Laura Ochoa" userId="S::locho016@fiu.edu::59124860-347a-40b0-a9d2-c7a2e55c2f94" providerId="AD" clId="Web-{47506DA8-55C8-2284-C920-4A685517F760}" dt="2023-12-15T16:26:10.539" v="32"/>
          <ac:spMkLst>
            <pc:docMk/>
            <pc:sldMk cId="2904938040" sldId="263"/>
            <ac:spMk id="20" creationId="{23F36240-6F18-4EA5-3722-3A8E086A27FB}"/>
          </ac:spMkLst>
        </pc:spChg>
        <pc:spChg chg="mod">
          <ac:chgData name="Laura Ochoa" userId="S::locho016@fiu.edu::59124860-347a-40b0-a9d2-c7a2e55c2f94" providerId="AD" clId="Web-{47506DA8-55C8-2284-C920-4A685517F760}" dt="2023-12-15T16:26:10.804" v="33"/>
          <ac:spMkLst>
            <pc:docMk/>
            <pc:sldMk cId="2904938040" sldId="263"/>
            <ac:spMk id="23" creationId="{6B942E18-9572-B73B-D67E-AE24C7A2EE80}"/>
          </ac:spMkLst>
        </pc:spChg>
        <pc:spChg chg="mod">
          <ac:chgData name="Laura Ochoa" userId="S::locho016@fiu.edu::59124860-347a-40b0-a9d2-c7a2e55c2f94" providerId="AD" clId="Web-{47506DA8-55C8-2284-C920-4A685517F760}" dt="2023-12-15T16:26:41.118" v="44"/>
          <ac:spMkLst>
            <pc:docMk/>
            <pc:sldMk cId="2904938040" sldId="263"/>
            <ac:spMk id="25" creationId="{F1FFAF5D-56ED-623A-EE71-0C00BB6CA63E}"/>
          </ac:spMkLst>
        </pc:spChg>
        <pc:spChg chg="mod">
          <ac:chgData name="Laura Ochoa" userId="S::locho016@fiu.edu::59124860-347a-40b0-a9d2-c7a2e55c2f94" providerId="AD" clId="Web-{47506DA8-55C8-2284-C920-4A685517F760}" dt="2023-12-15T16:26:11.070" v="34"/>
          <ac:spMkLst>
            <pc:docMk/>
            <pc:sldMk cId="2904938040" sldId="263"/>
            <ac:spMk id="26" creationId="{2EC11DCA-A509-A0BB-3D43-56AB233439D1}"/>
          </ac:spMkLst>
        </pc:spChg>
        <pc:spChg chg="mod">
          <ac:chgData name="Laura Ochoa" userId="S::locho016@fiu.edu::59124860-347a-40b0-a9d2-c7a2e55c2f94" providerId="AD" clId="Web-{47506DA8-55C8-2284-C920-4A685517F760}" dt="2023-12-15T16:26:11.351" v="35"/>
          <ac:spMkLst>
            <pc:docMk/>
            <pc:sldMk cId="2904938040" sldId="263"/>
            <ac:spMk id="29" creationId="{8596AE79-9812-EED8-4F58-C6F0550AAEE5}"/>
          </ac:spMkLst>
        </pc:spChg>
        <pc:spChg chg="mod">
          <ac:chgData name="Laura Ochoa" userId="S::locho016@fiu.edu::59124860-347a-40b0-a9d2-c7a2e55c2f94" providerId="AD" clId="Web-{47506DA8-55C8-2284-C920-4A685517F760}" dt="2023-12-15T16:26:11.617" v="36"/>
          <ac:spMkLst>
            <pc:docMk/>
            <pc:sldMk cId="2904938040" sldId="263"/>
            <ac:spMk id="32" creationId="{42E20091-DF57-8901-9A25-FED74439934B}"/>
          </ac:spMkLst>
        </pc:spChg>
        <pc:spChg chg="mod">
          <ac:chgData name="Laura Ochoa" userId="S::locho016@fiu.edu::59124860-347a-40b0-a9d2-c7a2e55c2f94" providerId="AD" clId="Web-{47506DA8-55C8-2284-C920-4A685517F760}" dt="2023-12-15T16:26:11.883" v="37"/>
          <ac:spMkLst>
            <pc:docMk/>
            <pc:sldMk cId="2904938040" sldId="263"/>
            <ac:spMk id="35" creationId="{F7C12D5C-EDCF-FB91-E262-31C2AA4D2E76}"/>
          </ac:spMkLst>
        </pc:spChg>
        <pc:spChg chg="mod">
          <ac:chgData name="Laura Ochoa" userId="S::locho016@fiu.edu::59124860-347a-40b0-a9d2-c7a2e55c2f94" providerId="AD" clId="Web-{47506DA8-55C8-2284-C920-4A685517F760}" dt="2023-12-15T16:26:12.148" v="38"/>
          <ac:spMkLst>
            <pc:docMk/>
            <pc:sldMk cId="2904938040" sldId="263"/>
            <ac:spMk id="36" creationId="{D4CD5628-1A26-38C5-D412-2CBB7B3667E6}"/>
          </ac:spMkLst>
        </pc:spChg>
        <pc:spChg chg="mod">
          <ac:chgData name="Laura Ochoa" userId="S::locho016@fiu.edu::59124860-347a-40b0-a9d2-c7a2e55c2f94" providerId="AD" clId="Web-{47506DA8-55C8-2284-C920-4A685517F760}" dt="2023-12-15T16:26:12.414" v="39"/>
          <ac:spMkLst>
            <pc:docMk/>
            <pc:sldMk cId="2904938040" sldId="263"/>
            <ac:spMk id="37" creationId="{4BE5A554-3E7C-4B38-E8B2-1A347853ADA0}"/>
          </ac:spMkLst>
        </pc:spChg>
        <pc:spChg chg="mod">
          <ac:chgData name="Laura Ochoa" userId="S::locho016@fiu.edu::59124860-347a-40b0-a9d2-c7a2e55c2f94" providerId="AD" clId="Web-{47506DA8-55C8-2284-C920-4A685517F760}" dt="2023-12-15T16:24:37.317" v="2" actId="20577"/>
          <ac:spMkLst>
            <pc:docMk/>
            <pc:sldMk cId="2904938040" sldId="263"/>
            <ac:spMk id="42" creationId="{AD176EA5-17C9-8191-0A8F-33320033CE85}"/>
          </ac:spMkLst>
        </pc:spChg>
      </pc:sldChg>
    </pc:docChg>
  </pc:docChgLst>
  <pc:docChgLst>
    <pc:chgData name="Laura Ochoa" userId="S::locho016@fiu.edu::59124860-347a-40b0-a9d2-c7a2e55c2f94" providerId="AD" clId="Web-{E93B4D14-2922-7336-572E-757DA629ED71}"/>
    <pc:docChg chg="modSld">
      <pc:chgData name="Laura Ochoa" userId="S::locho016@fiu.edu::59124860-347a-40b0-a9d2-c7a2e55c2f94" providerId="AD" clId="Web-{E93B4D14-2922-7336-572E-757DA629ED71}" dt="2023-12-16T21:15:01.807" v="10" actId="1076"/>
      <pc:docMkLst>
        <pc:docMk/>
      </pc:docMkLst>
      <pc:sldChg chg="addSp delSp modSp">
        <pc:chgData name="Laura Ochoa" userId="S::locho016@fiu.edu::59124860-347a-40b0-a9d2-c7a2e55c2f94" providerId="AD" clId="Web-{E93B4D14-2922-7336-572E-757DA629ED71}" dt="2023-12-16T21:14:33.040" v="3" actId="1076"/>
        <pc:sldMkLst>
          <pc:docMk/>
          <pc:sldMk cId="1052726984" sldId="260"/>
        </pc:sldMkLst>
        <pc:spChg chg="del">
          <ac:chgData name="Laura Ochoa" userId="S::locho016@fiu.edu::59124860-347a-40b0-a9d2-c7a2e55c2f94" providerId="AD" clId="Web-{E93B4D14-2922-7336-572E-757DA629ED71}" dt="2023-12-16T21:14:27.087" v="1"/>
          <ac:spMkLst>
            <pc:docMk/>
            <pc:sldMk cId="1052726984" sldId="260"/>
            <ac:spMk id="18" creationId="{71655D2F-F95D-D03B-C053-0F88C32124A5}"/>
          </ac:spMkLst>
        </pc:spChg>
        <pc:grpChg chg="del">
          <ac:chgData name="Laura Ochoa" userId="S::locho016@fiu.edu::59124860-347a-40b0-a9d2-c7a2e55c2f94" providerId="AD" clId="Web-{E93B4D14-2922-7336-572E-757DA629ED71}" dt="2023-12-16T21:14:25.446" v="0"/>
          <ac:grpSpMkLst>
            <pc:docMk/>
            <pc:sldMk cId="1052726984" sldId="260"/>
            <ac:grpSpMk id="16" creationId="{F3CCB774-DCDB-7B52-4E1D-5F44D2140D18}"/>
          </ac:grpSpMkLst>
        </pc:grpChg>
        <pc:picChg chg="add mod">
          <ac:chgData name="Laura Ochoa" userId="S::locho016@fiu.edu::59124860-347a-40b0-a9d2-c7a2e55c2f94" providerId="AD" clId="Web-{E93B4D14-2922-7336-572E-757DA629ED71}" dt="2023-12-16T21:14:33.040" v="3" actId="1076"/>
          <ac:picMkLst>
            <pc:docMk/>
            <pc:sldMk cId="1052726984" sldId="260"/>
            <ac:picMk id="2" creationId="{7204FBDD-C1BD-6B1C-F7D5-7B5D2F55F812}"/>
          </ac:picMkLst>
        </pc:picChg>
      </pc:sldChg>
      <pc:sldChg chg="addSp modSp">
        <pc:chgData name="Laura Ochoa" userId="S::locho016@fiu.edu::59124860-347a-40b0-a9d2-c7a2e55c2f94" providerId="AD" clId="Web-{E93B4D14-2922-7336-572E-757DA629ED71}" dt="2023-12-16T21:15:01.807" v="10" actId="1076"/>
        <pc:sldMkLst>
          <pc:docMk/>
          <pc:sldMk cId="2904938040" sldId="263"/>
        </pc:sldMkLst>
        <pc:spChg chg="mod">
          <ac:chgData name="Laura Ochoa" userId="S::locho016@fiu.edu::59124860-347a-40b0-a9d2-c7a2e55c2f94" providerId="AD" clId="Web-{E93B4D14-2922-7336-572E-757DA629ED71}" dt="2023-12-16T21:14:51.384" v="5" actId="1076"/>
          <ac:spMkLst>
            <pc:docMk/>
            <pc:sldMk cId="2904938040" sldId="263"/>
            <ac:spMk id="4" creationId="{7AD0E6FC-63DB-3C49-4539-EB08E7AFA66D}"/>
          </ac:spMkLst>
        </pc:spChg>
        <pc:grpChg chg="mod">
          <ac:chgData name="Laura Ochoa" userId="S::locho016@fiu.edu::59124860-347a-40b0-a9d2-c7a2e55c2f94" providerId="AD" clId="Web-{E93B4D14-2922-7336-572E-757DA629ED71}" dt="2023-12-16T21:14:56.292" v="7" actId="1076"/>
          <ac:grpSpMkLst>
            <pc:docMk/>
            <pc:sldMk cId="2904938040" sldId="263"/>
            <ac:grpSpMk id="2" creationId="{9C5651E6-1D48-8B67-CED0-E5E11DA35EFE}"/>
          </ac:grpSpMkLst>
        </pc:grpChg>
        <pc:picChg chg="mod">
          <ac:chgData name="Laura Ochoa" userId="S::locho016@fiu.edu::59124860-347a-40b0-a9d2-c7a2e55c2f94" providerId="AD" clId="Web-{E93B4D14-2922-7336-572E-757DA629ED71}" dt="2023-12-16T21:14:58.463" v="8" actId="1076"/>
          <ac:picMkLst>
            <pc:docMk/>
            <pc:sldMk cId="2904938040" sldId="263"/>
            <ac:picMk id="3" creationId="{2C4743B9-5992-0DBB-0F51-818FF41F039F}"/>
          </ac:picMkLst>
        </pc:picChg>
        <pc:picChg chg="add mod">
          <ac:chgData name="Laura Ochoa" userId="S::locho016@fiu.edu::59124860-347a-40b0-a9d2-c7a2e55c2f94" providerId="AD" clId="Web-{E93B4D14-2922-7336-572E-757DA629ED71}" dt="2023-12-16T21:15:01.807" v="10" actId="1076"/>
          <ac:picMkLst>
            <pc:docMk/>
            <pc:sldMk cId="2904938040" sldId="263"/>
            <ac:picMk id="34" creationId="{33E871C6-834E-B886-3DB7-C3159969071B}"/>
          </ac:picMkLst>
        </pc:picChg>
      </pc:sldChg>
    </pc:docChg>
  </pc:docChgLst>
  <pc:docChgLst>
    <pc:chgData name="Laura Ochoa" userId="S::locho016@fiu.edu::59124860-347a-40b0-a9d2-c7a2e55c2f94" providerId="AD" clId="Web-{4788D312-7DD4-B0B9-F0F3-67DB23D79977}"/>
    <pc:docChg chg="modSld">
      <pc:chgData name="Laura Ochoa" userId="S::locho016@fiu.edu::59124860-347a-40b0-a9d2-c7a2e55c2f94" providerId="AD" clId="Web-{4788D312-7DD4-B0B9-F0F3-67DB23D79977}" dt="2023-12-16T21:24:08.509" v="3"/>
      <pc:docMkLst>
        <pc:docMk/>
      </pc:docMkLst>
      <pc:sldChg chg="addSp delSp modSp">
        <pc:chgData name="Laura Ochoa" userId="S::locho016@fiu.edu::59124860-347a-40b0-a9d2-c7a2e55c2f94" providerId="AD" clId="Web-{4788D312-7DD4-B0B9-F0F3-67DB23D79977}" dt="2023-12-16T21:24:08.509" v="3"/>
        <pc:sldMkLst>
          <pc:docMk/>
          <pc:sldMk cId="271627983" sldId="256"/>
        </pc:sldMkLst>
        <pc:picChg chg="add del mod">
          <ac:chgData name="Laura Ochoa" userId="S::locho016@fiu.edu::59124860-347a-40b0-a9d2-c7a2e55c2f94" providerId="AD" clId="Web-{4788D312-7DD4-B0B9-F0F3-67DB23D79977}" dt="2023-12-16T21:24:08.509" v="3"/>
          <ac:picMkLst>
            <pc:docMk/>
            <pc:sldMk cId="271627983" sldId="256"/>
            <ac:picMk id="3" creationId="{34B5636B-2012-3382-867F-AA81491B274A}"/>
          </ac:picMkLst>
        </pc:picChg>
      </pc:sldChg>
    </pc:docChg>
  </pc:docChgLst>
  <pc:docChgLst>
    <pc:chgData name="Laura Ochoa" userId="S::locho016@fiu.edu::59124860-347a-40b0-a9d2-c7a2e55c2f94" providerId="AD" clId="Web-{D2E944D5-F0F0-A74C-DEFF-6E520627EEC7}"/>
    <pc:docChg chg="modSld">
      <pc:chgData name="Laura Ochoa" userId="S::locho016@fiu.edu::59124860-347a-40b0-a9d2-c7a2e55c2f94" providerId="AD" clId="Web-{D2E944D5-F0F0-A74C-DEFF-6E520627EEC7}" dt="2023-12-14T21:55:03.471" v="0" actId="1076"/>
      <pc:docMkLst>
        <pc:docMk/>
      </pc:docMkLst>
      <pc:sldChg chg="modSp">
        <pc:chgData name="Laura Ochoa" userId="S::locho016@fiu.edu::59124860-347a-40b0-a9d2-c7a2e55c2f94" providerId="AD" clId="Web-{D2E944D5-F0F0-A74C-DEFF-6E520627EEC7}" dt="2023-12-14T21:55:03.471" v="0" actId="1076"/>
        <pc:sldMkLst>
          <pc:docMk/>
          <pc:sldMk cId="2904938040" sldId="263"/>
        </pc:sldMkLst>
        <pc:spChg chg="mod">
          <ac:chgData name="Laura Ochoa" userId="S::locho016@fiu.edu::59124860-347a-40b0-a9d2-c7a2e55c2f94" providerId="AD" clId="Web-{D2E944D5-F0F0-A74C-DEFF-6E520627EEC7}" dt="2023-12-14T21:55:03.471" v="0" actId="1076"/>
          <ac:spMkLst>
            <pc:docMk/>
            <pc:sldMk cId="2904938040" sldId="263"/>
            <ac:spMk id="64" creationId="{6670B70A-5F29-9FDC-C7B0-165265F62183}"/>
          </ac:spMkLst>
        </pc:spChg>
      </pc:sldChg>
    </pc:docChg>
  </pc:docChgLst>
  <pc:docChgLst>
    <pc:chgData name="Laura Serbus" userId="S::lserbus@fiu.edu::bdce7c50-c5f9-47ca-b33a-5a97f0f798f6" providerId="AD" clId="Web-{319986E6-B82C-F8E0-F9B1-F9D4B4D0119D}"/>
    <pc:docChg chg="addSld modSld sldOrd">
      <pc:chgData name="Laura Serbus" userId="S::lserbus@fiu.edu::bdce7c50-c5f9-47ca-b33a-5a97f0f798f6" providerId="AD" clId="Web-{319986E6-B82C-F8E0-F9B1-F9D4B4D0119D}" dt="2023-12-19T02:42:41.377" v="163"/>
      <pc:docMkLst>
        <pc:docMk/>
      </pc:docMkLst>
      <pc:sldChg chg="delSp">
        <pc:chgData name="Laura Serbus" userId="S::lserbus@fiu.edu::bdce7c50-c5f9-47ca-b33a-5a97f0f798f6" providerId="AD" clId="Web-{319986E6-B82C-F8E0-F9B1-F9D4B4D0119D}" dt="2023-12-19T01:33:27.141" v="1"/>
        <pc:sldMkLst>
          <pc:docMk/>
          <pc:sldMk cId="3958759317" sldId="265"/>
        </pc:sldMkLst>
        <pc:spChg chg="del">
          <ac:chgData name="Laura Serbus" userId="S::lserbus@fiu.edu::bdce7c50-c5f9-47ca-b33a-5a97f0f798f6" providerId="AD" clId="Web-{319986E6-B82C-F8E0-F9B1-F9D4B4D0119D}" dt="2023-12-19T01:33:24.047" v="0"/>
          <ac:spMkLst>
            <pc:docMk/>
            <pc:sldMk cId="3958759317" sldId="265"/>
            <ac:spMk id="3" creationId="{1DCBB027-6A68-06BF-1070-FF8A0E271B48}"/>
          </ac:spMkLst>
        </pc:spChg>
        <pc:grpChg chg="del">
          <ac:chgData name="Laura Serbus" userId="S::lserbus@fiu.edu::bdce7c50-c5f9-47ca-b33a-5a97f0f798f6" providerId="AD" clId="Web-{319986E6-B82C-F8E0-F9B1-F9D4B4D0119D}" dt="2023-12-19T01:33:27.141" v="1"/>
          <ac:grpSpMkLst>
            <pc:docMk/>
            <pc:sldMk cId="3958759317" sldId="265"/>
            <ac:grpSpMk id="60" creationId="{4531E32C-DAD6-8F0D-A735-B582793860F4}"/>
          </ac:grpSpMkLst>
        </pc:grpChg>
      </pc:sldChg>
      <pc:sldChg chg="addSp delSp modSp add ord replId">
        <pc:chgData name="Laura Serbus" userId="S::lserbus@fiu.edu::bdce7c50-c5f9-47ca-b33a-5a97f0f798f6" providerId="AD" clId="Web-{319986E6-B82C-F8E0-F9B1-F9D4B4D0119D}" dt="2023-12-19T02:29:46.526" v="141"/>
        <pc:sldMkLst>
          <pc:docMk/>
          <pc:sldMk cId="1756382141" sldId="268"/>
        </pc:sldMkLst>
        <pc:spChg chg="add mod">
          <ac:chgData name="Laura Serbus" userId="S::lserbus@fiu.edu::bdce7c50-c5f9-47ca-b33a-5a97f0f798f6" providerId="AD" clId="Web-{319986E6-B82C-F8E0-F9B1-F9D4B4D0119D}" dt="2023-12-19T02:27:29.662" v="125" actId="1076"/>
          <ac:spMkLst>
            <pc:docMk/>
            <pc:sldMk cId="1756382141" sldId="268"/>
            <ac:spMk id="3" creationId="{5254275A-054E-318F-51F7-92B30E9E9856}"/>
          </ac:spMkLst>
        </pc:spChg>
        <pc:spChg chg="del">
          <ac:chgData name="Laura Serbus" userId="S::lserbus@fiu.edu::bdce7c50-c5f9-47ca-b33a-5a97f0f798f6" providerId="AD" clId="Web-{319986E6-B82C-F8E0-F9B1-F9D4B4D0119D}" dt="2023-12-19T01:33:43.532" v="7"/>
          <ac:spMkLst>
            <pc:docMk/>
            <pc:sldMk cId="1756382141" sldId="268"/>
            <ac:spMk id="4" creationId="{0685AAB3-DE6B-B434-FB16-23A05EACAA23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6" creationId="{09B6987C-496D-B33B-8F3C-5E069B5A7F9E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7" creationId="{D0702D34-7D39-7E98-DB17-128A1DAAED10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9" creationId="{0E5F7868-6CA0-59FA-04B1-E16426D6461B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25" creationId="{1837A272-7A56-0146-2BA1-F4177CFB6451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28" creationId="{B1D0C04E-3B9C-55FE-8421-8567D856EF56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42" creationId="{6269C562-A05E-5B8D-3D4A-2610387ACB21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60" creationId="{0A0A78FB-E380-D463-C786-5F2BB9AABC45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61" creationId="{C7C20C50-53D8-7B42-93D5-AC6FBCCDE302}"/>
          </ac:spMkLst>
        </pc:spChg>
        <pc:spChg chg="del">
          <ac:chgData name="Laura Serbus" userId="S::lserbus@fiu.edu::bdce7c50-c5f9-47ca-b33a-5a97f0f798f6" providerId="AD" clId="Web-{319986E6-B82C-F8E0-F9B1-F9D4B4D0119D}" dt="2023-12-19T01:33:43.532" v="6"/>
          <ac:spMkLst>
            <pc:docMk/>
            <pc:sldMk cId="1756382141" sldId="268"/>
            <ac:spMk id="64" creationId="{ACC2F257-1481-D9CA-D134-34775247B54C}"/>
          </ac:spMkLst>
        </pc:spChg>
        <pc:spChg chg="add mod">
          <ac:chgData name="Laura Serbus" userId="S::lserbus@fiu.edu::bdce7c50-c5f9-47ca-b33a-5a97f0f798f6" providerId="AD" clId="Web-{319986E6-B82C-F8E0-F9B1-F9D4B4D0119D}" dt="2023-12-19T02:29:08.274" v="138" actId="1076"/>
          <ac:spMkLst>
            <pc:docMk/>
            <pc:sldMk cId="1756382141" sldId="268"/>
            <ac:spMk id="65" creationId="{32A544BC-904D-6291-2848-62896A2822C3}"/>
          </ac:spMkLst>
        </pc:spChg>
        <pc:spChg chg="add mod">
          <ac:chgData name="Laura Serbus" userId="S::lserbus@fiu.edu::bdce7c50-c5f9-47ca-b33a-5a97f0f798f6" providerId="AD" clId="Web-{319986E6-B82C-F8E0-F9B1-F9D4B4D0119D}" dt="2023-12-19T02:29:08.415" v="139" actId="1076"/>
          <ac:spMkLst>
            <pc:docMk/>
            <pc:sldMk cId="1756382141" sldId="268"/>
            <ac:spMk id="66" creationId="{8C6CA8E5-29CC-6AD0-9156-7569101DC5F6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67" creationId="{1D3177F4-BA01-4A5C-0899-D0DC1FCF6AAC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68" creationId="{502C93D2-8DF4-D3EA-95D6-F6E89796E82D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70" creationId="{DE66FBC9-AA66-9023-F8F7-4B4159FAB59E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71" creationId="{F08E3C50-F219-C5AE-D448-647134397703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72" creationId="{C2987138-8F87-59CC-A2DF-0558493D6B27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74" creationId="{EFF17CD4-9606-B189-F219-EA7A8F2ACCBB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75" creationId="{E31E43CF-6D3C-E332-72D6-7F8FF709D303}"/>
          </ac:spMkLst>
        </pc:spChg>
        <pc:spChg chg="add mod">
          <ac:chgData name="Laura Serbus" userId="S::lserbus@fiu.edu::bdce7c50-c5f9-47ca-b33a-5a97f0f798f6" providerId="AD" clId="Web-{319986E6-B82C-F8E0-F9B1-F9D4B4D0119D}" dt="2023-12-19T02:29:07.978" v="136" actId="1076"/>
          <ac:spMkLst>
            <pc:docMk/>
            <pc:sldMk cId="1756382141" sldId="268"/>
            <ac:spMk id="91" creationId="{4C2A0E7D-74F2-5C9E-FABF-A661A6555930}"/>
          </ac:spMkLst>
        </pc:spChg>
        <pc:spChg chg="add mod">
          <ac:chgData name="Laura Serbus" userId="S::lserbus@fiu.edu::bdce7c50-c5f9-47ca-b33a-5a97f0f798f6" providerId="AD" clId="Web-{319986E6-B82C-F8E0-F9B1-F9D4B4D0119D}" dt="2023-12-19T02:29:08.118" v="137" actId="1076"/>
          <ac:spMkLst>
            <pc:docMk/>
            <pc:sldMk cId="1756382141" sldId="268"/>
            <ac:spMk id="92" creationId="{446D135B-FF64-01BD-76A4-549892B9746E}"/>
          </ac:spMkLst>
        </pc:spChg>
        <pc:spChg chg="add mod">
          <ac:chgData name="Laura Serbus" userId="S::lserbus@fiu.edu::bdce7c50-c5f9-47ca-b33a-5a97f0f798f6" providerId="AD" clId="Web-{319986E6-B82C-F8E0-F9B1-F9D4B4D0119D}" dt="2023-12-19T02:29:22.634" v="140" actId="1076"/>
          <ac:spMkLst>
            <pc:docMk/>
            <pc:sldMk cId="1756382141" sldId="268"/>
            <ac:spMk id="93" creationId="{84EF83F8-3B79-822D-9C24-93DF3F9279F2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94" creationId="{C373EB85-48A5-8476-A071-F2803D4DA8B5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97" creationId="{B26044A9-F71E-FE8A-1C66-09665DE9CE44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98" creationId="{31743183-E175-2637-8672-09B38A12806B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99" creationId="{7C36451F-ADE6-3AFD-82D8-143C9AD9CE32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4" creationId="{E4BB542C-F8A7-C00E-0EF2-D02AD77F5760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5" creationId="{8B8C34E1-80AA-AE43-FF03-F901CB02E801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6" creationId="{E62EFC7F-AE4D-05DC-4B0F-E1DD1A1238A9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7" creationId="{E43E3E2C-74B8-8290-90D5-C2C4B7B4B1C5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8" creationId="{839BA826-83C9-6364-0F48-297FBCC7A0C6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09" creationId="{92438155-4C5D-106A-F69E-BAAEA7DED291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0" creationId="{0F268F30-85ED-11FE-AF4B-9D8E0B5EA464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1" creationId="{05E366E8-8945-5004-DA25-9F7551FD7AD8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2" creationId="{44FAC97F-523E-19BD-879F-AEDCF561ED2A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3" creationId="{59D820BC-1581-6A59-4B0A-B44117633BD1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4" creationId="{F4908D36-28A7-1EDC-79A7-C140CD85869F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5" creationId="{04933CE0-7834-228E-7312-40D5413BAC82}"/>
          </ac:spMkLst>
        </pc:spChg>
        <pc:spChg chg="add">
          <ac:chgData name="Laura Serbus" userId="S::lserbus@fiu.edu::bdce7c50-c5f9-47ca-b33a-5a97f0f798f6" providerId="AD" clId="Web-{319986E6-B82C-F8E0-F9B1-F9D4B4D0119D}" dt="2023-12-19T01:33:55.063" v="8"/>
          <ac:spMkLst>
            <pc:docMk/>
            <pc:sldMk cId="1756382141" sldId="268"/>
            <ac:spMk id="116" creationId="{8AE9A655-1CA1-9C73-C0BF-09F6E4A6C94A}"/>
          </ac:spMkLst>
        </pc:spChg>
        <pc:grpChg chg="add">
          <ac:chgData name="Laura Serbus" userId="S::lserbus@fiu.edu::bdce7c50-c5f9-47ca-b33a-5a97f0f798f6" providerId="AD" clId="Web-{319986E6-B82C-F8E0-F9B1-F9D4B4D0119D}" dt="2023-12-19T02:29:46.526" v="141"/>
          <ac:grpSpMkLst>
            <pc:docMk/>
            <pc:sldMk cId="1756382141" sldId="268"/>
            <ac:grpSpMk id="2" creationId="{57A5D05F-AEB4-DC99-2268-DD3EC015FCC0}"/>
          </ac:grpSpMkLst>
        </pc:grpChg>
        <pc:grpChg chg="add mod">
          <ac:chgData name="Laura Serbus" userId="S::lserbus@fiu.edu::bdce7c50-c5f9-47ca-b33a-5a97f0f798f6" providerId="AD" clId="Web-{319986E6-B82C-F8E0-F9B1-F9D4B4D0119D}" dt="2023-12-19T01:34:28.814" v="16" actId="1076"/>
          <ac:grpSpMkLst>
            <pc:docMk/>
            <pc:sldMk cId="1756382141" sldId="268"/>
            <ac:grpSpMk id="6" creationId="{89608B4F-95CD-044E-4750-FDC0FBE03215}"/>
          </ac:grpSpMkLst>
        </pc:grpChg>
        <pc:grpChg chg="add mod">
          <ac:chgData name="Laura Serbus" userId="S::lserbus@fiu.edu::bdce7c50-c5f9-47ca-b33a-5a97f0f798f6" providerId="AD" clId="Web-{319986E6-B82C-F8E0-F9B1-F9D4B4D0119D}" dt="2023-12-19T01:34:28.908" v="17" actId="1076"/>
          <ac:grpSpMkLst>
            <pc:docMk/>
            <pc:sldMk cId="1756382141" sldId="268"/>
            <ac:grpSpMk id="10" creationId="{BA6D7284-626D-E9AE-B6FB-2104210F8C68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14" creationId="{847FAE20-2F48-32D4-A3B1-36B135FE6D7B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22" creationId="{0F87C3F2-92BF-B6BC-1B61-84EC1EE3202A}"/>
          </ac:grpSpMkLst>
        </pc:grpChg>
        <pc:grpChg chg="del">
          <ac:chgData name="Laura Serbus" userId="S::lserbus@fiu.edu::bdce7c50-c5f9-47ca-b33a-5a97f0f798f6" providerId="AD" clId="Web-{319986E6-B82C-F8E0-F9B1-F9D4B4D0119D}" dt="2023-12-19T01:33:43.532" v="3"/>
          <ac:grpSpMkLst>
            <pc:docMk/>
            <pc:sldMk cId="1756382141" sldId="268"/>
            <ac:grpSpMk id="31" creationId="{5AC2B6E8-F30A-8A70-A76F-32D658E5253F}"/>
          </ac:grpSpMkLst>
        </pc:grpChg>
        <pc:grpChg chg="del">
          <ac:chgData name="Laura Serbus" userId="S::lserbus@fiu.edu::bdce7c50-c5f9-47ca-b33a-5a97f0f798f6" providerId="AD" clId="Web-{319986E6-B82C-F8E0-F9B1-F9D4B4D0119D}" dt="2023-12-19T01:33:43.532" v="5"/>
          <ac:grpSpMkLst>
            <pc:docMk/>
            <pc:sldMk cId="1756382141" sldId="268"/>
            <ac:grpSpMk id="53" creationId="{821F235A-39EB-C605-7F2D-3FE00B92F652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62" creationId="{0A0DDA90-D5B6-18DE-2660-67B45CD9A49E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63" creationId="{6D6EA85D-0710-A7F3-348C-C2EE70542C99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69" creationId="{27E8902E-E852-AD40-75A4-D70428CD390A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73" creationId="{9A529C47-CF28-F762-23ED-0938D8B4248A}"/>
          </ac:grpSpMkLst>
        </pc:grpChg>
        <pc:grpChg chg="del">
          <ac:chgData name="Laura Serbus" userId="S::lserbus@fiu.edu::bdce7c50-c5f9-47ca-b33a-5a97f0f798f6" providerId="AD" clId="Web-{319986E6-B82C-F8E0-F9B1-F9D4B4D0119D}" dt="2023-12-19T01:33:43.532" v="4"/>
          <ac:grpSpMkLst>
            <pc:docMk/>
            <pc:sldMk cId="1756382141" sldId="268"/>
            <ac:grpSpMk id="76" creationId="{016E61B0-514A-4506-90E5-136691123AB4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96" creationId="{54FABF9C-D61B-F78B-FA98-7FA1AF738314}"/>
          </ac:grpSpMkLst>
        </pc:grpChg>
        <pc:grpChg chg="add">
          <ac:chgData name="Laura Serbus" userId="S::lserbus@fiu.edu::bdce7c50-c5f9-47ca-b33a-5a97f0f798f6" providerId="AD" clId="Web-{319986E6-B82C-F8E0-F9B1-F9D4B4D0119D}" dt="2023-12-19T01:33:55.063" v="8"/>
          <ac:grpSpMkLst>
            <pc:docMk/>
            <pc:sldMk cId="1756382141" sldId="268"/>
            <ac:grpSpMk id="100" creationId="{C3660A72-57BA-BB5F-5B27-710B2AF5D3A1}"/>
          </ac:grpSpMkLst>
        </pc:grpChg>
        <pc:picChg chg="add">
          <ac:chgData name="Laura Serbus" userId="S::lserbus@fiu.edu::bdce7c50-c5f9-47ca-b33a-5a97f0f798f6" providerId="AD" clId="Web-{319986E6-B82C-F8E0-F9B1-F9D4B4D0119D}" dt="2023-12-19T01:33:55.063" v="8"/>
          <ac:picMkLst>
            <pc:docMk/>
            <pc:sldMk cId="1756382141" sldId="268"/>
            <ac:picMk id="11" creationId="{303B9EBA-BDF9-9442-C07A-A6AEDD3B10FA}"/>
          </ac:picMkLst>
        </pc:picChg>
        <pc:picChg chg="add">
          <ac:chgData name="Laura Serbus" userId="S::lserbus@fiu.edu::bdce7c50-c5f9-47ca-b33a-5a97f0f798f6" providerId="AD" clId="Web-{319986E6-B82C-F8E0-F9B1-F9D4B4D0119D}" dt="2023-12-19T01:33:55.063" v="8"/>
          <ac:picMkLst>
            <pc:docMk/>
            <pc:sldMk cId="1756382141" sldId="268"/>
            <ac:picMk id="95" creationId="{EBA53448-2C79-3442-15F9-12AC5E9B6EE2}"/>
          </ac:picMkLst>
        </pc:picChg>
      </pc:sldChg>
      <pc:sldChg chg="addSp delSp modSp">
        <pc:chgData name="Laura Serbus" userId="S::lserbus@fiu.edu::bdce7c50-c5f9-47ca-b33a-5a97f0f798f6" providerId="AD" clId="Web-{319986E6-B82C-F8E0-F9B1-F9D4B4D0119D}" dt="2023-12-19T02:30:00.088" v="142"/>
        <pc:sldMkLst>
          <pc:docMk/>
          <pc:sldMk cId="1061097907" sldId="269"/>
        </pc:sldMkLst>
        <pc:spChg chg="add del mod">
          <ac:chgData name="Laura Serbus" userId="S::lserbus@fiu.edu::bdce7c50-c5f9-47ca-b33a-5a97f0f798f6" providerId="AD" clId="Web-{319986E6-B82C-F8E0-F9B1-F9D4B4D0119D}" dt="2023-12-19T02:18:55.691" v="65"/>
          <ac:spMkLst>
            <pc:docMk/>
            <pc:sldMk cId="1061097907" sldId="269"/>
            <ac:spMk id="3" creationId="{8178DB9D-67ED-6B38-0C5D-BA3A5E284118}"/>
          </ac:spMkLst>
        </pc:spChg>
        <pc:spChg chg="mod topLvl">
          <ac:chgData name="Laura Serbus" userId="S::lserbus@fiu.edu::bdce7c50-c5f9-47ca-b33a-5a97f0f798f6" providerId="AD" clId="Web-{319986E6-B82C-F8E0-F9B1-F9D4B4D0119D}" dt="2023-12-19T02:24:32.170" v="123" actId="20577"/>
          <ac:spMkLst>
            <pc:docMk/>
            <pc:sldMk cId="1061097907" sldId="269"/>
            <ac:spMk id="4" creationId="{625361A5-B4DD-DBE6-FA4A-677CE41215B8}"/>
          </ac:spMkLst>
        </pc:spChg>
        <pc:spChg chg="mod">
          <ac:chgData name="Laura Serbus" userId="S::lserbus@fiu.edu::bdce7c50-c5f9-47ca-b33a-5a97f0f798f6" providerId="AD" clId="Web-{319986E6-B82C-F8E0-F9B1-F9D4B4D0119D}" dt="2023-12-19T02:22:31.947" v="104" actId="1076"/>
          <ac:spMkLst>
            <pc:docMk/>
            <pc:sldMk cId="1061097907" sldId="269"/>
            <ac:spMk id="6" creationId="{2D4A3562-01A6-6BC3-79AE-7F65DEDA1E6D}"/>
          </ac:spMkLst>
        </pc:spChg>
        <pc:spChg chg="mod ord">
          <ac:chgData name="Laura Serbus" userId="S::lserbus@fiu.edu::bdce7c50-c5f9-47ca-b33a-5a97f0f798f6" providerId="AD" clId="Web-{319986E6-B82C-F8E0-F9B1-F9D4B4D0119D}" dt="2023-12-19T02:22:15.822" v="102" actId="14100"/>
          <ac:spMkLst>
            <pc:docMk/>
            <pc:sldMk cId="1061097907" sldId="269"/>
            <ac:spMk id="17" creationId="{3BC412CD-7ABF-0D13-8E3A-A47748A8FA4D}"/>
          </ac:spMkLst>
        </pc:spChg>
        <pc:spChg chg="add del mod ord">
          <ac:chgData name="Laura Serbus" userId="S::lserbus@fiu.edu::bdce7c50-c5f9-47ca-b33a-5a97f0f798f6" providerId="AD" clId="Web-{319986E6-B82C-F8E0-F9B1-F9D4B4D0119D}" dt="2023-12-19T02:18:47.941" v="62"/>
          <ac:spMkLst>
            <pc:docMk/>
            <pc:sldMk cId="1061097907" sldId="269"/>
            <ac:spMk id="46" creationId="{71538C0B-BD28-D99E-4575-EF5B1DEC5A82}"/>
          </ac:spMkLst>
        </pc:spChg>
        <pc:spChg chg="ord">
          <ac:chgData name="Laura Serbus" userId="S::lserbus@fiu.edu::bdce7c50-c5f9-47ca-b33a-5a97f0f798f6" providerId="AD" clId="Web-{319986E6-B82C-F8E0-F9B1-F9D4B4D0119D}" dt="2023-12-19T02:19:20.223" v="66"/>
          <ac:spMkLst>
            <pc:docMk/>
            <pc:sldMk cId="1061097907" sldId="269"/>
            <ac:spMk id="48" creationId="{C74D277D-12EF-3870-0FEF-F4A9C632A23D}"/>
          </ac:spMkLst>
        </pc:spChg>
        <pc:spChg chg="del">
          <ac:chgData name="Laura Serbus" userId="S::lserbus@fiu.edu::bdce7c50-c5f9-47ca-b33a-5a97f0f798f6" providerId="AD" clId="Web-{319986E6-B82C-F8E0-F9B1-F9D4B4D0119D}" dt="2023-12-19T02:19:34.208" v="67"/>
          <ac:spMkLst>
            <pc:docMk/>
            <pc:sldMk cId="1061097907" sldId="269"/>
            <ac:spMk id="64" creationId="{A6F41BA1-34A5-FAEC-385E-95BE12A3DC39}"/>
          </ac:spMkLst>
        </pc:spChg>
        <pc:spChg chg="mod">
          <ac:chgData name="Laura Serbus" userId="S::lserbus@fiu.edu::bdce7c50-c5f9-47ca-b33a-5a97f0f798f6" providerId="AD" clId="Web-{319986E6-B82C-F8E0-F9B1-F9D4B4D0119D}" dt="2023-12-19T02:15:46.623" v="40" actId="1076"/>
          <ac:spMkLst>
            <pc:docMk/>
            <pc:sldMk cId="1061097907" sldId="269"/>
            <ac:spMk id="66" creationId="{9F2D294A-E570-7388-8394-1CEBA9B3D5BA}"/>
          </ac:spMkLst>
        </pc:spChg>
        <pc:spChg chg="mod topLvl">
          <ac:chgData name="Laura Serbus" userId="S::lserbus@fiu.edu::bdce7c50-c5f9-47ca-b33a-5a97f0f798f6" providerId="AD" clId="Web-{319986E6-B82C-F8E0-F9B1-F9D4B4D0119D}" dt="2023-12-19T02:24:38.904" v="124" actId="1076"/>
          <ac:spMkLst>
            <pc:docMk/>
            <pc:sldMk cId="1061097907" sldId="269"/>
            <ac:spMk id="73" creationId="{AD25639C-994C-69F5-1E6E-55AE87EFF444}"/>
          </ac:spMkLst>
        </pc:spChg>
        <pc:grpChg chg="mod">
          <ac:chgData name="Laura Serbus" userId="S::lserbus@fiu.edu::bdce7c50-c5f9-47ca-b33a-5a97f0f798f6" providerId="AD" clId="Web-{319986E6-B82C-F8E0-F9B1-F9D4B4D0119D}" dt="2023-12-19T02:18:33.206" v="60"/>
          <ac:grpSpMkLst>
            <pc:docMk/>
            <pc:sldMk cId="1061097907" sldId="269"/>
            <ac:grpSpMk id="5" creationId="{3E77AA05-337C-5063-ADA4-D84BCECAF4D1}"/>
          </ac:grpSpMkLst>
        </pc:grpChg>
        <pc:grpChg chg="add del">
          <ac:chgData name="Laura Serbus" userId="S::lserbus@fiu.edu::bdce7c50-c5f9-47ca-b33a-5a97f0f798f6" providerId="AD" clId="Web-{319986E6-B82C-F8E0-F9B1-F9D4B4D0119D}" dt="2023-12-19T02:23:11.839" v="105"/>
          <ac:grpSpMkLst>
            <pc:docMk/>
            <pc:sldMk cId="1061097907" sldId="269"/>
            <ac:grpSpMk id="10" creationId="{F64B4C8B-4755-8EA3-DA79-B0638128D0AE}"/>
          </ac:grpSpMkLst>
        </pc:grpChg>
        <pc:grpChg chg="add">
          <ac:chgData name="Laura Serbus" userId="S::lserbus@fiu.edu::bdce7c50-c5f9-47ca-b33a-5a97f0f798f6" providerId="AD" clId="Web-{319986E6-B82C-F8E0-F9B1-F9D4B4D0119D}" dt="2023-12-19T02:30:00.088" v="142"/>
          <ac:grpSpMkLst>
            <pc:docMk/>
            <pc:sldMk cId="1061097907" sldId="269"/>
            <ac:grpSpMk id="11" creationId="{BE136D85-C2A0-9855-36C9-E3354BFEC103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23:11.839" v="105"/>
          <ac:grpSpMkLst>
            <pc:docMk/>
            <pc:sldMk cId="1061097907" sldId="269"/>
            <ac:grpSpMk id="16" creationId="{B7479125-A159-5368-44C0-5C9CD14DF77B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23:29.605" v="110" actId="1076"/>
          <ac:grpSpMkLst>
            <pc:docMk/>
            <pc:sldMk cId="1061097907" sldId="269"/>
            <ac:grpSpMk id="28" creationId="{0719C164-4CC7-DC96-7089-E00769B7BC2D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23:29.637" v="111" actId="1076"/>
          <ac:grpSpMkLst>
            <pc:docMk/>
            <pc:sldMk cId="1061097907" sldId="269"/>
            <ac:grpSpMk id="42" creationId="{BB2F568D-37F5-D9A0-B872-214AC7E78E90}"/>
          </ac:grpSpMkLst>
        </pc:grpChg>
        <pc:grpChg chg="add del">
          <ac:chgData name="Laura Serbus" userId="S::lserbus@fiu.edu::bdce7c50-c5f9-47ca-b33a-5a97f0f798f6" providerId="AD" clId="Web-{319986E6-B82C-F8E0-F9B1-F9D4B4D0119D}" dt="2023-12-19T02:18:33.206" v="60"/>
          <ac:grpSpMkLst>
            <pc:docMk/>
            <pc:sldMk cId="1061097907" sldId="269"/>
            <ac:grpSpMk id="47" creationId="{F15C6E8B-AACA-74C4-C82F-7AF9FD5EBF38}"/>
          </ac:grpSpMkLst>
        </pc:grpChg>
        <pc:picChg chg="add del ord">
          <ac:chgData name="Laura Serbus" userId="S::lserbus@fiu.edu::bdce7c50-c5f9-47ca-b33a-5a97f0f798f6" providerId="AD" clId="Web-{319986E6-B82C-F8E0-F9B1-F9D4B4D0119D}" dt="2023-12-19T02:18:38.675" v="61"/>
          <ac:picMkLst>
            <pc:docMk/>
            <pc:sldMk cId="1061097907" sldId="269"/>
            <ac:picMk id="13" creationId="{BEC86A83-28B4-77E5-B552-EFE05C4E0FF5}"/>
          </ac:picMkLst>
        </pc:picChg>
      </pc:sldChg>
      <pc:sldChg chg="addSp delSp modSp">
        <pc:chgData name="Laura Serbus" userId="S::lserbus@fiu.edu::bdce7c50-c5f9-47ca-b33a-5a97f0f798f6" providerId="AD" clId="Web-{319986E6-B82C-F8E0-F9B1-F9D4B4D0119D}" dt="2023-12-19T02:42:41.377" v="163"/>
        <pc:sldMkLst>
          <pc:docMk/>
          <pc:sldMk cId="2077986063" sldId="270"/>
        </pc:sldMkLst>
        <pc:spChg chg="topLvl">
          <ac:chgData name="Laura Serbus" userId="S::lserbus@fiu.edu::bdce7c50-c5f9-47ca-b33a-5a97f0f798f6" providerId="AD" clId="Web-{319986E6-B82C-F8E0-F9B1-F9D4B4D0119D}" dt="2023-12-19T02:38:44.339" v="147"/>
          <ac:spMkLst>
            <pc:docMk/>
            <pc:sldMk cId="2077986063" sldId="270"/>
            <ac:spMk id="3" creationId="{5254275A-054E-318F-51F7-92B30E9E9856}"/>
          </ac:spMkLst>
        </pc:spChg>
        <pc:spChg chg="add del mod">
          <ac:chgData name="Laura Serbus" userId="S::lserbus@fiu.edu::bdce7c50-c5f9-47ca-b33a-5a97f0f798f6" providerId="AD" clId="Web-{319986E6-B82C-F8E0-F9B1-F9D4B4D0119D}" dt="2023-12-19T02:38:30.604" v="145"/>
          <ac:spMkLst>
            <pc:docMk/>
            <pc:sldMk cId="2077986063" sldId="270"/>
            <ac:spMk id="4" creationId="{27BAC0AC-3DA5-CC40-C151-57716F24B84F}"/>
          </ac:spMkLst>
        </pc:spChg>
        <pc:spChg chg="mod">
          <ac:chgData name="Laura Serbus" userId="S::lserbus@fiu.edu::bdce7c50-c5f9-47ca-b33a-5a97f0f798f6" providerId="AD" clId="Web-{319986E6-B82C-F8E0-F9B1-F9D4B4D0119D}" dt="2023-12-19T02:39:32.122" v="155" actId="1076"/>
          <ac:spMkLst>
            <pc:docMk/>
            <pc:sldMk cId="2077986063" sldId="270"/>
            <ac:spMk id="5" creationId="{AC88D5EA-0829-4D14-2769-01B3FFF354E9}"/>
          </ac:spMkLst>
        </pc:spChg>
        <pc:spChg chg="mod topLvl">
          <ac:chgData name="Laura Serbus" userId="S::lserbus@fiu.edu::bdce7c50-c5f9-47ca-b33a-5a97f0f798f6" providerId="AD" clId="Web-{319986E6-B82C-F8E0-F9B1-F9D4B4D0119D}" dt="2023-12-19T02:42:41.377" v="163"/>
          <ac:spMkLst>
            <pc:docMk/>
            <pc:sldMk cId="2077986063" sldId="270"/>
            <ac:spMk id="94" creationId="{C373EB85-48A5-8476-A071-F2803D4DA8B5}"/>
          </ac:spMkLst>
        </pc:spChg>
        <pc:spChg chg="mod topLvl">
          <ac:chgData name="Laura Serbus" userId="S::lserbus@fiu.edu::bdce7c50-c5f9-47ca-b33a-5a97f0f798f6" providerId="AD" clId="Web-{319986E6-B82C-F8E0-F9B1-F9D4B4D0119D}" dt="2023-12-19T02:42:41.377" v="163"/>
          <ac:spMkLst>
            <pc:docMk/>
            <pc:sldMk cId="2077986063" sldId="270"/>
            <ac:spMk id="97" creationId="{B26044A9-F71E-FE8A-1C66-09665DE9CE44}"/>
          </ac:spMkLst>
        </pc:spChg>
        <pc:spChg chg="mod topLvl">
          <ac:chgData name="Laura Serbus" userId="S::lserbus@fiu.edu::bdce7c50-c5f9-47ca-b33a-5a97f0f798f6" providerId="AD" clId="Web-{319986E6-B82C-F8E0-F9B1-F9D4B4D0119D}" dt="2023-12-19T02:42:41.377" v="163"/>
          <ac:spMkLst>
            <pc:docMk/>
            <pc:sldMk cId="2077986063" sldId="270"/>
            <ac:spMk id="98" creationId="{31743183-E175-2637-8672-09B38A12806B}"/>
          </ac:spMkLst>
        </pc:spChg>
        <pc:spChg chg="mod topLvl">
          <ac:chgData name="Laura Serbus" userId="S::lserbus@fiu.edu::bdce7c50-c5f9-47ca-b33a-5a97f0f798f6" providerId="AD" clId="Web-{319986E6-B82C-F8E0-F9B1-F9D4B4D0119D}" dt="2023-12-19T02:42:41.377" v="163"/>
          <ac:spMkLst>
            <pc:docMk/>
            <pc:sldMk cId="2077986063" sldId="270"/>
            <ac:spMk id="99" creationId="{7C36451F-ADE6-3AFD-82D8-143C9AD9CE32}"/>
          </ac:spMkLst>
        </pc:spChg>
        <pc:spChg chg="mod topLvl">
          <ac:chgData name="Laura Serbus" userId="S::lserbus@fiu.edu::bdce7c50-c5f9-47ca-b33a-5a97f0f798f6" providerId="AD" clId="Web-{319986E6-B82C-F8E0-F9B1-F9D4B4D0119D}" dt="2023-12-19T02:42:41.377" v="163"/>
          <ac:spMkLst>
            <pc:docMk/>
            <pc:sldMk cId="2077986063" sldId="270"/>
            <ac:spMk id="104" creationId="{E4BB542C-F8A7-C00E-0EF2-D02AD77F5760}"/>
          </ac:spMkLst>
        </pc:spChg>
        <pc:grpChg chg="del">
          <ac:chgData name="Laura Serbus" userId="S::lserbus@fiu.edu::bdce7c50-c5f9-47ca-b33a-5a97f0f798f6" providerId="AD" clId="Web-{319986E6-B82C-F8E0-F9B1-F9D4B4D0119D}" dt="2023-12-19T02:38:44.339" v="147"/>
          <ac:grpSpMkLst>
            <pc:docMk/>
            <pc:sldMk cId="2077986063" sldId="270"/>
            <ac:grpSpMk id="2" creationId="{57A5D05F-AEB4-DC99-2268-DD3EC015FCC0}"/>
          </ac:grpSpMkLst>
        </pc:grpChg>
        <pc:grpChg chg="add del mod topLvl">
          <ac:chgData name="Laura Serbus" userId="S::lserbus@fiu.edu::bdce7c50-c5f9-47ca-b33a-5a97f0f798f6" providerId="AD" clId="Web-{319986E6-B82C-F8E0-F9B1-F9D4B4D0119D}" dt="2023-12-19T02:42:41.377" v="163"/>
          <ac:grpSpMkLst>
            <pc:docMk/>
            <pc:sldMk cId="2077986063" sldId="270"/>
            <ac:grpSpMk id="6" creationId="{89608B4F-95CD-044E-4750-FDC0FBE03215}"/>
          </ac:grpSpMkLst>
        </pc:grpChg>
        <pc:grpChg chg="add del topLvl">
          <ac:chgData name="Laura Serbus" userId="S::lserbus@fiu.edu::bdce7c50-c5f9-47ca-b33a-5a97f0f798f6" providerId="AD" clId="Web-{319986E6-B82C-F8E0-F9B1-F9D4B4D0119D}" dt="2023-12-19T02:38:53.761" v="150"/>
          <ac:grpSpMkLst>
            <pc:docMk/>
            <pc:sldMk cId="2077986063" sldId="270"/>
            <ac:grpSpMk id="10" creationId="{BA6D7284-626D-E9AE-B6FB-2104210F8C68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39:13.121" v="152" actId="1076"/>
          <ac:grpSpMkLst>
            <pc:docMk/>
            <pc:sldMk cId="2077986063" sldId="270"/>
            <ac:grpSpMk id="14" creationId="{847FAE20-2F48-32D4-A3B1-36B135FE6D7B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42:41.377" v="163"/>
          <ac:grpSpMkLst>
            <pc:docMk/>
            <pc:sldMk cId="2077986063" sldId="270"/>
            <ac:grpSpMk id="96" creationId="{54FABF9C-D61B-F78B-FA98-7FA1AF738314}"/>
          </ac:grpSpMkLst>
        </pc:grpChg>
        <pc:grpChg chg="mod topLvl">
          <ac:chgData name="Laura Serbus" userId="S::lserbus@fiu.edu::bdce7c50-c5f9-47ca-b33a-5a97f0f798f6" providerId="AD" clId="Web-{319986E6-B82C-F8E0-F9B1-F9D4B4D0119D}" dt="2023-12-19T02:42:41.377" v="163"/>
          <ac:grpSpMkLst>
            <pc:docMk/>
            <pc:sldMk cId="2077986063" sldId="270"/>
            <ac:grpSpMk id="100" creationId="{C3660A72-57BA-BB5F-5B27-710B2AF5D3A1}"/>
          </ac:grpSpMkLst>
        </pc:grpChg>
        <pc:picChg chg="mod topLvl modCrop">
          <ac:chgData name="Laura Serbus" userId="S::lserbus@fiu.edu::bdce7c50-c5f9-47ca-b33a-5a97f0f798f6" providerId="AD" clId="Web-{319986E6-B82C-F8E0-F9B1-F9D4B4D0119D}" dt="2023-12-19T02:39:23.309" v="154"/>
          <ac:picMkLst>
            <pc:docMk/>
            <pc:sldMk cId="2077986063" sldId="270"/>
            <ac:picMk id="11" creationId="{303B9EBA-BDF9-9442-C07A-A6AEDD3B10FA}"/>
          </ac:picMkLst>
        </pc:picChg>
        <pc:picChg chg="mod topLvl">
          <ac:chgData name="Laura Serbus" userId="S::lserbus@fiu.edu::bdce7c50-c5f9-47ca-b33a-5a97f0f798f6" providerId="AD" clId="Web-{319986E6-B82C-F8E0-F9B1-F9D4B4D0119D}" dt="2023-12-19T02:42:41.377" v="163"/>
          <ac:picMkLst>
            <pc:docMk/>
            <pc:sldMk cId="2077986063" sldId="270"/>
            <ac:picMk id="95" creationId="{EBA53448-2C79-3442-15F9-12AC5E9B6EE2}"/>
          </ac:picMkLst>
        </pc:picChg>
      </pc:sldChg>
      <pc:sldChg chg="add replId">
        <pc:chgData name="Laura Serbus" userId="S::lserbus@fiu.edu::bdce7c50-c5f9-47ca-b33a-5a97f0f798f6" providerId="AD" clId="Web-{319986E6-B82C-F8E0-F9B1-F9D4B4D0119D}" dt="2023-12-19T02:38:36.432" v="146"/>
        <pc:sldMkLst>
          <pc:docMk/>
          <pc:sldMk cId="3513443724" sldId="271"/>
        </pc:sldMkLst>
      </pc:sldChg>
    </pc:docChg>
  </pc:docChgLst>
  <pc:docChgLst>
    <pc:chgData name="Laura Ochoa" userId="59124860-347a-40b0-a9d2-c7a2e55c2f94" providerId="ADAL" clId="{7A49A105-D2DF-B642-9EB7-0B339745F503}"/>
    <pc:docChg chg="undo custSel addSld modSld sldOrd">
      <pc:chgData name="Laura Ochoa" userId="59124860-347a-40b0-a9d2-c7a2e55c2f94" providerId="ADAL" clId="{7A49A105-D2DF-B642-9EB7-0B339745F503}" dt="2023-12-16T21:46:06.719" v="192" actId="165"/>
      <pc:docMkLst>
        <pc:docMk/>
      </pc:docMkLst>
      <pc:sldChg chg="addSp delSp modSp mod ord">
        <pc:chgData name="Laura Ochoa" userId="59124860-347a-40b0-a9d2-c7a2e55c2f94" providerId="ADAL" clId="{7A49A105-D2DF-B642-9EB7-0B339745F503}" dt="2023-12-16T21:33:54.599" v="122" actId="1076"/>
        <pc:sldMkLst>
          <pc:docMk/>
          <pc:sldMk cId="1052726984" sldId="260"/>
        </pc:sldMkLst>
        <pc:spChg chg="add del mod">
          <ac:chgData name="Laura Ochoa" userId="59124860-347a-40b0-a9d2-c7a2e55c2f94" providerId="ADAL" clId="{7A49A105-D2DF-B642-9EB7-0B339745F503}" dt="2023-12-16T21:28:55.831" v="68" actId="478"/>
          <ac:spMkLst>
            <pc:docMk/>
            <pc:sldMk cId="1052726984" sldId="260"/>
            <ac:spMk id="3" creationId="{713DF2E1-5AF0-D0B8-134F-1711EE24F6C3}"/>
          </ac:spMkLst>
        </pc:spChg>
        <pc:spChg chg="add mod">
          <ac:chgData name="Laura Ochoa" userId="59124860-347a-40b0-a9d2-c7a2e55c2f94" providerId="ADAL" clId="{7A49A105-D2DF-B642-9EB7-0B339745F503}" dt="2023-12-16T21:28:56.584" v="69"/>
          <ac:spMkLst>
            <pc:docMk/>
            <pc:sldMk cId="1052726984" sldId="260"/>
            <ac:spMk id="4" creationId="{4286A1D8-9F77-1A11-4ACD-05110231477B}"/>
          </ac:spMkLst>
        </pc:spChg>
        <pc:spChg chg="add mod">
          <ac:chgData name="Laura Ochoa" userId="59124860-347a-40b0-a9d2-c7a2e55c2f94" providerId="ADAL" clId="{7A49A105-D2DF-B642-9EB7-0B339745F503}" dt="2023-12-16T21:29:31.866" v="88" actId="404"/>
          <ac:spMkLst>
            <pc:docMk/>
            <pc:sldMk cId="1052726984" sldId="260"/>
            <ac:spMk id="19" creationId="{57D52679-2823-4555-A553-CB5FB405BB4A}"/>
          </ac:spMkLst>
        </pc:spChg>
        <pc:spChg chg="add mod">
          <ac:chgData name="Laura Ochoa" userId="59124860-347a-40b0-a9d2-c7a2e55c2f94" providerId="ADAL" clId="{7A49A105-D2DF-B642-9EB7-0B339745F503}" dt="2023-12-16T21:31:29.128" v="110" actId="1076"/>
          <ac:spMkLst>
            <pc:docMk/>
            <pc:sldMk cId="1052726984" sldId="260"/>
            <ac:spMk id="22" creationId="{D53B1113-3B1A-D73D-8F01-A2C0FCA8126A}"/>
          </ac:spMkLst>
        </pc:spChg>
        <pc:picChg chg="del">
          <ac:chgData name="Laura Ochoa" userId="59124860-347a-40b0-a9d2-c7a2e55c2f94" providerId="ADAL" clId="{7A49A105-D2DF-B642-9EB7-0B339745F503}" dt="2023-12-16T21:28:04.278" v="57" actId="478"/>
          <ac:picMkLst>
            <pc:docMk/>
            <pc:sldMk cId="1052726984" sldId="260"/>
            <ac:picMk id="2" creationId="{7204FBDD-C1BD-6B1C-F7D5-7B5D2F55F812}"/>
          </ac:picMkLst>
        </pc:picChg>
        <pc:picChg chg="add mod">
          <ac:chgData name="Laura Ochoa" userId="59124860-347a-40b0-a9d2-c7a2e55c2f94" providerId="ADAL" clId="{7A49A105-D2DF-B642-9EB7-0B339745F503}" dt="2023-12-16T21:33:37.117" v="116" actId="14100"/>
          <ac:picMkLst>
            <pc:docMk/>
            <pc:sldMk cId="1052726984" sldId="260"/>
            <ac:picMk id="17" creationId="{E7CF9923-6731-EE52-777C-53ED69ED7299}"/>
          </ac:picMkLst>
        </pc:picChg>
        <pc:picChg chg="add mod">
          <ac:chgData name="Laura Ochoa" userId="59124860-347a-40b0-a9d2-c7a2e55c2f94" providerId="ADAL" clId="{7A49A105-D2DF-B642-9EB7-0B339745F503}" dt="2023-12-16T21:31:19.451" v="92" actId="1076"/>
          <ac:picMkLst>
            <pc:docMk/>
            <pc:sldMk cId="1052726984" sldId="260"/>
            <ac:picMk id="21" creationId="{7B9F38B2-0C34-7A0C-08F7-DE3CA8CF1ECB}"/>
          </ac:picMkLst>
        </pc:picChg>
        <pc:picChg chg="add del mod">
          <ac:chgData name="Laura Ochoa" userId="59124860-347a-40b0-a9d2-c7a2e55c2f94" providerId="ADAL" clId="{7A49A105-D2DF-B642-9EB7-0B339745F503}" dt="2023-12-16T21:33:28.844" v="115" actId="478"/>
          <ac:picMkLst>
            <pc:docMk/>
            <pc:sldMk cId="1052726984" sldId="260"/>
            <ac:picMk id="24" creationId="{4D4A5E30-2DA9-5F28-002F-919365ABABDA}"/>
          </ac:picMkLst>
        </pc:picChg>
        <pc:picChg chg="add mod">
          <ac:chgData name="Laura Ochoa" userId="59124860-347a-40b0-a9d2-c7a2e55c2f94" providerId="ADAL" clId="{7A49A105-D2DF-B642-9EB7-0B339745F503}" dt="2023-12-16T21:33:54.599" v="122" actId="1076"/>
          <ac:picMkLst>
            <pc:docMk/>
            <pc:sldMk cId="1052726984" sldId="260"/>
            <ac:picMk id="26" creationId="{72FB2CC0-2F39-0E66-57C1-D2ACB1EB2321}"/>
          </ac:picMkLst>
        </pc:picChg>
      </pc:sldChg>
      <pc:sldChg chg="addSp delSp modSp mod">
        <pc:chgData name="Laura Ochoa" userId="59124860-347a-40b0-a9d2-c7a2e55c2f94" providerId="ADAL" clId="{7A49A105-D2DF-B642-9EB7-0B339745F503}" dt="2023-12-16T21:46:06.719" v="192" actId="165"/>
        <pc:sldMkLst>
          <pc:docMk/>
          <pc:sldMk cId="2904938040" sldId="263"/>
        </pc:sldMkLst>
        <pc:spChg chg="mod">
          <ac:chgData name="Laura Ochoa" userId="59124860-347a-40b0-a9d2-c7a2e55c2f94" providerId="ADAL" clId="{7A49A105-D2DF-B642-9EB7-0B339745F503}" dt="2023-12-16T21:42:12.661" v="147" actId="1076"/>
          <ac:spMkLst>
            <pc:docMk/>
            <pc:sldMk cId="2904938040" sldId="263"/>
            <ac:spMk id="4" creationId="{7AD0E6FC-63DB-3C49-4539-EB08E7AFA66D}"/>
          </ac:spMkLst>
        </pc:spChg>
        <pc:spChg chg="add del mod">
          <ac:chgData name="Laura Ochoa" userId="59124860-347a-40b0-a9d2-c7a2e55c2f94" providerId="ADAL" clId="{7A49A105-D2DF-B642-9EB7-0B339745F503}" dt="2023-12-16T21:41:47.561" v="140" actId="478"/>
          <ac:spMkLst>
            <pc:docMk/>
            <pc:sldMk cId="2904938040" sldId="263"/>
            <ac:spMk id="38" creationId="{0B4160DD-C90E-6F71-6262-0A502ACABA28}"/>
          </ac:spMkLst>
        </pc:spChg>
        <pc:spChg chg="add mod">
          <ac:chgData name="Laura Ochoa" userId="59124860-347a-40b0-a9d2-c7a2e55c2f94" providerId="ADAL" clId="{7A49A105-D2DF-B642-9EB7-0B339745F503}" dt="2023-12-16T21:41:55.976" v="142" actId="1076"/>
          <ac:spMkLst>
            <pc:docMk/>
            <pc:sldMk cId="2904938040" sldId="263"/>
            <ac:spMk id="40" creationId="{D07E1ECC-85CB-CA6A-6CB0-0F79324FF29A}"/>
          </ac:spMkLst>
        </pc:spChg>
        <pc:spChg chg="add mod topLvl">
          <ac:chgData name="Laura Ochoa" userId="59124860-347a-40b0-a9d2-c7a2e55c2f94" providerId="ADAL" clId="{7A49A105-D2DF-B642-9EB7-0B339745F503}" dt="2023-12-16T21:46:06.719" v="192" actId="165"/>
          <ac:spMkLst>
            <pc:docMk/>
            <pc:sldMk cId="2904938040" sldId="263"/>
            <ac:spMk id="45" creationId="{EA62A79B-6716-C16A-4A92-DD7A7EC220C9}"/>
          </ac:spMkLst>
        </pc:spChg>
        <pc:spChg chg="mod">
          <ac:chgData name="Laura Ochoa" userId="59124860-347a-40b0-a9d2-c7a2e55c2f94" providerId="ADAL" clId="{7A49A105-D2DF-B642-9EB7-0B339745F503}" dt="2023-12-16T21:42:07.726" v="145" actId="1076"/>
          <ac:spMkLst>
            <pc:docMk/>
            <pc:sldMk cId="2904938040" sldId="263"/>
            <ac:spMk id="64" creationId="{6670B70A-5F29-9FDC-C7B0-165265F62183}"/>
          </ac:spMkLst>
        </pc:spChg>
        <pc:grpChg chg="add mod topLvl">
          <ac:chgData name="Laura Ochoa" userId="59124860-347a-40b0-a9d2-c7a2e55c2f94" providerId="ADAL" clId="{7A49A105-D2DF-B642-9EB7-0B339745F503}" dt="2023-12-16T21:46:06.719" v="192" actId="165"/>
          <ac:grpSpMkLst>
            <pc:docMk/>
            <pc:sldMk cId="2904938040" sldId="263"/>
            <ac:grpSpMk id="41" creationId="{C241C9D1-C0AB-F1BF-1552-DCB05FF7FBDB}"/>
          </ac:grpSpMkLst>
        </pc:grpChg>
        <pc:grpChg chg="add del mod">
          <ac:chgData name="Laura Ochoa" userId="59124860-347a-40b0-a9d2-c7a2e55c2f94" providerId="ADAL" clId="{7A49A105-D2DF-B642-9EB7-0B339745F503}" dt="2023-12-16T21:46:06.719" v="192" actId="165"/>
          <ac:grpSpMkLst>
            <pc:docMk/>
            <pc:sldMk cId="2904938040" sldId="263"/>
            <ac:grpSpMk id="46" creationId="{C5C6C2D2-AD1C-AC00-7CB7-C983917FAB2A}"/>
          </ac:grpSpMkLst>
        </pc:grpChg>
        <pc:picChg chg="mod">
          <ac:chgData name="Laura Ochoa" userId="59124860-347a-40b0-a9d2-c7a2e55c2f94" providerId="ADAL" clId="{7A49A105-D2DF-B642-9EB7-0B339745F503}" dt="2023-12-16T21:18:42.521" v="18" actId="1076"/>
          <ac:picMkLst>
            <pc:docMk/>
            <pc:sldMk cId="2904938040" sldId="263"/>
            <ac:picMk id="3" creationId="{2C4743B9-5992-0DBB-0F51-818FF41F039F}"/>
          </ac:picMkLst>
        </pc:picChg>
        <pc:picChg chg="del">
          <ac:chgData name="Laura Ochoa" userId="59124860-347a-40b0-a9d2-c7a2e55c2f94" providerId="ADAL" clId="{7A49A105-D2DF-B642-9EB7-0B339745F503}" dt="2023-12-16T21:27:59.868" v="56" actId="478"/>
          <ac:picMkLst>
            <pc:docMk/>
            <pc:sldMk cId="2904938040" sldId="263"/>
            <ac:picMk id="34" creationId="{33E871C6-834E-B886-3DB7-C3159969071B}"/>
          </ac:picMkLst>
        </pc:picChg>
        <pc:picChg chg="add del mod">
          <ac:chgData name="Laura Ochoa" userId="59124860-347a-40b0-a9d2-c7a2e55c2f94" providerId="ADAL" clId="{7A49A105-D2DF-B642-9EB7-0B339745F503}" dt="2023-12-16T21:25:30.370" v="55" actId="478"/>
          <ac:picMkLst>
            <pc:docMk/>
            <pc:sldMk cId="2904938040" sldId="263"/>
            <ac:picMk id="34" creationId="{92252EAE-7261-7D02-4A00-BA2B84C3E304}"/>
          </ac:picMkLst>
        </pc:picChg>
        <pc:picChg chg="add mod">
          <ac:chgData name="Laura Ochoa" userId="59124860-347a-40b0-a9d2-c7a2e55c2f94" providerId="ADAL" clId="{7A49A105-D2DF-B642-9EB7-0B339745F503}" dt="2023-12-16T21:41:35.711" v="137" actId="1035"/>
          <ac:picMkLst>
            <pc:docMk/>
            <pc:sldMk cId="2904938040" sldId="263"/>
            <ac:picMk id="39" creationId="{41990938-B71E-5BB7-25CC-769683E57457}"/>
          </ac:picMkLst>
        </pc:picChg>
        <pc:picChg chg="add mod topLvl">
          <ac:chgData name="Laura Ochoa" userId="59124860-347a-40b0-a9d2-c7a2e55c2f94" providerId="ADAL" clId="{7A49A105-D2DF-B642-9EB7-0B339745F503}" dt="2023-12-16T21:46:06.719" v="192" actId="165"/>
          <ac:picMkLst>
            <pc:docMk/>
            <pc:sldMk cId="2904938040" sldId="263"/>
            <ac:picMk id="44" creationId="{8C459EAA-6EA3-CF02-6CE3-96B0F624D567}"/>
          </ac:picMkLst>
        </pc:picChg>
      </pc:sldChg>
      <pc:sldChg chg="addSp delSp modSp add mod">
        <pc:chgData name="Laura Ochoa" userId="59124860-347a-40b0-a9d2-c7a2e55c2f94" providerId="ADAL" clId="{7A49A105-D2DF-B642-9EB7-0B339745F503}" dt="2023-12-16T21:41:14.061" v="133" actId="14100"/>
        <pc:sldMkLst>
          <pc:docMk/>
          <pc:sldMk cId="1714014568" sldId="264"/>
        </pc:sldMkLst>
        <pc:picChg chg="add mod">
          <ac:chgData name="Laura Ochoa" userId="59124860-347a-40b0-a9d2-c7a2e55c2f94" providerId="ADAL" clId="{7A49A105-D2DF-B642-9EB7-0B339745F503}" dt="2023-12-16T21:41:14.061" v="133" actId="14100"/>
          <ac:picMkLst>
            <pc:docMk/>
            <pc:sldMk cId="1714014568" sldId="264"/>
            <ac:picMk id="3" creationId="{02629BD8-5FED-3D2F-03CB-C7855E423C11}"/>
          </ac:picMkLst>
        </pc:picChg>
        <pc:picChg chg="del">
          <ac:chgData name="Laura Ochoa" userId="59124860-347a-40b0-a9d2-c7a2e55c2f94" providerId="ADAL" clId="{7A49A105-D2DF-B642-9EB7-0B339745F503}" dt="2023-12-16T21:40:35.210" v="124" actId="478"/>
          <ac:picMkLst>
            <pc:docMk/>
            <pc:sldMk cId="1714014568" sldId="264"/>
            <ac:picMk id="17" creationId="{E7CF9923-6731-EE52-777C-53ED69ED7299}"/>
          </ac:picMkLst>
        </pc:picChg>
        <pc:picChg chg="del">
          <ac:chgData name="Laura Ochoa" userId="59124860-347a-40b0-a9d2-c7a2e55c2f94" providerId="ADAL" clId="{7A49A105-D2DF-B642-9EB7-0B339745F503}" dt="2023-12-16T21:40:35.706" v="125" actId="478"/>
          <ac:picMkLst>
            <pc:docMk/>
            <pc:sldMk cId="1714014568" sldId="264"/>
            <ac:picMk id="21" creationId="{7B9F38B2-0C34-7A0C-08F7-DE3CA8CF1ECB}"/>
          </ac:picMkLst>
        </pc:picChg>
        <pc:picChg chg="del">
          <ac:chgData name="Laura Ochoa" userId="59124860-347a-40b0-a9d2-c7a2e55c2f94" providerId="ADAL" clId="{7A49A105-D2DF-B642-9EB7-0B339745F503}" dt="2023-12-16T21:40:36.710" v="126" actId="478"/>
          <ac:picMkLst>
            <pc:docMk/>
            <pc:sldMk cId="1714014568" sldId="264"/>
            <ac:picMk id="26" creationId="{72FB2CC0-2F39-0E66-57C1-D2ACB1EB2321}"/>
          </ac:picMkLst>
        </pc:picChg>
      </pc:sldChg>
    </pc:docChg>
  </pc:docChgLst>
  <pc:docChgLst>
    <pc:chgData name="Laura Ochoa" userId="S::locho016@fiu.edu::59124860-347a-40b0-a9d2-c7a2e55c2f94" providerId="AD" clId="Web-{426577D0-2C65-CF87-3FBD-553F46D63A59}"/>
    <pc:docChg chg="addSld modSld">
      <pc:chgData name="Laura Ochoa" userId="S::locho016@fiu.edu::59124860-347a-40b0-a9d2-c7a2e55c2f94" providerId="AD" clId="Web-{426577D0-2C65-CF87-3FBD-553F46D63A59}" dt="2023-12-16T22:05:24.167" v="3" actId="1076"/>
      <pc:docMkLst>
        <pc:docMk/>
      </pc:docMkLst>
      <pc:sldChg chg="delSp modSp add replId">
        <pc:chgData name="Laura Ochoa" userId="S::locho016@fiu.edu::59124860-347a-40b0-a9d2-c7a2e55c2f94" providerId="AD" clId="Web-{426577D0-2C65-CF87-3FBD-553F46D63A59}" dt="2023-12-16T22:05:24.167" v="3" actId="1076"/>
        <pc:sldMkLst>
          <pc:docMk/>
          <pc:sldMk cId="3958759317" sldId="265"/>
        </pc:sldMkLst>
        <pc:spChg chg="mod">
          <ac:chgData name="Laura Ochoa" userId="S::locho016@fiu.edu::59124860-347a-40b0-a9d2-c7a2e55c2f94" providerId="AD" clId="Web-{426577D0-2C65-CF87-3FBD-553F46D63A59}" dt="2023-12-16T22:05:24.167" v="3" actId="1076"/>
          <ac:spMkLst>
            <pc:docMk/>
            <pc:sldMk cId="3958759317" sldId="265"/>
            <ac:spMk id="8" creationId="{9DCB5C82-ABCE-4F58-6840-B68006E3CE33}"/>
          </ac:spMkLst>
        </pc:spChg>
        <pc:grpChg chg="del">
          <ac:chgData name="Laura Ochoa" userId="S::locho016@fiu.edu::59124860-347a-40b0-a9d2-c7a2e55c2f94" providerId="AD" clId="Web-{426577D0-2C65-CF87-3FBD-553F46D63A59}" dt="2023-12-16T22:05:12.589" v="1"/>
          <ac:grpSpMkLst>
            <pc:docMk/>
            <pc:sldMk cId="3958759317" sldId="265"/>
            <ac:grpSpMk id="5" creationId="{5C4F3FBF-D50A-A2BE-A668-A55E9E857A2B}"/>
          </ac:grpSpMkLst>
        </pc:grpChg>
        <pc:picChg chg="del">
          <ac:chgData name="Laura Ochoa" userId="S::locho016@fiu.edu::59124860-347a-40b0-a9d2-c7a2e55c2f94" providerId="AD" clId="Web-{426577D0-2C65-CF87-3FBD-553F46D63A59}" dt="2023-12-16T22:05:13.979" v="2"/>
          <ac:picMkLst>
            <pc:docMk/>
            <pc:sldMk cId="3958759317" sldId="265"/>
            <ac:picMk id="28" creationId="{FE475C4E-5808-1DDF-A2BC-2D78BB7C873C}"/>
          </ac:picMkLst>
        </pc:picChg>
      </pc:sldChg>
    </pc:docChg>
  </pc:docChgLst>
  <pc:docChgLst>
    <pc:chgData name="Laura Ochoa" userId="S::locho016@fiu.edu::59124860-347a-40b0-a9d2-c7a2e55c2f94" providerId="AD" clId="Web-{1649778C-4075-5D2B-6ED3-1134E6C6BB9A}"/>
    <pc:docChg chg="modSld">
      <pc:chgData name="Laura Ochoa" userId="S::locho016@fiu.edu::59124860-347a-40b0-a9d2-c7a2e55c2f94" providerId="AD" clId="Web-{1649778C-4075-5D2B-6ED3-1134E6C6BB9A}" dt="2023-12-19T02:34:34.988" v="58"/>
      <pc:docMkLst>
        <pc:docMk/>
      </pc:docMkLst>
      <pc:sldChg chg="addSp delSp modSp">
        <pc:chgData name="Laura Ochoa" userId="S::locho016@fiu.edu::59124860-347a-40b0-a9d2-c7a2e55c2f94" providerId="AD" clId="Web-{1649778C-4075-5D2B-6ED3-1134E6C6BB9A}" dt="2023-12-19T02:34:34.988" v="58"/>
        <pc:sldMkLst>
          <pc:docMk/>
          <pc:sldMk cId="1756382141" sldId="268"/>
        </pc:sldMkLst>
        <pc:spChg chg="add del mod">
          <ac:chgData name="Laura Ochoa" userId="S::locho016@fiu.edu::59124860-347a-40b0-a9d2-c7a2e55c2f94" providerId="AD" clId="Web-{1649778C-4075-5D2B-6ED3-1134E6C6BB9A}" dt="2023-12-19T02:34:34.988" v="58"/>
          <ac:spMkLst>
            <pc:docMk/>
            <pc:sldMk cId="1756382141" sldId="268"/>
            <ac:spMk id="4" creationId="{DE097729-F18E-620C-D120-2A0518962EB0}"/>
          </ac:spMkLst>
        </pc:spChg>
      </pc:sldChg>
    </pc:docChg>
  </pc:docChgLst>
  <pc:docChgLst>
    <pc:chgData name="Laura Ochoa" userId="59124860-347a-40b0-a9d2-c7a2e55c2f94" providerId="ADAL" clId="{64256F12-2289-5549-81F4-B77BBE3D9D97}"/>
    <pc:docChg chg="undo custSel addSld delSld modSld">
      <pc:chgData name="Laura Ochoa" userId="59124860-347a-40b0-a9d2-c7a2e55c2f94" providerId="ADAL" clId="{64256F12-2289-5549-81F4-B77BBE3D9D97}" dt="2023-12-19T02:58:16.414" v="455" actId="2696"/>
      <pc:docMkLst>
        <pc:docMk/>
      </pc:docMkLst>
      <pc:sldChg chg="addSp delSp modSp mod">
        <pc:chgData name="Laura Ochoa" userId="59124860-347a-40b0-a9d2-c7a2e55c2f94" providerId="ADAL" clId="{64256F12-2289-5549-81F4-B77BBE3D9D97}" dt="2023-12-19T02:57:46.981" v="453" actId="164"/>
        <pc:sldMkLst>
          <pc:docMk/>
          <pc:sldMk cId="1756382141" sldId="268"/>
        </pc:sldMkLst>
        <pc:spChg chg="add del mod">
          <ac:chgData name="Laura Ochoa" userId="59124860-347a-40b0-a9d2-c7a2e55c2f94" providerId="ADAL" clId="{64256F12-2289-5549-81F4-B77BBE3D9D97}" dt="2023-12-19T02:56:51.010" v="400" actId="478"/>
          <ac:spMkLst>
            <pc:docMk/>
            <pc:sldMk cId="1756382141" sldId="268"/>
            <ac:spMk id="5" creationId="{AC88D5EA-0829-4D14-2769-01B3FFF354E9}"/>
          </ac:spMkLst>
        </pc:spChg>
        <pc:spChg chg="add mod">
          <ac:chgData name="Laura Ochoa" userId="59124860-347a-40b0-a9d2-c7a2e55c2f94" providerId="ADAL" clId="{64256F12-2289-5549-81F4-B77BBE3D9D97}" dt="2023-12-19T02:57:30.310" v="452" actId="20577"/>
          <ac:spMkLst>
            <pc:docMk/>
            <pc:sldMk cId="1756382141" sldId="268"/>
            <ac:spMk id="7" creationId="{F34DA111-F84F-D436-6DF5-2A9B7C0837FF}"/>
          </ac:spMkLst>
        </pc:spChg>
        <pc:spChg chg="add del mod">
          <ac:chgData name="Laura Ochoa" userId="59124860-347a-40b0-a9d2-c7a2e55c2f94" providerId="ADAL" clId="{64256F12-2289-5549-81F4-B77BBE3D9D97}" dt="2023-12-19T02:56:55.020" v="402" actId="478"/>
          <ac:spMkLst>
            <pc:docMk/>
            <pc:sldMk cId="1756382141" sldId="268"/>
            <ac:spMk id="65" creationId="{32A544BC-904D-6291-2848-62896A2822C3}"/>
          </ac:spMkLst>
        </pc:spChg>
        <pc:spChg chg="add del mod">
          <ac:chgData name="Laura Ochoa" userId="59124860-347a-40b0-a9d2-c7a2e55c2f94" providerId="ADAL" clId="{64256F12-2289-5549-81F4-B77BBE3D9D97}" dt="2023-12-19T02:56:50.012" v="399" actId="478"/>
          <ac:spMkLst>
            <pc:docMk/>
            <pc:sldMk cId="1756382141" sldId="268"/>
            <ac:spMk id="66" creationId="{8C6CA8E5-29CC-6AD0-9156-7569101DC5F6}"/>
          </ac:spMkLst>
        </pc:spChg>
        <pc:spChg chg="add del mod">
          <ac:chgData name="Laura Ochoa" userId="59124860-347a-40b0-a9d2-c7a2e55c2f94" providerId="ADAL" clId="{64256F12-2289-5549-81F4-B77BBE3D9D97}" dt="2023-12-19T02:56:48.012" v="398" actId="478"/>
          <ac:spMkLst>
            <pc:docMk/>
            <pc:sldMk cId="1756382141" sldId="268"/>
            <ac:spMk id="91" creationId="{4C2A0E7D-74F2-5C9E-FABF-A661A6555930}"/>
          </ac:spMkLst>
        </pc:spChg>
        <pc:spChg chg="add del mod">
          <ac:chgData name="Laura Ochoa" userId="59124860-347a-40b0-a9d2-c7a2e55c2f94" providerId="ADAL" clId="{64256F12-2289-5549-81F4-B77BBE3D9D97}" dt="2023-12-19T02:56:52.411" v="401" actId="478"/>
          <ac:spMkLst>
            <pc:docMk/>
            <pc:sldMk cId="1756382141" sldId="268"/>
            <ac:spMk id="92" creationId="{446D135B-FF64-01BD-76A4-549892B9746E}"/>
          </ac:spMkLst>
        </pc:spChg>
        <pc:spChg chg="mod">
          <ac:chgData name="Laura Ochoa" userId="59124860-347a-40b0-a9d2-c7a2e55c2f94" providerId="ADAL" clId="{64256F12-2289-5549-81F4-B77BBE3D9D97}" dt="2023-12-19T02:36:18.232" v="43" actId="478"/>
          <ac:spMkLst>
            <pc:docMk/>
            <pc:sldMk cId="1756382141" sldId="268"/>
            <ac:spMk id="93" creationId="{84EF83F8-3B79-822D-9C24-93DF3F9279F2}"/>
          </ac:spMkLst>
        </pc:spChg>
        <pc:grpChg chg="add">
          <ac:chgData name="Laura Ochoa" userId="59124860-347a-40b0-a9d2-c7a2e55c2f94" providerId="ADAL" clId="{64256F12-2289-5549-81F4-B77BBE3D9D97}" dt="2023-12-19T02:57:46.981" v="453" actId="164"/>
          <ac:grpSpMkLst>
            <pc:docMk/>
            <pc:sldMk cId="1756382141" sldId="268"/>
            <ac:grpSpMk id="8" creationId="{710104E2-3FF4-202A-ED36-D7246BD5D190}"/>
          </ac:grpSpMkLst>
        </pc:grpChg>
        <pc:grpChg chg="add del">
          <ac:chgData name="Laura Ochoa" userId="59124860-347a-40b0-a9d2-c7a2e55c2f94" providerId="ADAL" clId="{64256F12-2289-5549-81F4-B77BBE3D9D97}" dt="2023-12-19T02:56:52.411" v="401" actId="478"/>
          <ac:grpSpMkLst>
            <pc:docMk/>
            <pc:sldMk cId="1756382141" sldId="268"/>
            <ac:grpSpMk id="22" creationId="{0F87C3F2-92BF-B6BC-1B61-84EC1EE3202A}"/>
          </ac:grpSpMkLst>
        </pc:grpChg>
      </pc:sldChg>
      <pc:sldChg chg="addSp modSp add del mod">
        <pc:chgData name="Laura Ochoa" userId="59124860-347a-40b0-a9d2-c7a2e55c2f94" providerId="ADAL" clId="{64256F12-2289-5549-81F4-B77BBE3D9D97}" dt="2023-12-19T02:58:15.292" v="454" actId="2696"/>
        <pc:sldMkLst>
          <pc:docMk/>
          <pc:sldMk cId="2077986063" sldId="270"/>
        </pc:sldMkLst>
        <pc:spChg chg="mod">
          <ac:chgData name="Laura Ochoa" userId="59124860-347a-40b0-a9d2-c7a2e55c2f94" providerId="ADAL" clId="{64256F12-2289-5549-81F4-B77BBE3D9D97}" dt="2023-12-19T02:55:20.713" v="273" actId="20577"/>
          <ac:spMkLst>
            <pc:docMk/>
            <pc:sldMk cId="2077986063" sldId="270"/>
            <ac:spMk id="5" creationId="{AC88D5EA-0829-4D14-2769-01B3FFF354E9}"/>
          </ac:spMkLst>
        </pc:spChg>
        <pc:spChg chg="add mod">
          <ac:chgData name="Laura Ochoa" userId="59124860-347a-40b0-a9d2-c7a2e55c2f94" providerId="ADAL" clId="{64256F12-2289-5549-81F4-B77BBE3D9D97}" dt="2023-12-19T02:55:56.061" v="394" actId="1036"/>
          <ac:spMkLst>
            <pc:docMk/>
            <pc:sldMk cId="2077986063" sldId="270"/>
            <ac:spMk id="81" creationId="{984EB447-3448-890A-4725-F03769A3C38D}"/>
          </ac:spMkLst>
        </pc:spChg>
        <pc:grpChg chg="add mod">
          <ac:chgData name="Laura Ochoa" userId="59124860-347a-40b0-a9d2-c7a2e55c2f94" providerId="ADAL" clId="{64256F12-2289-5549-81F4-B77BBE3D9D97}" dt="2023-12-19T02:56:19.869" v="397" actId="1038"/>
          <ac:grpSpMkLst>
            <pc:docMk/>
            <pc:sldMk cId="2077986063" sldId="270"/>
            <ac:grpSpMk id="82" creationId="{96E3ABCE-8070-3D61-F0E3-145561C28BFB}"/>
          </ac:grpSpMkLst>
        </pc:grpChg>
        <pc:picChg chg="mod modCrop">
          <ac:chgData name="Laura Ochoa" userId="59124860-347a-40b0-a9d2-c7a2e55c2f94" providerId="ADAL" clId="{64256F12-2289-5549-81F4-B77BBE3D9D97}" dt="2023-12-19T02:56:05.359" v="395" actId="732"/>
          <ac:picMkLst>
            <pc:docMk/>
            <pc:sldMk cId="2077986063" sldId="270"/>
            <ac:picMk id="11" creationId="{303B9EBA-BDF9-9442-C07A-A6AEDD3B10FA}"/>
          </ac:picMkLst>
        </pc:picChg>
      </pc:sldChg>
      <pc:sldChg chg="del">
        <pc:chgData name="Laura Ochoa" userId="59124860-347a-40b0-a9d2-c7a2e55c2f94" providerId="ADAL" clId="{64256F12-2289-5549-81F4-B77BBE3D9D97}" dt="2023-12-19T02:58:16.414" v="455" actId="2696"/>
        <pc:sldMkLst>
          <pc:docMk/>
          <pc:sldMk cId="3513443724" sldId="271"/>
        </pc:sldMkLst>
      </pc:sldChg>
    </pc:docChg>
  </pc:docChgLst>
  <pc:docChgLst>
    <pc:chgData name="Laura Ochoa" userId="S::locho016@fiu.edu::59124860-347a-40b0-a9d2-c7a2e55c2f94" providerId="AD" clId="Web-{7473EA1C-E13E-A350-69BC-470D0ADE5241}"/>
    <pc:docChg chg="modSld">
      <pc:chgData name="Laura Ochoa" userId="S::locho016@fiu.edu::59124860-347a-40b0-a9d2-c7a2e55c2f94" providerId="AD" clId="Web-{7473EA1C-E13E-A350-69BC-470D0ADE5241}" dt="2023-12-18T23:13:07.904" v="34" actId="1076"/>
      <pc:docMkLst>
        <pc:docMk/>
      </pc:docMkLst>
      <pc:sldChg chg="addSp modSp">
        <pc:chgData name="Laura Ochoa" userId="S::locho016@fiu.edu::59124860-347a-40b0-a9d2-c7a2e55c2f94" providerId="AD" clId="Web-{7473EA1C-E13E-A350-69BC-470D0ADE5241}" dt="2023-12-18T23:13:07.904" v="34" actId="1076"/>
        <pc:sldMkLst>
          <pc:docMk/>
          <pc:sldMk cId="3958759317" sldId="265"/>
        </pc:sldMkLst>
        <pc:spChg chg="add mod">
          <ac:chgData name="Laura Ochoa" userId="S::locho016@fiu.edu::59124860-347a-40b0-a9d2-c7a2e55c2f94" providerId="AD" clId="Web-{7473EA1C-E13E-A350-69BC-470D0ADE5241}" dt="2023-12-18T23:13:07.904" v="34" actId="1076"/>
          <ac:spMkLst>
            <pc:docMk/>
            <pc:sldMk cId="3958759317" sldId="265"/>
            <ac:spMk id="3" creationId="{1DCBB027-6A68-06BF-1070-FF8A0E271B48}"/>
          </ac:spMkLst>
        </pc:spChg>
        <pc:spChg chg="mod">
          <ac:chgData name="Laura Ochoa" userId="S::locho016@fiu.edu::59124860-347a-40b0-a9d2-c7a2e55c2f94" providerId="AD" clId="Web-{7473EA1C-E13E-A350-69BC-470D0ADE5241}" dt="2023-12-18T23:11:19.631" v="3" actId="1076"/>
          <ac:spMkLst>
            <pc:docMk/>
            <pc:sldMk cId="3958759317" sldId="265"/>
            <ac:spMk id="59" creationId="{E913963E-3463-3A37-9513-4A12091CE393}"/>
          </ac:spMkLst>
        </pc:spChg>
        <pc:grpChg chg="mod">
          <ac:chgData name="Laura Ochoa" userId="S::locho016@fiu.edu::59124860-347a-40b0-a9d2-c7a2e55c2f94" providerId="AD" clId="Web-{7473EA1C-E13E-A350-69BC-470D0ADE5241}" dt="2023-12-18T23:11:11.052" v="1" actId="1076"/>
          <ac:grpSpMkLst>
            <pc:docMk/>
            <pc:sldMk cId="3958759317" sldId="265"/>
            <ac:grpSpMk id="31" creationId="{630E7D5F-F89F-B8DE-6413-E418E9B68B31}"/>
          </ac:grpSpMkLst>
        </pc:grpChg>
      </pc:sldChg>
    </pc:docChg>
  </pc:docChgLst>
  <pc:docChgLst>
    <pc:chgData name="Laura Ochoa" userId="59124860-347a-40b0-a9d2-c7a2e55c2f94" providerId="ADAL" clId="{67A63A88-7D7A-7647-9E34-31F962E7FC9C}"/>
    <pc:docChg chg="undo redo custSel addSld delSld modSld sldOrd">
      <pc:chgData name="Laura Ochoa" userId="59124860-347a-40b0-a9d2-c7a2e55c2f94" providerId="ADAL" clId="{67A63A88-7D7A-7647-9E34-31F962E7FC9C}" dt="2023-12-19T02:05:28.801" v="2549" actId="20578"/>
      <pc:docMkLst>
        <pc:docMk/>
      </pc:docMkLst>
      <pc:sldChg chg="add del">
        <pc:chgData name="Laura Ochoa" userId="59124860-347a-40b0-a9d2-c7a2e55c2f94" providerId="ADAL" clId="{67A63A88-7D7A-7647-9E34-31F962E7FC9C}" dt="2023-12-17T14:29:04.001" v="1272" actId="2696"/>
        <pc:sldMkLst>
          <pc:docMk/>
          <pc:sldMk cId="271627983" sldId="256"/>
        </pc:sldMkLst>
      </pc:sldChg>
      <pc:sldChg chg="del">
        <pc:chgData name="Laura Ochoa" userId="59124860-347a-40b0-a9d2-c7a2e55c2f94" providerId="ADAL" clId="{67A63A88-7D7A-7647-9E34-31F962E7FC9C}" dt="2023-12-16T22:31:35.368" v="746" actId="2696"/>
        <pc:sldMkLst>
          <pc:docMk/>
          <pc:sldMk cId="1052726984" sldId="260"/>
        </pc:sldMkLst>
      </pc:sldChg>
      <pc:sldChg chg="del">
        <pc:chgData name="Laura Ochoa" userId="59124860-347a-40b0-a9d2-c7a2e55c2f94" providerId="ADAL" clId="{67A63A88-7D7A-7647-9E34-31F962E7FC9C}" dt="2023-12-16T22:31:39.640" v="748" actId="2696"/>
        <pc:sldMkLst>
          <pc:docMk/>
          <pc:sldMk cId="3750869982" sldId="261"/>
        </pc:sldMkLst>
      </pc:sldChg>
      <pc:sldChg chg="add del">
        <pc:chgData name="Laura Ochoa" userId="59124860-347a-40b0-a9d2-c7a2e55c2f94" providerId="ADAL" clId="{67A63A88-7D7A-7647-9E34-31F962E7FC9C}" dt="2023-12-16T22:31:46.545" v="751" actId="2696"/>
        <pc:sldMkLst>
          <pc:docMk/>
          <pc:sldMk cId="150878583" sldId="262"/>
        </pc:sldMkLst>
      </pc:sldChg>
      <pc:sldChg chg="addSp delSp del mod">
        <pc:chgData name="Laura Ochoa" userId="59124860-347a-40b0-a9d2-c7a2e55c2f94" providerId="ADAL" clId="{67A63A88-7D7A-7647-9E34-31F962E7FC9C}" dt="2023-12-17T14:28:47.017" v="1270" actId="2696"/>
        <pc:sldMkLst>
          <pc:docMk/>
          <pc:sldMk cId="2904938040" sldId="263"/>
        </pc:sldMkLst>
        <pc:grpChg chg="add del">
          <ac:chgData name="Laura Ochoa" userId="59124860-347a-40b0-a9d2-c7a2e55c2f94" providerId="ADAL" clId="{67A63A88-7D7A-7647-9E34-31F962E7FC9C}" dt="2023-12-16T22:21:56.490" v="545" actId="478"/>
          <ac:grpSpMkLst>
            <pc:docMk/>
            <pc:sldMk cId="2904938040" sldId="263"/>
            <ac:grpSpMk id="5" creationId="{3F73DBD7-820A-0CF7-EA7F-FA74F5172567}"/>
          </ac:grpSpMkLst>
        </pc:grpChg>
        <pc:picChg chg="add del">
          <ac:chgData name="Laura Ochoa" userId="59124860-347a-40b0-a9d2-c7a2e55c2f94" providerId="ADAL" clId="{67A63A88-7D7A-7647-9E34-31F962E7FC9C}" dt="2023-12-16T22:21:55.591" v="544" actId="478"/>
          <ac:picMkLst>
            <pc:docMk/>
            <pc:sldMk cId="2904938040" sldId="263"/>
            <ac:picMk id="28" creationId="{F8DCB3E6-7C02-6819-3A81-9413D2B346B1}"/>
          </ac:picMkLst>
        </pc:picChg>
      </pc:sldChg>
      <pc:sldChg chg="del">
        <pc:chgData name="Laura Ochoa" userId="59124860-347a-40b0-a9d2-c7a2e55c2f94" providerId="ADAL" clId="{67A63A88-7D7A-7647-9E34-31F962E7FC9C}" dt="2023-12-16T22:31:36.437" v="747" actId="2696"/>
        <pc:sldMkLst>
          <pc:docMk/>
          <pc:sldMk cId="1714014568" sldId="264"/>
        </pc:sldMkLst>
      </pc:sldChg>
      <pc:sldChg chg="addSp delSp modSp mod ord">
        <pc:chgData name="Laura Ochoa" userId="59124860-347a-40b0-a9d2-c7a2e55c2f94" providerId="ADAL" clId="{67A63A88-7D7A-7647-9E34-31F962E7FC9C}" dt="2023-12-19T02:05:28.801" v="2549" actId="20578"/>
        <pc:sldMkLst>
          <pc:docMk/>
          <pc:sldMk cId="3958759317" sldId="265"/>
        </pc:sldMkLst>
        <pc:spChg chg="add del mod">
          <ac:chgData name="Laura Ochoa" userId="59124860-347a-40b0-a9d2-c7a2e55c2f94" providerId="ADAL" clId="{67A63A88-7D7A-7647-9E34-31F962E7FC9C}" dt="2023-12-17T14:19:03.053" v="974" actId="478"/>
          <ac:spMkLst>
            <pc:docMk/>
            <pc:sldMk cId="3958759317" sldId="265"/>
            <ac:spMk id="3" creationId="{01B6F56E-8AB2-34BF-1F46-DE6276EED421}"/>
          </ac:spMkLst>
        </pc:spChg>
        <pc:spChg chg="mod">
          <ac:chgData name="Laura Ochoa" userId="59124860-347a-40b0-a9d2-c7a2e55c2f94" providerId="ADAL" clId="{67A63A88-7D7A-7647-9E34-31F962E7FC9C}" dt="2023-12-16T22:23:28.586" v="710" actId="20577"/>
          <ac:spMkLst>
            <pc:docMk/>
            <pc:sldMk cId="3958759317" sldId="265"/>
            <ac:spMk id="4" creationId="{625361A5-B4DD-DBE6-FA4A-677CE41215B8}"/>
          </ac:spMkLst>
        </pc:spChg>
        <pc:spChg chg="mod">
          <ac:chgData name="Laura Ochoa" userId="59124860-347a-40b0-a9d2-c7a2e55c2f94" providerId="ADAL" clId="{67A63A88-7D7A-7647-9E34-31F962E7FC9C}" dt="2023-12-16T22:06:15.412" v="0" actId="1076"/>
          <ac:spMkLst>
            <pc:docMk/>
            <pc:sldMk cId="3958759317" sldId="265"/>
            <ac:spMk id="8" creationId="{9DCB5C82-ABCE-4F58-6840-B68006E3CE33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10" creationId="{BE978AF5-75B6-555E-B6AE-0BB0ACC44B57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16" creationId="{E9728AAF-A5C0-92F8-0AE3-F9FD5B8D658F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17" creationId="{16F1AC77-ED2F-6FCC-FBFB-CF8FEF10E7EC}"/>
          </ac:spMkLst>
        </pc:spChg>
        <pc:spChg chg="mod">
          <ac:chgData name="Laura Ochoa" userId="59124860-347a-40b0-a9d2-c7a2e55c2f94" providerId="ADAL" clId="{67A63A88-7D7A-7647-9E34-31F962E7FC9C}" dt="2023-12-16T22:19:15.641" v="511" actId="1076"/>
          <ac:spMkLst>
            <pc:docMk/>
            <pc:sldMk cId="3958759317" sldId="265"/>
            <ac:spMk id="17" creationId="{3699BBE5-791F-2CAD-10B3-EDB8845F2525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19" creationId="{63407444-6C29-D9D6-A28B-E2AAB4DC59DF}"/>
          </ac:spMkLst>
        </pc:spChg>
        <pc:spChg chg="mod">
          <ac:chgData name="Laura Ochoa" userId="59124860-347a-40b0-a9d2-c7a2e55c2f94" providerId="ADAL" clId="{67A63A88-7D7A-7647-9E34-31F962E7FC9C}" dt="2023-12-16T22:06:31.402" v="4" actId="1076"/>
          <ac:spMkLst>
            <pc:docMk/>
            <pc:sldMk cId="3958759317" sldId="265"/>
            <ac:spMk id="20" creationId="{7A9B7C27-05D1-3E5A-DD52-946D7E74FC2C}"/>
          </ac:spMkLst>
        </pc:spChg>
        <pc:spChg chg="mod">
          <ac:chgData name="Laura Ochoa" userId="59124860-347a-40b0-a9d2-c7a2e55c2f94" providerId="ADAL" clId="{67A63A88-7D7A-7647-9E34-31F962E7FC9C}" dt="2023-12-16T22:19:21.019" v="512" actId="1076"/>
          <ac:spMkLst>
            <pc:docMk/>
            <pc:sldMk cId="3958759317" sldId="265"/>
            <ac:spMk id="22" creationId="{A0DDEEC7-596C-ABF4-8DBF-522E3E04121A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22" creationId="{F2E1977B-51C2-1983-382F-9B255E06B8BF}"/>
          </ac:spMkLst>
        </pc:spChg>
        <pc:spChg chg="mod">
          <ac:chgData name="Laura Ochoa" userId="59124860-347a-40b0-a9d2-c7a2e55c2f94" providerId="ADAL" clId="{67A63A88-7D7A-7647-9E34-31F962E7FC9C}" dt="2023-12-16T22:06:34.293" v="5" actId="1076"/>
          <ac:spMkLst>
            <pc:docMk/>
            <pc:sldMk cId="3958759317" sldId="265"/>
            <ac:spMk id="23" creationId="{E22EF6C9-7205-7292-7EC8-ADCB26C3DC96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25" creationId="{EADDCF27-842A-9CE0-0FEB-EAFDFABFDC74}"/>
          </ac:spMkLst>
        </pc:spChg>
        <pc:spChg chg="mod">
          <ac:chgData name="Laura Ochoa" userId="59124860-347a-40b0-a9d2-c7a2e55c2f94" providerId="ADAL" clId="{67A63A88-7D7A-7647-9E34-31F962E7FC9C}" dt="2023-12-16T22:06:37.635" v="6" actId="1076"/>
          <ac:spMkLst>
            <pc:docMk/>
            <pc:sldMk cId="3958759317" sldId="265"/>
            <ac:spMk id="26" creationId="{8BBC649C-C1E0-48D7-DD67-969621D7386E}"/>
          </ac:spMkLst>
        </pc:spChg>
        <pc:spChg chg="mod">
          <ac:chgData name="Laura Ochoa" userId="59124860-347a-40b0-a9d2-c7a2e55c2f94" providerId="ADAL" clId="{67A63A88-7D7A-7647-9E34-31F962E7FC9C}" dt="2023-12-16T22:19:26.567" v="513" actId="1076"/>
          <ac:spMkLst>
            <pc:docMk/>
            <pc:sldMk cId="3958759317" sldId="265"/>
            <ac:spMk id="28" creationId="{570318E8-6944-9467-8BBF-E82F53923D4D}"/>
          </ac:spMkLst>
        </pc:spChg>
        <pc:spChg chg="mod">
          <ac:chgData name="Laura Ochoa" userId="59124860-347a-40b0-a9d2-c7a2e55c2f94" providerId="ADAL" clId="{67A63A88-7D7A-7647-9E34-31F962E7FC9C}" dt="2023-12-17T14:15:59.331" v="877"/>
          <ac:spMkLst>
            <pc:docMk/>
            <pc:sldMk cId="3958759317" sldId="265"/>
            <ac:spMk id="28" creationId="{9486C795-C829-88FD-62A0-1D619ECE17A1}"/>
          </ac:spMkLst>
        </pc:spChg>
        <pc:spChg chg="mod">
          <ac:chgData name="Laura Ochoa" userId="59124860-347a-40b0-a9d2-c7a2e55c2f94" providerId="ADAL" clId="{67A63A88-7D7A-7647-9E34-31F962E7FC9C}" dt="2023-12-16T22:06:40.882" v="7" actId="1076"/>
          <ac:spMkLst>
            <pc:docMk/>
            <pc:sldMk cId="3958759317" sldId="265"/>
            <ac:spMk id="29" creationId="{11BB7C8A-598B-22A8-6574-FD6F5D096521}"/>
          </ac:spMkLst>
        </pc:spChg>
        <pc:spChg chg="mod">
          <ac:chgData name="Laura Ochoa" userId="59124860-347a-40b0-a9d2-c7a2e55c2f94" providerId="ADAL" clId="{67A63A88-7D7A-7647-9E34-31F962E7FC9C}" dt="2023-12-16T22:06:45.843" v="8" actId="1076"/>
          <ac:spMkLst>
            <pc:docMk/>
            <pc:sldMk cId="3958759317" sldId="265"/>
            <ac:spMk id="32" creationId="{0BAB6074-433B-CE6B-7E2A-469D9CAB78AF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34" creationId="{7917C2E4-0DEB-4F4A-ED6C-FA4C9CC70967}"/>
          </ac:spMkLst>
        </pc:spChg>
        <pc:spChg chg="mod">
          <ac:chgData name="Laura Ochoa" userId="59124860-347a-40b0-a9d2-c7a2e55c2f94" providerId="ADAL" clId="{67A63A88-7D7A-7647-9E34-31F962E7FC9C}" dt="2023-12-16T22:19:41.739" v="514" actId="1076"/>
          <ac:spMkLst>
            <pc:docMk/>
            <pc:sldMk cId="3958759317" sldId="265"/>
            <ac:spMk id="34" creationId="{B796E425-3234-A31C-7F27-6231EA16B179}"/>
          </ac:spMkLst>
        </pc:spChg>
        <pc:spChg chg="mod">
          <ac:chgData name="Laura Ochoa" userId="59124860-347a-40b0-a9d2-c7a2e55c2f94" providerId="ADAL" clId="{67A63A88-7D7A-7647-9E34-31F962E7FC9C}" dt="2023-12-16T22:06:19.409" v="1" actId="1076"/>
          <ac:spMkLst>
            <pc:docMk/>
            <pc:sldMk cId="3958759317" sldId="265"/>
            <ac:spMk id="35" creationId="{964C837B-8FE6-A2D7-91B9-65FB2605C105}"/>
          </ac:spMkLst>
        </pc:spChg>
        <pc:spChg chg="mod">
          <ac:chgData name="Laura Ochoa" userId="59124860-347a-40b0-a9d2-c7a2e55c2f94" providerId="ADAL" clId="{67A63A88-7D7A-7647-9E34-31F962E7FC9C}" dt="2023-12-16T22:06:24.015" v="2" actId="1076"/>
          <ac:spMkLst>
            <pc:docMk/>
            <pc:sldMk cId="3958759317" sldId="265"/>
            <ac:spMk id="36" creationId="{A522DE97-5567-7424-2F82-F2E2412E5241}"/>
          </ac:spMkLst>
        </pc:spChg>
        <pc:spChg chg="mod">
          <ac:chgData name="Laura Ochoa" userId="59124860-347a-40b0-a9d2-c7a2e55c2f94" providerId="ADAL" clId="{67A63A88-7D7A-7647-9E34-31F962E7FC9C}" dt="2023-12-16T22:06:27.880" v="3" actId="1076"/>
          <ac:spMkLst>
            <pc:docMk/>
            <pc:sldMk cId="3958759317" sldId="265"/>
            <ac:spMk id="37" creationId="{91E2505B-FE47-C87D-D7AA-968BBE11D180}"/>
          </ac:spMkLst>
        </pc:spChg>
        <pc:spChg chg="mod">
          <ac:chgData name="Laura Ochoa" userId="59124860-347a-40b0-a9d2-c7a2e55c2f94" providerId="ADAL" clId="{67A63A88-7D7A-7647-9E34-31F962E7FC9C}" dt="2023-12-16T22:06:49.203" v="9" actId="1076"/>
          <ac:spMkLst>
            <pc:docMk/>
            <pc:sldMk cId="3958759317" sldId="265"/>
            <ac:spMk id="40" creationId="{23B5C67A-8349-EF33-51C2-2CB56E3EA6A3}"/>
          </ac:spMkLst>
        </pc:spChg>
        <pc:spChg chg="mod">
          <ac:chgData name="Laura Ochoa" userId="59124860-347a-40b0-a9d2-c7a2e55c2f94" providerId="ADAL" clId="{67A63A88-7D7A-7647-9E34-31F962E7FC9C}" dt="2023-12-16T22:30:56.872" v="744" actId="14100"/>
          <ac:spMkLst>
            <pc:docMk/>
            <pc:sldMk cId="3958759317" sldId="265"/>
            <ac:spMk id="42" creationId="{04ECB370-4819-C43E-55CD-B39995B2EF02}"/>
          </ac:spMkLst>
        </pc:spChg>
        <pc:spChg chg="mod">
          <ac:chgData name="Laura Ochoa" userId="59124860-347a-40b0-a9d2-c7a2e55c2f94" providerId="ADAL" clId="{67A63A88-7D7A-7647-9E34-31F962E7FC9C}" dt="2023-12-16T22:10:42.937" v="183"/>
          <ac:spMkLst>
            <pc:docMk/>
            <pc:sldMk cId="3958759317" sldId="265"/>
            <ac:spMk id="43" creationId="{851B5834-67E8-8032-2C8B-43534C9B45C3}"/>
          </ac:spMkLst>
        </pc:spChg>
        <pc:spChg chg="mod">
          <ac:chgData name="Laura Ochoa" userId="59124860-347a-40b0-a9d2-c7a2e55c2f94" providerId="ADAL" clId="{67A63A88-7D7A-7647-9E34-31F962E7FC9C}" dt="2023-12-16T22:06:56.979" v="10" actId="1076"/>
          <ac:spMkLst>
            <pc:docMk/>
            <pc:sldMk cId="3958759317" sldId="265"/>
            <ac:spMk id="45" creationId="{B55720EB-586E-A7D8-34E6-77B955A97793}"/>
          </ac:spMkLst>
        </pc:spChg>
        <pc:spChg chg="add mod">
          <ac:chgData name="Laura Ochoa" userId="59124860-347a-40b0-a9d2-c7a2e55c2f94" providerId="ADAL" clId="{67A63A88-7D7A-7647-9E34-31F962E7FC9C}" dt="2023-12-16T22:15:57.022" v="479" actId="1035"/>
          <ac:spMkLst>
            <pc:docMk/>
            <pc:sldMk cId="3958759317" sldId="265"/>
            <ac:spMk id="46" creationId="{71538C0B-BD28-D99E-4575-EF5B1DEC5A82}"/>
          </ac:spMkLst>
        </pc:spChg>
        <pc:spChg chg="add mod">
          <ac:chgData name="Laura Ochoa" userId="59124860-347a-40b0-a9d2-c7a2e55c2f94" providerId="ADAL" clId="{67A63A88-7D7A-7647-9E34-31F962E7FC9C}" dt="2023-12-16T22:29:47.181" v="716" actId="1037"/>
          <ac:spMkLst>
            <pc:docMk/>
            <pc:sldMk cId="3958759317" sldId="265"/>
            <ac:spMk id="48" creationId="{C74D277D-12EF-3870-0FEF-F4A9C632A23D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49" creationId="{3B26A0D3-A9F4-9AC2-1A99-7044FFF8C5DD}"/>
          </ac:spMkLst>
        </pc:spChg>
        <pc:spChg chg="add del mod topLvl">
          <ac:chgData name="Laura Ochoa" userId="59124860-347a-40b0-a9d2-c7a2e55c2f94" providerId="ADAL" clId="{67A63A88-7D7A-7647-9E34-31F962E7FC9C}" dt="2023-12-16T22:15:22.293" v="395" actId="478"/>
          <ac:spMkLst>
            <pc:docMk/>
            <pc:sldMk cId="3958759317" sldId="265"/>
            <ac:spMk id="49" creationId="{BB146527-A2E6-29C6-F1C7-85A7E81EF2D9}"/>
          </ac:spMkLst>
        </pc:spChg>
        <pc:spChg chg="add mod">
          <ac:chgData name="Laura Ochoa" userId="59124860-347a-40b0-a9d2-c7a2e55c2f94" providerId="ADAL" clId="{67A63A88-7D7A-7647-9E34-31F962E7FC9C}" dt="2023-12-16T22:16:28.027" v="485" actId="1038"/>
          <ac:spMkLst>
            <pc:docMk/>
            <pc:sldMk cId="3958759317" sldId="265"/>
            <ac:spMk id="52" creationId="{A8AACA05-F9F5-DF93-6DE8-A454BF9F6CC5}"/>
          </ac:spMkLst>
        </pc:spChg>
        <pc:spChg chg="mod">
          <ac:chgData name="Laura Ochoa" userId="59124860-347a-40b0-a9d2-c7a2e55c2f94" providerId="ADAL" clId="{67A63A88-7D7A-7647-9E34-31F962E7FC9C}" dt="2023-12-17T14:23:31.019" v="1057" actId="403"/>
          <ac:spMkLst>
            <pc:docMk/>
            <pc:sldMk cId="3958759317" sldId="265"/>
            <ac:spMk id="54" creationId="{FCB24B1C-041A-DAAF-BCDF-48026E4ED7EC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55" creationId="{0DC4F4BA-FC31-B084-0CF4-8870D045ABA1}"/>
          </ac:spMkLst>
        </pc:spChg>
        <pc:spChg chg="add del mod">
          <ac:chgData name="Laura Ochoa" userId="59124860-347a-40b0-a9d2-c7a2e55c2f94" providerId="ADAL" clId="{67A63A88-7D7A-7647-9E34-31F962E7FC9C}" dt="2023-12-16T22:22:23.939" v="550" actId="478"/>
          <ac:spMkLst>
            <pc:docMk/>
            <pc:sldMk cId="3958759317" sldId="265"/>
            <ac:spMk id="56" creationId="{2DFE43DC-20F6-D2F8-EA44-76CE81038385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56" creationId="{B7643533-7E17-924C-8D7A-F05197137DDB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57" creationId="{F96C380B-3C82-E92E-B037-90913D5FDF9F}"/>
          </ac:spMkLst>
        </pc:spChg>
        <pc:spChg chg="mod">
          <ac:chgData name="Laura Ochoa" userId="59124860-347a-40b0-a9d2-c7a2e55c2f94" providerId="ADAL" clId="{67A63A88-7D7A-7647-9E34-31F962E7FC9C}" dt="2023-12-17T14:19:06.179" v="976"/>
          <ac:spMkLst>
            <pc:docMk/>
            <pc:sldMk cId="3958759317" sldId="265"/>
            <ac:spMk id="58" creationId="{94BD8F6B-9FD3-5ADE-D851-04259BE7B2D7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59" creationId="{A4E2F192-EEAA-6143-44FC-49F364ABA3BA}"/>
          </ac:spMkLst>
        </pc:spChg>
        <pc:spChg chg="mod">
          <ac:chgData name="Laura Ochoa" userId="59124860-347a-40b0-a9d2-c7a2e55c2f94" providerId="ADAL" clId="{67A63A88-7D7A-7647-9E34-31F962E7FC9C}" dt="2023-12-17T14:23:04.486" v="1054" actId="404"/>
          <ac:spMkLst>
            <pc:docMk/>
            <pc:sldMk cId="3958759317" sldId="265"/>
            <ac:spMk id="59" creationId="{E913963E-3463-3A37-9513-4A12091CE393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60" creationId="{67C407E7-702C-EA95-1276-F418F491E949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61" creationId="{1C8A64DE-9455-EA58-0D94-1C6DC981EA86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61" creationId="{7F2A4582-9824-351F-000F-5433288A0E7B}"/>
          </ac:spMkLst>
        </pc:spChg>
        <pc:spChg chg="mod">
          <ac:chgData name="Laura Ochoa" userId="59124860-347a-40b0-a9d2-c7a2e55c2f94" providerId="ADAL" clId="{67A63A88-7D7A-7647-9E34-31F962E7FC9C}" dt="2023-12-16T22:30:39.740" v="741" actId="404"/>
          <ac:spMkLst>
            <pc:docMk/>
            <pc:sldMk cId="3958759317" sldId="265"/>
            <ac:spMk id="64" creationId="{A6F41BA1-34A5-FAEC-385E-95BE12A3DC39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65" creationId="{36A257B9-C9F2-D1FD-3535-EDF5BD372879}"/>
          </ac:spMkLst>
        </pc:spChg>
        <pc:spChg chg="mod">
          <ac:chgData name="Laura Ochoa" userId="59124860-347a-40b0-a9d2-c7a2e55c2f94" providerId="ADAL" clId="{67A63A88-7D7A-7647-9E34-31F962E7FC9C}" dt="2023-12-17T14:30:10.922" v="1286" actId="1076"/>
          <ac:spMkLst>
            <pc:docMk/>
            <pc:sldMk cId="3958759317" sldId="265"/>
            <ac:spMk id="65" creationId="{6B92BA79-53B8-1B85-E23D-CB703B5BAC57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66" creationId="{4DA7DEBB-DB6D-BD40-1BE4-EC8FA5CEDBD4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67" creationId="{1B7276F9-D627-C755-5421-6284BBA87C82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67" creationId="{446282C5-D3DE-CC11-C737-A8A65D9CA300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68" creationId="{8CC6FC95-06D2-AFA7-BBA7-5360C47A2747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69" creationId="{5A18681A-B831-A583-6DFD-3771D64014B6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69" creationId="{831D2DE6-6D06-3454-F566-72A8AEBFAC42}"/>
          </ac:spMkLst>
        </pc:spChg>
        <pc:spChg chg="mod">
          <ac:chgData name="Laura Ochoa" userId="59124860-347a-40b0-a9d2-c7a2e55c2f94" providerId="ADAL" clId="{67A63A88-7D7A-7647-9E34-31F962E7FC9C}" dt="2023-12-17T14:27:52.618" v="1262"/>
          <ac:spMkLst>
            <pc:docMk/>
            <pc:sldMk cId="3958759317" sldId="265"/>
            <ac:spMk id="70" creationId="{6E32AC1C-6C9C-AE86-B8BC-97B616EBBBAD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71" creationId="{9895759B-887F-D6DB-404C-90574983FFDB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73" creationId="{4591B503-1F59-8DF7-CCFB-D3A8A3D57D93}"/>
          </ac:spMkLst>
        </pc:spChg>
        <pc:spChg chg="mod">
          <ac:chgData name="Laura Ochoa" userId="59124860-347a-40b0-a9d2-c7a2e55c2f94" providerId="ADAL" clId="{67A63A88-7D7A-7647-9E34-31F962E7FC9C}" dt="2023-12-16T22:22:20.170" v="548"/>
          <ac:spMkLst>
            <pc:docMk/>
            <pc:sldMk cId="3958759317" sldId="265"/>
            <ac:spMk id="75" creationId="{AEB825E7-5793-A3AA-8929-49278CDC400C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78" creationId="{158C262F-1594-FA97-0E04-8E3A3F2CC30D}"/>
          </ac:spMkLst>
        </pc:spChg>
        <pc:spChg chg="mod">
          <ac:chgData name="Laura Ochoa" userId="59124860-347a-40b0-a9d2-c7a2e55c2f94" providerId="ADAL" clId="{67A63A88-7D7A-7647-9E34-31F962E7FC9C}" dt="2023-12-16T22:29:07.321" v="712" actId="1038"/>
          <ac:spMkLst>
            <pc:docMk/>
            <pc:sldMk cId="3958759317" sldId="265"/>
            <ac:spMk id="79" creationId="{06BA78B5-305A-5F90-8369-54111EA6C310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80" creationId="{A4837E06-AF60-B213-90EF-17CA93594A84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83" creationId="{3E0636C2-260C-033E-9924-2741F8EEFB28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85" creationId="{31C062C1-7387-9736-275D-CC9E1C6FAA73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87" creationId="{2C66B28D-B5AA-9762-F6F4-A16A4D39483A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89" creationId="{DFBE3EFF-3513-D8C3-DD07-38B72199981A}"/>
          </ac:spMkLst>
        </pc:spChg>
        <pc:spChg chg="del mod topLvl">
          <ac:chgData name="Laura Ochoa" userId="59124860-347a-40b0-a9d2-c7a2e55c2f94" providerId="ADAL" clId="{67A63A88-7D7A-7647-9E34-31F962E7FC9C}" dt="2023-12-17T14:19:04.953" v="975" actId="478"/>
          <ac:spMkLst>
            <pc:docMk/>
            <pc:sldMk cId="3958759317" sldId="265"/>
            <ac:spMk id="91" creationId="{46C20E16-3BF8-7929-E8BF-38F946271306}"/>
          </ac:spMkLst>
        </pc:spChg>
        <pc:spChg chg="mod">
          <ac:chgData name="Laura Ochoa" userId="59124860-347a-40b0-a9d2-c7a2e55c2f94" providerId="ADAL" clId="{67A63A88-7D7A-7647-9E34-31F962E7FC9C}" dt="2023-12-17T14:17:33.868" v="958" actId="1036"/>
          <ac:spMkLst>
            <pc:docMk/>
            <pc:sldMk cId="3958759317" sldId="265"/>
            <ac:spMk id="93" creationId="{F593E64E-DA46-FA38-4467-4C265D3BEB09}"/>
          </ac:spMkLst>
        </pc:spChg>
        <pc:spChg chg="mod">
          <ac:chgData name="Laura Ochoa" userId="59124860-347a-40b0-a9d2-c7a2e55c2f94" providerId="ADAL" clId="{67A63A88-7D7A-7647-9E34-31F962E7FC9C}" dt="2023-12-17T14:17:33.868" v="958" actId="1036"/>
          <ac:spMkLst>
            <pc:docMk/>
            <pc:sldMk cId="3958759317" sldId="265"/>
            <ac:spMk id="94" creationId="{E7D51E36-9EC8-5FDE-EE44-A5BC471CFDFE}"/>
          </ac:spMkLst>
        </pc:spChg>
        <pc:spChg chg="mod">
          <ac:chgData name="Laura Ochoa" userId="59124860-347a-40b0-a9d2-c7a2e55c2f94" providerId="ADAL" clId="{67A63A88-7D7A-7647-9E34-31F962E7FC9C}" dt="2023-12-17T14:16:41.670" v="904" actId="1035"/>
          <ac:spMkLst>
            <pc:docMk/>
            <pc:sldMk cId="3958759317" sldId="265"/>
            <ac:spMk id="95" creationId="{8F374F1C-4869-BC43-F566-4448B60169C8}"/>
          </ac:spMkLst>
        </pc:spChg>
        <pc:spChg chg="mod">
          <ac:chgData name="Laura Ochoa" userId="59124860-347a-40b0-a9d2-c7a2e55c2f94" providerId="ADAL" clId="{67A63A88-7D7A-7647-9E34-31F962E7FC9C}" dt="2023-12-17T14:16:41.670" v="904" actId="1035"/>
          <ac:spMkLst>
            <pc:docMk/>
            <pc:sldMk cId="3958759317" sldId="265"/>
            <ac:spMk id="96" creationId="{D7FDE5B2-E771-29E3-8EDC-D751FD3DD5B9}"/>
          </ac:spMkLst>
        </pc:spChg>
        <pc:spChg chg="add del mod">
          <ac:chgData name="Laura Ochoa" userId="59124860-347a-40b0-a9d2-c7a2e55c2f94" providerId="ADAL" clId="{67A63A88-7D7A-7647-9E34-31F962E7FC9C}" dt="2023-12-17T14:18:14.963" v="966" actId="1076"/>
          <ac:spMkLst>
            <pc:docMk/>
            <pc:sldMk cId="3958759317" sldId="265"/>
            <ac:spMk id="97" creationId="{776BFC78-175B-E52B-2C83-5ECB5F50921B}"/>
          </ac:spMkLst>
        </pc:spChg>
        <pc:spChg chg="mod">
          <ac:chgData name="Laura Ochoa" userId="59124860-347a-40b0-a9d2-c7a2e55c2f94" providerId="ADAL" clId="{67A63A88-7D7A-7647-9E34-31F962E7FC9C}" dt="2023-12-17T14:18:08.977" v="965" actId="1076"/>
          <ac:spMkLst>
            <pc:docMk/>
            <pc:sldMk cId="3958759317" sldId="265"/>
            <ac:spMk id="98" creationId="{AE1BCD2C-0991-32B5-348A-BC7456538104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101" creationId="{D19977D6-CF0C-A695-44E3-4FAFCE56CE39}"/>
          </ac:spMkLst>
        </pc:spChg>
        <pc:spChg chg="mod">
          <ac:chgData name="Laura Ochoa" userId="59124860-347a-40b0-a9d2-c7a2e55c2f94" providerId="ADAL" clId="{67A63A88-7D7A-7647-9E34-31F962E7FC9C}" dt="2023-12-16T22:22:24.874" v="551"/>
          <ac:spMkLst>
            <pc:docMk/>
            <pc:sldMk cId="3958759317" sldId="265"/>
            <ac:spMk id="103" creationId="{DFD71DBE-9CDE-59A9-3D1C-3E2A38C1A347}"/>
          </ac:spMkLst>
        </pc:spChg>
        <pc:grpChg chg="add mod">
          <ac:chgData name="Laura Ochoa" userId="59124860-347a-40b0-a9d2-c7a2e55c2f94" providerId="ADAL" clId="{67A63A88-7D7A-7647-9E34-31F962E7FC9C}" dt="2023-12-16T22:07:18.169" v="27" actId="1035"/>
          <ac:grpSpMkLst>
            <pc:docMk/>
            <pc:sldMk cId="3958759317" sldId="265"/>
            <ac:grpSpMk id="5" creationId="{3E77AA05-337C-5063-ADA4-D84BCECAF4D1}"/>
          </ac:grpSpMkLst>
        </pc:grpChg>
        <pc:grpChg chg="add del mod">
          <ac:chgData name="Laura Ochoa" userId="59124860-347a-40b0-a9d2-c7a2e55c2f94" providerId="ADAL" clId="{67A63A88-7D7A-7647-9E34-31F962E7FC9C}" dt="2023-12-17T14:29:52.232" v="1283" actId="478"/>
          <ac:grpSpMkLst>
            <pc:docMk/>
            <pc:sldMk cId="3958759317" sldId="265"/>
            <ac:grpSpMk id="6" creationId="{BBEEBE67-8EAA-4035-4B12-CE2ABE2243BD}"/>
          </ac:grpSpMkLst>
        </pc:grpChg>
        <pc:grpChg chg="mod">
          <ac:chgData name="Laura Ochoa" userId="59124860-347a-40b0-a9d2-c7a2e55c2f94" providerId="ADAL" clId="{67A63A88-7D7A-7647-9E34-31F962E7FC9C}" dt="2023-12-17T14:15:59.331" v="877"/>
          <ac:grpSpMkLst>
            <pc:docMk/>
            <pc:sldMk cId="3958759317" sldId="265"/>
            <ac:grpSpMk id="11" creationId="{575517B4-134A-BD8C-FAFA-73CA174A90A7}"/>
          </ac:grpSpMkLst>
        </pc:grpChg>
        <pc:grpChg chg="mod">
          <ac:chgData name="Laura Ochoa" userId="59124860-347a-40b0-a9d2-c7a2e55c2f94" providerId="ADAL" clId="{67A63A88-7D7A-7647-9E34-31F962E7FC9C}" dt="2023-12-17T14:15:59.331" v="877"/>
          <ac:grpSpMkLst>
            <pc:docMk/>
            <pc:sldMk cId="3958759317" sldId="265"/>
            <ac:grpSpMk id="14" creationId="{95DA0425-5D99-2F66-179A-F2EE811E2A99}"/>
          </ac:grpSpMkLst>
        </pc:grpChg>
        <pc:grpChg chg="add del mod">
          <ac:chgData name="Laura Ochoa" userId="59124860-347a-40b0-a9d2-c7a2e55c2f94" providerId="ADAL" clId="{67A63A88-7D7A-7647-9E34-31F962E7FC9C}" dt="2023-12-16T22:22:18.087" v="546" actId="478"/>
          <ac:grpSpMkLst>
            <pc:docMk/>
            <pc:sldMk cId="3958759317" sldId="265"/>
            <ac:grpSpMk id="14" creationId="{F05164C6-81CD-62FF-363E-8D2A9DE27EB1}"/>
          </ac:grpSpMkLst>
        </pc:grpChg>
        <pc:grpChg chg="add mod">
          <ac:chgData name="Laura Ochoa" userId="59124860-347a-40b0-a9d2-c7a2e55c2f94" providerId="ADAL" clId="{67A63A88-7D7A-7647-9E34-31F962E7FC9C}" dt="2023-12-17T14:30:26.147" v="1290" actId="1076"/>
          <ac:grpSpMkLst>
            <pc:docMk/>
            <pc:sldMk cId="3958759317" sldId="265"/>
            <ac:grpSpMk id="31" creationId="{630E7D5F-F89F-B8DE-6413-E418E9B68B31}"/>
          </ac:grpSpMkLst>
        </pc:grpChg>
        <pc:grpChg chg="mod">
          <ac:chgData name="Laura Ochoa" userId="59124860-347a-40b0-a9d2-c7a2e55c2f94" providerId="ADAL" clId="{67A63A88-7D7A-7647-9E34-31F962E7FC9C}" dt="2023-12-17T14:19:06.179" v="976"/>
          <ac:grpSpMkLst>
            <pc:docMk/>
            <pc:sldMk cId="3958759317" sldId="265"/>
            <ac:grpSpMk id="38" creationId="{80C16FDB-AA97-54A1-EB6B-D029515AC5FA}"/>
          </ac:grpSpMkLst>
        </pc:grpChg>
        <pc:grpChg chg="mod">
          <ac:chgData name="Laura Ochoa" userId="59124860-347a-40b0-a9d2-c7a2e55c2f94" providerId="ADAL" clId="{67A63A88-7D7A-7647-9E34-31F962E7FC9C}" dt="2023-12-17T14:19:06.179" v="976"/>
          <ac:grpSpMkLst>
            <pc:docMk/>
            <pc:sldMk cId="3958759317" sldId="265"/>
            <ac:grpSpMk id="43" creationId="{AC525830-2F45-8A9F-6980-4E72C62B6751}"/>
          </ac:grpSpMkLst>
        </pc:grpChg>
        <pc:grpChg chg="add topLvl">
          <ac:chgData name="Laura Ochoa" userId="59124860-347a-40b0-a9d2-c7a2e55c2f94" providerId="ADAL" clId="{67A63A88-7D7A-7647-9E34-31F962E7FC9C}" dt="2023-12-16T22:15:22.293" v="395" actId="478"/>
          <ac:grpSpMkLst>
            <pc:docMk/>
            <pc:sldMk cId="3958759317" sldId="265"/>
            <ac:grpSpMk id="47" creationId="{F15C6E8B-AACA-74C4-C82F-7AF9FD5EBF38}"/>
          </ac:grpSpMkLst>
        </pc:grpChg>
        <pc:grpChg chg="add del">
          <ac:chgData name="Laura Ochoa" userId="59124860-347a-40b0-a9d2-c7a2e55c2f94" providerId="ADAL" clId="{67A63A88-7D7A-7647-9E34-31F962E7FC9C}" dt="2023-12-16T22:15:22.293" v="395" actId="478"/>
          <ac:grpSpMkLst>
            <pc:docMk/>
            <pc:sldMk cId="3958759317" sldId="265"/>
            <ac:grpSpMk id="50" creationId="{0A4FCD1B-F02C-F7D9-5204-FE25BC7BA06F}"/>
          </ac:grpSpMkLst>
        </pc:grpChg>
        <pc:grpChg chg="mod">
          <ac:chgData name="Laura Ochoa" userId="59124860-347a-40b0-a9d2-c7a2e55c2f94" providerId="ADAL" clId="{67A63A88-7D7A-7647-9E34-31F962E7FC9C}" dt="2023-12-17T14:19:06.179" v="976"/>
          <ac:grpSpMkLst>
            <pc:docMk/>
            <pc:sldMk cId="3958759317" sldId="265"/>
            <ac:grpSpMk id="50" creationId="{154E4951-D979-4384-5D00-D011835B99C3}"/>
          </ac:grpSpMkLst>
        </pc:grpChg>
        <pc:grpChg chg="add">
          <ac:chgData name="Laura Ochoa" userId="59124860-347a-40b0-a9d2-c7a2e55c2f94" providerId="ADAL" clId="{67A63A88-7D7A-7647-9E34-31F962E7FC9C}" dt="2023-12-16T22:16:08.468" v="480" actId="164"/>
          <ac:grpSpMkLst>
            <pc:docMk/>
            <pc:sldMk cId="3958759317" sldId="265"/>
            <ac:grpSpMk id="51" creationId="{EC837DC9-158C-861D-0587-B6B976CBB516}"/>
          </ac:grpSpMkLst>
        </pc:grpChg>
        <pc:grpChg chg="add mod">
          <ac:chgData name="Laura Ochoa" userId="59124860-347a-40b0-a9d2-c7a2e55c2f94" providerId="ADAL" clId="{67A63A88-7D7A-7647-9E34-31F962E7FC9C}" dt="2023-12-16T22:29:39.713" v="715" actId="1076"/>
          <ac:grpSpMkLst>
            <pc:docMk/>
            <pc:sldMk cId="3958759317" sldId="265"/>
            <ac:grpSpMk id="53" creationId="{3A62EA54-80D8-1943-6D41-7F3020AF6520}"/>
          </ac:grpSpMkLst>
        </pc:grpChg>
        <pc:grpChg chg="add del mod">
          <ac:chgData name="Laura Ochoa" userId="59124860-347a-40b0-a9d2-c7a2e55c2f94" providerId="ADAL" clId="{67A63A88-7D7A-7647-9E34-31F962E7FC9C}" dt="2023-12-16T22:22:22.493" v="549"/>
          <ac:grpSpMkLst>
            <pc:docMk/>
            <pc:sldMk cId="3958759317" sldId="265"/>
            <ac:grpSpMk id="57" creationId="{B54B8DE7-576A-6E99-56EC-E41E56845FCD}"/>
          </ac:grpSpMkLst>
        </pc:grpChg>
        <pc:grpChg chg="mod">
          <ac:chgData name="Laura Ochoa" userId="59124860-347a-40b0-a9d2-c7a2e55c2f94" providerId="ADAL" clId="{67A63A88-7D7A-7647-9E34-31F962E7FC9C}" dt="2023-12-16T22:22:20.170" v="548"/>
          <ac:grpSpMkLst>
            <pc:docMk/>
            <pc:sldMk cId="3958759317" sldId="265"/>
            <ac:grpSpMk id="58" creationId="{E518302E-F06E-194C-80F7-9D9405F784F4}"/>
          </ac:grpSpMkLst>
        </pc:grpChg>
        <pc:grpChg chg="add mod">
          <ac:chgData name="Laura Ochoa" userId="59124860-347a-40b0-a9d2-c7a2e55c2f94" providerId="ADAL" clId="{67A63A88-7D7A-7647-9E34-31F962E7FC9C}" dt="2023-12-17T14:30:34.045" v="1291" actId="1076"/>
          <ac:grpSpMkLst>
            <pc:docMk/>
            <pc:sldMk cId="3958759317" sldId="265"/>
            <ac:grpSpMk id="60" creationId="{4531E32C-DAD6-8F0D-A735-B582793860F4}"/>
          </ac:grpSpMkLst>
        </pc:grpChg>
        <pc:grpChg chg="mod">
          <ac:chgData name="Laura Ochoa" userId="59124860-347a-40b0-a9d2-c7a2e55c2f94" providerId="ADAL" clId="{67A63A88-7D7A-7647-9E34-31F962E7FC9C}" dt="2023-12-16T22:22:20.170" v="548"/>
          <ac:grpSpMkLst>
            <pc:docMk/>
            <pc:sldMk cId="3958759317" sldId="265"/>
            <ac:grpSpMk id="62" creationId="{A1D599AB-9838-4606-9FD3-A3D55FD5AB1A}"/>
          </ac:grpSpMkLst>
        </pc:grpChg>
        <pc:grpChg chg="mod">
          <ac:chgData name="Laura Ochoa" userId="59124860-347a-40b0-a9d2-c7a2e55c2f94" providerId="ADAL" clId="{67A63A88-7D7A-7647-9E34-31F962E7FC9C}" dt="2023-12-17T14:27:52.618" v="1262"/>
          <ac:grpSpMkLst>
            <pc:docMk/>
            <pc:sldMk cId="3958759317" sldId="265"/>
            <ac:grpSpMk id="62" creationId="{E077E02C-C47C-EB77-4DDE-3D78977FDC98}"/>
          </ac:grpSpMkLst>
        </pc:grpChg>
        <pc:grpChg chg="mod">
          <ac:chgData name="Laura Ochoa" userId="59124860-347a-40b0-a9d2-c7a2e55c2f94" providerId="ADAL" clId="{67A63A88-7D7A-7647-9E34-31F962E7FC9C}" dt="2023-12-17T14:27:52.618" v="1262"/>
          <ac:grpSpMkLst>
            <pc:docMk/>
            <pc:sldMk cId="3958759317" sldId="265"/>
            <ac:grpSpMk id="63" creationId="{4A557E2D-0159-5B5B-A008-A7B1B656A459}"/>
          </ac:grpSpMkLst>
        </pc:grpChg>
        <pc:grpChg chg="add mod">
          <ac:chgData name="Laura Ochoa" userId="59124860-347a-40b0-a9d2-c7a2e55c2f94" providerId="ADAL" clId="{67A63A88-7D7A-7647-9E34-31F962E7FC9C}" dt="2023-12-16T22:23:22.882" v="694" actId="1076"/>
          <ac:grpSpMkLst>
            <pc:docMk/>
            <pc:sldMk cId="3958759317" sldId="265"/>
            <ac:grpSpMk id="76" creationId="{B9F3A558-3284-190E-4EEB-A841BEE02096}"/>
          </ac:grpSpMkLst>
        </pc:grpChg>
        <pc:grpChg chg="mod">
          <ac:chgData name="Laura Ochoa" userId="59124860-347a-40b0-a9d2-c7a2e55c2f94" providerId="ADAL" clId="{67A63A88-7D7A-7647-9E34-31F962E7FC9C}" dt="2023-12-16T22:22:24.874" v="551"/>
          <ac:grpSpMkLst>
            <pc:docMk/>
            <pc:sldMk cId="3958759317" sldId="265"/>
            <ac:grpSpMk id="77" creationId="{37E32308-6ED8-2AE9-212A-295B5CCE8639}"/>
          </ac:grpSpMkLst>
        </pc:grpChg>
        <pc:grpChg chg="mod">
          <ac:chgData name="Laura Ochoa" userId="59124860-347a-40b0-a9d2-c7a2e55c2f94" providerId="ADAL" clId="{67A63A88-7D7A-7647-9E34-31F962E7FC9C}" dt="2023-12-16T22:22:24.874" v="551"/>
          <ac:grpSpMkLst>
            <pc:docMk/>
            <pc:sldMk cId="3958759317" sldId="265"/>
            <ac:grpSpMk id="81" creationId="{C97BAC72-D90C-F9CE-6C35-4B7C92990288}"/>
          </ac:grpSpMkLst>
        </pc:grpChg>
        <pc:grpChg chg="del mod topLvl">
          <ac:chgData name="Laura Ochoa" userId="59124860-347a-40b0-a9d2-c7a2e55c2f94" providerId="ADAL" clId="{67A63A88-7D7A-7647-9E34-31F962E7FC9C}" dt="2023-12-17T14:19:03.053" v="974" actId="478"/>
          <ac:grpSpMkLst>
            <pc:docMk/>
            <pc:sldMk cId="3958759317" sldId="265"/>
            <ac:grpSpMk id="99" creationId="{DF8677DB-AE28-F937-D3E0-FF663E2FCC66}"/>
          </ac:grpSpMkLst>
        </pc:grpChg>
        <pc:grpChg chg="del mod">
          <ac:chgData name="Laura Ochoa" userId="59124860-347a-40b0-a9d2-c7a2e55c2f94" providerId="ADAL" clId="{67A63A88-7D7A-7647-9E34-31F962E7FC9C}" dt="2023-12-17T13:10:43.976" v="754" actId="165"/>
          <ac:grpSpMkLst>
            <pc:docMk/>
            <pc:sldMk cId="3958759317" sldId="265"/>
            <ac:grpSpMk id="100" creationId="{28A19D92-2FA3-6EAA-1070-90038E1D8E71}"/>
          </ac:grpSpMkLst>
        </pc:grpChg>
        <pc:picChg chg="del mod">
          <ac:chgData name="Laura Ochoa" userId="59124860-347a-40b0-a9d2-c7a2e55c2f94" providerId="ADAL" clId="{67A63A88-7D7A-7647-9E34-31F962E7FC9C}" dt="2023-12-16T22:07:43.393" v="31" actId="478"/>
          <ac:picMkLst>
            <pc:docMk/>
            <pc:sldMk cId="3958759317" sldId="265"/>
            <ac:picMk id="3" creationId="{27134050-642C-E80C-9EF4-DF6131D030CA}"/>
          </ac:picMkLst>
        </pc:picChg>
        <pc:picChg chg="add del mod">
          <ac:chgData name="Laura Ochoa" userId="59124860-347a-40b0-a9d2-c7a2e55c2f94" providerId="ADAL" clId="{67A63A88-7D7A-7647-9E34-31F962E7FC9C}" dt="2023-12-16T22:07:56.592" v="33" actId="478"/>
          <ac:picMkLst>
            <pc:docMk/>
            <pc:sldMk cId="3958759317" sldId="265"/>
            <ac:picMk id="6" creationId="{CD519A18-1D1C-8BF1-C8C5-D6DE606B2FCC}"/>
          </ac:picMkLst>
        </pc:picChg>
        <pc:picChg chg="add del mod">
          <ac:chgData name="Laura Ochoa" userId="59124860-347a-40b0-a9d2-c7a2e55c2f94" providerId="ADAL" clId="{67A63A88-7D7A-7647-9E34-31F962E7FC9C}" dt="2023-12-16T22:09:29.137" v="84" actId="478"/>
          <ac:picMkLst>
            <pc:docMk/>
            <pc:sldMk cId="3958759317" sldId="265"/>
            <ac:picMk id="11" creationId="{55BAB63B-4ACE-4792-8FAC-2629BA418BBB}"/>
          </ac:picMkLst>
        </pc:picChg>
        <pc:picChg chg="add mod">
          <ac:chgData name="Laura Ochoa" userId="59124860-347a-40b0-a9d2-c7a2e55c2f94" providerId="ADAL" clId="{67A63A88-7D7A-7647-9E34-31F962E7FC9C}" dt="2023-12-16T22:14:33.284" v="374" actId="167"/>
          <ac:picMkLst>
            <pc:docMk/>
            <pc:sldMk cId="3958759317" sldId="265"/>
            <ac:picMk id="13" creationId="{BEC86A83-28B4-77E5-B552-EFE05C4E0FF5}"/>
          </ac:picMkLst>
        </pc:picChg>
        <pc:picChg chg="mod">
          <ac:chgData name="Laura Ochoa" userId="59124860-347a-40b0-a9d2-c7a2e55c2f94" providerId="ADAL" clId="{67A63A88-7D7A-7647-9E34-31F962E7FC9C}" dt="2023-12-16T22:10:42.937" v="183"/>
          <ac:picMkLst>
            <pc:docMk/>
            <pc:sldMk cId="3958759317" sldId="265"/>
            <ac:picMk id="16" creationId="{E2EDF6AD-9F47-4571-5451-EEF8E3959D11}"/>
          </ac:picMkLst>
        </pc:picChg>
        <pc:picChg chg="mod">
          <ac:chgData name="Laura Ochoa" userId="59124860-347a-40b0-a9d2-c7a2e55c2f94" providerId="ADAL" clId="{67A63A88-7D7A-7647-9E34-31F962E7FC9C}" dt="2023-12-16T22:10:42.937" v="183"/>
          <ac:picMkLst>
            <pc:docMk/>
            <pc:sldMk cId="3958759317" sldId="265"/>
            <ac:picMk id="19" creationId="{317AEB81-98CF-C91E-4175-0AE123CA0BEB}"/>
          </ac:picMkLst>
        </pc:picChg>
        <pc:picChg chg="mod">
          <ac:chgData name="Laura Ochoa" userId="59124860-347a-40b0-a9d2-c7a2e55c2f94" providerId="ADAL" clId="{67A63A88-7D7A-7647-9E34-31F962E7FC9C}" dt="2023-12-16T22:10:42.937" v="183"/>
          <ac:picMkLst>
            <pc:docMk/>
            <pc:sldMk cId="3958759317" sldId="265"/>
            <ac:picMk id="25" creationId="{88449AFF-683C-8BA2-4816-DC3BED3932AD}"/>
          </ac:picMkLst>
        </pc:picChg>
        <pc:picChg chg="mod">
          <ac:chgData name="Laura Ochoa" userId="59124860-347a-40b0-a9d2-c7a2e55c2f94" providerId="ADAL" clId="{67A63A88-7D7A-7647-9E34-31F962E7FC9C}" dt="2023-12-16T22:10:42.937" v="183"/>
          <ac:picMkLst>
            <pc:docMk/>
            <pc:sldMk cId="3958759317" sldId="265"/>
            <ac:picMk id="31" creationId="{03D691F2-14A8-3E54-6429-DA05C3BAD854}"/>
          </ac:picMkLst>
        </pc:picChg>
        <pc:picChg chg="mod">
          <ac:chgData name="Laura Ochoa" userId="59124860-347a-40b0-a9d2-c7a2e55c2f94" providerId="ADAL" clId="{67A63A88-7D7A-7647-9E34-31F962E7FC9C}" dt="2023-12-16T22:10:42.937" v="183"/>
          <ac:picMkLst>
            <pc:docMk/>
            <pc:sldMk cId="3958759317" sldId="265"/>
            <ac:picMk id="38" creationId="{99811C86-D354-CD79-A8C8-E05625FC5659}"/>
          </ac:picMkLst>
        </pc:picChg>
        <pc:picChg chg="add del mod">
          <ac:chgData name="Laura Ochoa" userId="59124860-347a-40b0-a9d2-c7a2e55c2f94" providerId="ADAL" clId="{67A63A88-7D7A-7647-9E34-31F962E7FC9C}" dt="2023-12-16T22:22:19.076" v="547" actId="478"/>
          <ac:picMkLst>
            <pc:docMk/>
            <pc:sldMk cId="3958759317" sldId="265"/>
            <ac:picMk id="55" creationId="{D9DD7753-5A27-042D-8A5D-13DB1CC58E50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63" creationId="{BFF9BDC5-44F7-FA80-269E-4A38876FB273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66" creationId="{FF856B21-77BC-81B9-4430-CFDEFD31597C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68" creationId="{9F2C1959-FA38-C2B6-A6EB-C33E026E7C79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70" creationId="{6B0BD9AC-DA06-76AF-B1BD-9F77A635C465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72" creationId="{0A8909D0-ED89-96E5-73A8-0E7F6B8858EB}"/>
          </ac:picMkLst>
        </pc:picChg>
        <pc:picChg chg="mod">
          <ac:chgData name="Laura Ochoa" userId="59124860-347a-40b0-a9d2-c7a2e55c2f94" providerId="ADAL" clId="{67A63A88-7D7A-7647-9E34-31F962E7FC9C}" dt="2023-12-16T22:22:20.170" v="548"/>
          <ac:picMkLst>
            <pc:docMk/>
            <pc:sldMk cId="3958759317" sldId="265"/>
            <ac:picMk id="74" creationId="{16DF447E-B3C0-43D8-D69F-4937EE99502F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82" creationId="{884D5405-6032-88CC-36FD-5F5D49118909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84" creationId="{385F3CD4-185D-5EB0-2298-CFBC88D520E1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86" creationId="{8074F386-72AB-42FF-D8B8-3BBA903FFC17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88" creationId="{DA2553D4-BBBD-5441-D8DD-CACC4F4F94B7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90" creationId="{6FEA68BC-FCC2-0DBF-B8B1-8456048631EE}"/>
          </ac:picMkLst>
        </pc:picChg>
        <pc:picChg chg="mod">
          <ac:chgData name="Laura Ochoa" userId="59124860-347a-40b0-a9d2-c7a2e55c2f94" providerId="ADAL" clId="{67A63A88-7D7A-7647-9E34-31F962E7FC9C}" dt="2023-12-16T22:22:24.874" v="551"/>
          <ac:picMkLst>
            <pc:docMk/>
            <pc:sldMk cId="3958759317" sldId="265"/>
            <ac:picMk id="102" creationId="{1577E202-10CF-9F5B-41CE-8741101D4584}"/>
          </ac:picMkLst>
        </pc:picChg>
        <pc:picChg chg="add del mod">
          <ac:chgData name="Laura Ochoa" userId="59124860-347a-40b0-a9d2-c7a2e55c2f94" providerId="ADAL" clId="{67A63A88-7D7A-7647-9E34-31F962E7FC9C}" dt="2023-12-16T22:30:28.690" v="740" actId="478"/>
          <ac:picMkLst>
            <pc:docMk/>
            <pc:sldMk cId="3958759317" sldId="265"/>
            <ac:picMk id="104" creationId="{B1E1F7AC-DCDF-A0D3-A0DA-3A3222FE1C19}"/>
          </ac:picMkLst>
        </pc:picChg>
      </pc:sldChg>
      <pc:sldChg chg="addSp delSp modSp add del mod">
        <pc:chgData name="Laura Ochoa" userId="59124860-347a-40b0-a9d2-c7a2e55c2f94" providerId="ADAL" clId="{67A63A88-7D7A-7647-9E34-31F962E7FC9C}" dt="2023-12-17T14:28:48.733" v="1271" actId="2696"/>
        <pc:sldMkLst>
          <pc:docMk/>
          <pc:sldMk cId="1665846235" sldId="266"/>
        </pc:sldMkLst>
        <pc:spChg chg="add mod">
          <ac:chgData name="Laura Ochoa" userId="59124860-347a-40b0-a9d2-c7a2e55c2f94" providerId="ADAL" clId="{67A63A88-7D7A-7647-9E34-31F962E7FC9C}" dt="2023-12-16T22:21:31.732" v="540" actId="1036"/>
          <ac:spMkLst>
            <pc:docMk/>
            <pc:sldMk cId="1665846235" sldId="266"/>
            <ac:spMk id="6" creationId="{B668F774-80C4-7022-8AF4-AF0C896B927A}"/>
          </ac:spMkLst>
        </pc:spChg>
        <pc:spChg chg="add mod">
          <ac:chgData name="Laura Ochoa" userId="59124860-347a-40b0-a9d2-c7a2e55c2f94" providerId="ADAL" clId="{67A63A88-7D7A-7647-9E34-31F962E7FC9C}" dt="2023-12-16T22:21:31.732" v="540" actId="1036"/>
          <ac:spMkLst>
            <pc:docMk/>
            <pc:sldMk cId="1665846235" sldId="266"/>
            <ac:spMk id="10" creationId="{73141787-9A76-9232-3A5E-5F19882D4526}"/>
          </ac:spMkLst>
        </pc:spChg>
        <pc:spChg chg="add mod">
          <ac:chgData name="Laura Ochoa" userId="59124860-347a-40b0-a9d2-c7a2e55c2f94" providerId="ADAL" clId="{67A63A88-7D7A-7647-9E34-31F962E7FC9C}" dt="2023-12-16T22:21:31.732" v="540" actId="1036"/>
          <ac:spMkLst>
            <pc:docMk/>
            <pc:sldMk cId="1665846235" sldId="266"/>
            <ac:spMk id="11" creationId="{FF326DAF-01B6-BB6A-E9A9-03629C3C794B}"/>
          </ac:spMkLst>
        </pc:spChg>
        <pc:spChg chg="mod">
          <ac:chgData name="Laura Ochoa" userId="59124860-347a-40b0-a9d2-c7a2e55c2f94" providerId="ADAL" clId="{67A63A88-7D7A-7647-9E34-31F962E7FC9C}" dt="2023-12-16T22:20:10.128" v="517" actId="1076"/>
          <ac:spMkLst>
            <pc:docMk/>
            <pc:sldMk cId="1665846235" sldId="266"/>
            <ac:spMk id="17" creationId="{3699BBE5-791F-2CAD-10B3-EDB8845F2525}"/>
          </ac:spMkLst>
        </pc:spChg>
        <pc:spChg chg="mod">
          <ac:chgData name="Laura Ochoa" userId="59124860-347a-40b0-a9d2-c7a2e55c2f94" providerId="ADAL" clId="{67A63A88-7D7A-7647-9E34-31F962E7FC9C}" dt="2023-12-16T22:20:13.955" v="518" actId="1076"/>
          <ac:spMkLst>
            <pc:docMk/>
            <pc:sldMk cId="1665846235" sldId="266"/>
            <ac:spMk id="22" creationId="{A0DDEEC7-596C-ABF4-8DBF-522E3E04121A}"/>
          </ac:spMkLst>
        </pc:spChg>
        <pc:spChg chg="mod">
          <ac:chgData name="Laura Ochoa" userId="59124860-347a-40b0-a9d2-c7a2e55c2f94" providerId="ADAL" clId="{67A63A88-7D7A-7647-9E34-31F962E7FC9C}" dt="2023-12-16T22:20:41.990" v="520" actId="1076"/>
          <ac:spMkLst>
            <pc:docMk/>
            <pc:sldMk cId="1665846235" sldId="266"/>
            <ac:spMk id="34" creationId="{B796E425-3234-A31C-7F27-6231EA16B179}"/>
          </ac:spMkLst>
        </pc:spChg>
        <pc:spChg chg="mod">
          <ac:chgData name="Laura Ochoa" userId="59124860-347a-40b0-a9d2-c7a2e55c2f94" providerId="ADAL" clId="{67A63A88-7D7A-7647-9E34-31F962E7FC9C}" dt="2023-12-16T22:20:50.787" v="521" actId="1076"/>
          <ac:spMkLst>
            <pc:docMk/>
            <pc:sldMk cId="1665846235" sldId="266"/>
            <ac:spMk id="43" creationId="{851B5834-67E8-8032-2C8B-43534C9B45C3}"/>
          </ac:spMkLst>
        </pc:spChg>
        <pc:spChg chg="mod">
          <ac:chgData name="Laura Ochoa" userId="59124860-347a-40b0-a9d2-c7a2e55c2f94" providerId="ADAL" clId="{67A63A88-7D7A-7647-9E34-31F962E7FC9C}" dt="2023-12-16T22:20:56.193" v="522" actId="1076"/>
          <ac:spMkLst>
            <pc:docMk/>
            <pc:sldMk cId="1665846235" sldId="266"/>
            <ac:spMk id="56" creationId="{2DFE43DC-20F6-D2F8-EA44-76CE81038385}"/>
          </ac:spMkLst>
        </pc:spChg>
        <pc:grpChg chg="add">
          <ac:chgData name="Laura Ochoa" userId="59124860-347a-40b0-a9d2-c7a2e55c2f94" providerId="ADAL" clId="{67A63A88-7D7A-7647-9E34-31F962E7FC9C}" dt="2023-12-16T22:21:01.325" v="523" actId="164"/>
          <ac:grpSpMkLst>
            <pc:docMk/>
            <pc:sldMk cId="1665846235" sldId="266"/>
            <ac:grpSpMk id="3" creationId="{F76C0D56-FDF8-21EF-817A-0C8405311189}"/>
          </ac:grpSpMkLst>
        </pc:grpChg>
        <pc:grpChg chg="add">
          <ac:chgData name="Laura Ochoa" userId="59124860-347a-40b0-a9d2-c7a2e55c2f94" providerId="ADAL" clId="{67A63A88-7D7A-7647-9E34-31F962E7FC9C}" dt="2023-12-16T22:21:43.023" v="541" actId="164"/>
          <ac:grpSpMkLst>
            <pc:docMk/>
            <pc:sldMk cId="1665846235" sldId="266"/>
            <ac:grpSpMk id="49" creationId="{89EB6556-0048-D870-A846-47D02AE916A4}"/>
          </ac:grpSpMkLst>
        </pc:grpChg>
        <pc:grpChg chg="del">
          <ac:chgData name="Laura Ochoa" userId="59124860-347a-40b0-a9d2-c7a2e55c2f94" providerId="ADAL" clId="{67A63A88-7D7A-7647-9E34-31F962E7FC9C}" dt="2023-12-16T22:20:03.337" v="516" actId="478"/>
          <ac:grpSpMkLst>
            <pc:docMk/>
            <pc:sldMk cId="1665846235" sldId="266"/>
            <ac:grpSpMk id="53" creationId="{3A62EA54-80D8-1943-6D41-7F3020AF6520}"/>
          </ac:grpSpMkLst>
        </pc:grpChg>
      </pc:sldChg>
      <pc:sldChg chg="addSp delSp modSp add mod">
        <pc:chgData name="Laura Ochoa" userId="59124860-347a-40b0-a9d2-c7a2e55c2f94" providerId="ADAL" clId="{67A63A88-7D7A-7647-9E34-31F962E7FC9C}" dt="2023-12-17T14:29:44.305" v="1282" actId="1076"/>
        <pc:sldMkLst>
          <pc:docMk/>
          <pc:sldMk cId="2920808942" sldId="267"/>
        </pc:sldMkLst>
        <pc:spChg chg="del">
          <ac:chgData name="Laura Ochoa" userId="59124860-347a-40b0-a9d2-c7a2e55c2f94" providerId="ADAL" clId="{67A63A88-7D7A-7647-9E34-31F962E7FC9C}" dt="2023-12-17T14:23:51.999" v="1058" actId="478"/>
          <ac:spMkLst>
            <pc:docMk/>
            <pc:sldMk cId="2920808942" sldId="267"/>
            <ac:spMk id="4" creationId="{625361A5-B4DD-DBE6-FA4A-677CE41215B8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10" creationId="{BE978AF5-75B6-555E-B6AE-0BB0ACC44B57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16" creationId="{E9728AAF-A5C0-92F8-0AE3-F9FD5B8D658F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17" creationId="{16F1AC77-ED2F-6FCC-FBFB-CF8FEF10E7EC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19" creationId="{63407444-6C29-D9D6-A28B-E2AAB4DC59DF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22" creationId="{F2E1977B-51C2-1983-382F-9B255E06B8BF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25" creationId="{EADDCF27-842A-9CE0-0FEB-EAFDFABFDC74}"/>
          </ac:spMkLst>
        </pc:spChg>
        <pc:spChg chg="mod">
          <ac:chgData name="Laura Ochoa" userId="59124860-347a-40b0-a9d2-c7a2e55c2f94" providerId="ADAL" clId="{67A63A88-7D7A-7647-9E34-31F962E7FC9C}" dt="2023-12-17T14:20:26.293" v="998" actId="403"/>
          <ac:spMkLst>
            <pc:docMk/>
            <pc:sldMk cId="2920808942" sldId="267"/>
            <ac:spMk id="28" creationId="{9486C795-C829-88FD-62A0-1D619ECE17A1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42" creationId="{281B2BD5-0B59-6A6A-523F-D04B9A4DFA8C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50" creationId="{D1C7B3FD-B790-41B1-596B-B42DFAC28579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54" creationId="{18B2D7D8-4281-D299-BE1B-283E3400185A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55" creationId="{614D317A-97B4-1D07-ACDA-24C58B6B589D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56" creationId="{D64EAE53-6463-E442-081A-4DD76FCEA787}"/>
          </ac:spMkLst>
        </pc:spChg>
        <pc:spChg chg="mod">
          <ac:chgData name="Laura Ochoa" userId="59124860-347a-40b0-a9d2-c7a2e55c2f94" providerId="ADAL" clId="{67A63A88-7D7A-7647-9E34-31F962E7FC9C}" dt="2023-12-17T14:21:51.325" v="1022" actId="404"/>
          <ac:spMkLst>
            <pc:docMk/>
            <pc:sldMk cId="2920808942" sldId="267"/>
            <ac:spMk id="57" creationId="{2ABD3D55-A127-E33F-0613-817D25230418}"/>
          </ac:spMkLst>
        </pc:spChg>
        <pc:spChg chg="mod">
          <ac:chgData name="Laura Ochoa" userId="59124860-347a-40b0-a9d2-c7a2e55c2f94" providerId="ADAL" clId="{67A63A88-7D7A-7647-9E34-31F962E7FC9C}" dt="2023-12-17T14:22:05.941" v="1049" actId="403"/>
          <ac:spMkLst>
            <pc:docMk/>
            <pc:sldMk cId="2920808942" sldId="267"/>
            <ac:spMk id="58" creationId="{44FE9872-3B04-1B08-8130-5D0E4B0F8ADF}"/>
          </ac:spMkLst>
        </pc:spChg>
        <pc:spChg chg="mod">
          <ac:chgData name="Laura Ochoa" userId="59124860-347a-40b0-a9d2-c7a2e55c2f94" providerId="ADAL" clId="{67A63A88-7D7A-7647-9E34-31F962E7FC9C}" dt="2023-12-17T14:26:44.923" v="1250" actId="1036"/>
          <ac:spMkLst>
            <pc:docMk/>
            <pc:sldMk cId="2920808942" sldId="267"/>
            <ac:spMk id="60" creationId="{5CB0B68A-E407-5C6F-3647-5A1EA7F4C05E}"/>
          </ac:spMkLst>
        </pc:spChg>
        <pc:spChg chg="mod">
          <ac:chgData name="Laura Ochoa" userId="59124860-347a-40b0-a9d2-c7a2e55c2f94" providerId="ADAL" clId="{67A63A88-7D7A-7647-9E34-31F962E7FC9C}" dt="2023-12-17T14:27:42.197" v="1261" actId="1076"/>
          <ac:spMkLst>
            <pc:docMk/>
            <pc:sldMk cId="2920808942" sldId="267"/>
            <ac:spMk id="63" creationId="{727A6F84-414D-C095-BCC6-933A740F2ED8}"/>
          </ac:spMkLst>
        </pc:spChg>
        <pc:spChg chg="del">
          <ac:chgData name="Laura Ochoa" userId="59124860-347a-40b0-a9d2-c7a2e55c2f94" providerId="ADAL" clId="{67A63A88-7D7A-7647-9E34-31F962E7FC9C}" dt="2023-12-17T14:23:53.488" v="1059" actId="478"/>
          <ac:spMkLst>
            <pc:docMk/>
            <pc:sldMk cId="2920808942" sldId="267"/>
            <ac:spMk id="64" creationId="{A6F41BA1-34A5-FAEC-385E-95BE12A3DC39}"/>
          </ac:spMkLst>
        </pc:spChg>
        <pc:spChg chg="mod">
          <ac:chgData name="Laura Ochoa" userId="59124860-347a-40b0-a9d2-c7a2e55c2f94" providerId="ADAL" clId="{67A63A88-7D7A-7647-9E34-31F962E7FC9C}" dt="2023-12-17T14:25:29.077" v="1161" actId="1036"/>
          <ac:spMkLst>
            <pc:docMk/>
            <pc:sldMk cId="2920808942" sldId="267"/>
            <ac:spMk id="65" creationId="{C7CDB78A-D962-D65A-9834-9DB1C1D4E545}"/>
          </ac:spMkLst>
        </pc:spChg>
        <pc:spChg chg="mod">
          <ac:chgData name="Laura Ochoa" userId="59124860-347a-40b0-a9d2-c7a2e55c2f94" providerId="ADAL" clId="{67A63A88-7D7A-7647-9E34-31F962E7FC9C}" dt="2023-12-17T14:25:16.749" v="1135" actId="1037"/>
          <ac:spMkLst>
            <pc:docMk/>
            <pc:sldMk cId="2920808942" sldId="267"/>
            <ac:spMk id="66" creationId="{2A5A7F23-CA7A-3CBA-8F56-772EFE895076}"/>
          </ac:spMkLst>
        </pc:spChg>
        <pc:spChg chg="mod">
          <ac:chgData name="Laura Ochoa" userId="59124860-347a-40b0-a9d2-c7a2e55c2f94" providerId="ADAL" clId="{67A63A88-7D7A-7647-9E34-31F962E7FC9C}" dt="2023-12-17T14:26:21.269" v="1249" actId="1038"/>
          <ac:spMkLst>
            <pc:docMk/>
            <pc:sldMk cId="2920808942" sldId="267"/>
            <ac:spMk id="67" creationId="{A746B4C1-421E-21B1-5907-43CA432C6271}"/>
          </ac:spMkLst>
        </pc:spChg>
        <pc:spChg chg="mod">
          <ac:chgData name="Laura Ochoa" userId="59124860-347a-40b0-a9d2-c7a2e55c2f94" providerId="ADAL" clId="{67A63A88-7D7A-7647-9E34-31F962E7FC9C}" dt="2023-12-17T14:26:00.019" v="1245" actId="1037"/>
          <ac:spMkLst>
            <pc:docMk/>
            <pc:sldMk cId="2920808942" sldId="267"/>
            <ac:spMk id="68" creationId="{EB5ADCE8-4606-7A67-6622-90114755604B}"/>
          </ac:spMkLst>
        </pc:spChg>
        <pc:spChg chg="mod">
          <ac:chgData name="Laura Ochoa" userId="59124860-347a-40b0-a9d2-c7a2e55c2f94" providerId="ADAL" clId="{67A63A88-7D7A-7647-9E34-31F962E7FC9C}" dt="2023-12-17T14:27:37.842" v="1260" actId="1076"/>
          <ac:spMkLst>
            <pc:docMk/>
            <pc:sldMk cId="2920808942" sldId="267"/>
            <ac:spMk id="69" creationId="{35835564-0A36-8036-46AF-DBE67CF67329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72" creationId="{09BCB0AE-E0E7-2798-D60B-0B36FA737C28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75" creationId="{4BA70D5D-88C8-F64F-9E18-FE5017973D2E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100" creationId="{2112AFD8-938B-5313-EC87-9CA0BC0319C8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104" creationId="{4B9FE5F5-4CD9-8BEC-487B-FAD6E61E1E56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105" creationId="{C613A2E4-4D11-4085-6C56-AEAC184D366A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106" creationId="{FF362D2A-C966-5255-6421-BE44C6725403}"/>
          </ac:spMkLst>
        </pc:spChg>
        <pc:spChg chg="mod">
          <ac:chgData name="Laura Ochoa" userId="59124860-347a-40b0-a9d2-c7a2e55c2f94" providerId="ADAL" clId="{67A63A88-7D7A-7647-9E34-31F962E7FC9C}" dt="2023-12-17T14:28:35.531" v="1268"/>
          <ac:spMkLst>
            <pc:docMk/>
            <pc:sldMk cId="2920808942" sldId="267"/>
            <ac:spMk id="107" creationId="{1AAB799F-4001-CD04-1FFA-F6E93C629E75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09" creationId="{3819F637-A8C2-AA46-C5E7-29CED260750D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2" creationId="{34BB966F-0D53-6278-344F-99F2B468E7C8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3" creationId="{C71ABEB7-013B-1396-8A05-309853C526F4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4" creationId="{D1B0857A-6104-6899-C9A5-95106697AC8D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5" creationId="{F8EC19A7-B9FE-B61B-29BD-B7D062DF1348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6" creationId="{13E88A2D-3962-426F-38A2-E40B2FB5C589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7" creationId="{80296362-37D3-E852-9752-83A51C934EA5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19" creationId="{435FC615-4F5D-DFF4-DFC6-B056BFB40BEA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2" creationId="{724B1A20-0974-8161-D07F-C8DB19289093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4" creationId="{CF6299EF-1035-7653-32CB-5DD293F5F3D2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5" creationId="{33801605-ED00-D1FE-3DD0-E9D2A72A1C69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6" creationId="{E35F4E0E-C0D2-F19A-6415-F6A2B0BFD136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7" creationId="{7C075623-469E-A40F-0697-1BC2953D617D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8" creationId="{8B74F830-3CEA-D015-F7A4-C3E2425F8AE7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29" creationId="{DB8EDF5A-D724-FACC-FA0B-87D92B280240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1" creationId="{93E43035-2795-4063-1C68-937D44FC0BC4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4" creationId="{AF53F6FE-6C27-CBAA-3CC6-A80AB44C8888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5" creationId="{6BFB3228-A300-2714-293C-8411BAA326C1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6" creationId="{AB4CEF90-DA76-2035-383C-1D8A1ED9CFF6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7" creationId="{3E2F20FC-59C9-34F2-F22D-45F692F85FDD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8" creationId="{51F4B3FF-9A93-BE17-1812-3515D89EE8F0}"/>
          </ac:spMkLst>
        </pc:spChg>
        <pc:spChg chg="mod">
          <ac:chgData name="Laura Ochoa" userId="59124860-347a-40b0-a9d2-c7a2e55c2f94" providerId="ADAL" clId="{67A63A88-7D7A-7647-9E34-31F962E7FC9C}" dt="2023-12-17T14:29:22.141" v="1275"/>
          <ac:spMkLst>
            <pc:docMk/>
            <pc:sldMk cId="2920808942" sldId="267"/>
            <ac:spMk id="139" creationId="{7A2FA123-8D39-1F65-4F15-B0A9C10B2393}"/>
          </ac:spMkLst>
        </pc:spChg>
        <pc:grpChg chg="del mod">
          <ac:chgData name="Laura Ochoa" userId="59124860-347a-40b0-a9d2-c7a2e55c2f94" providerId="ADAL" clId="{67A63A88-7D7A-7647-9E34-31F962E7FC9C}" dt="2023-12-17T14:29:19.218" v="1273" actId="478"/>
          <ac:grpSpMkLst>
            <pc:docMk/>
            <pc:sldMk cId="2920808942" sldId="267"/>
            <ac:grpSpMk id="6" creationId="{BBEEBE67-8EAA-4035-4B12-CE2ABE2243BD}"/>
          </ac:grpSpMkLst>
        </pc:grpChg>
        <pc:grpChg chg="add mod">
          <ac:chgData name="Laura Ochoa" userId="59124860-347a-40b0-a9d2-c7a2e55c2f94" providerId="ADAL" clId="{67A63A88-7D7A-7647-9E34-31F962E7FC9C}" dt="2023-12-17T14:18:46.923" v="972" actId="1076"/>
          <ac:grpSpMkLst>
            <pc:docMk/>
            <pc:sldMk cId="2920808942" sldId="267"/>
            <ac:grpSpMk id="31" creationId="{EF47B5FF-FBC9-829F-35B8-CEE28113BC32}"/>
          </ac:grpSpMkLst>
        </pc:grpChg>
        <pc:grpChg chg="add del mod">
          <ac:chgData name="Laura Ochoa" userId="59124860-347a-40b0-a9d2-c7a2e55c2f94" providerId="ADAL" clId="{67A63A88-7D7A-7647-9E34-31F962E7FC9C}" dt="2023-12-17T14:29:26.967" v="1277" actId="478"/>
          <ac:grpSpMkLst>
            <pc:docMk/>
            <pc:sldMk cId="2920808942" sldId="267"/>
            <ac:grpSpMk id="34" creationId="{AA0BFCE4-E4F8-82D6-4885-C88C8890C301}"/>
          </ac:grpSpMkLst>
        </pc:grpChg>
        <pc:grpChg chg="add del mod">
          <ac:chgData name="Laura Ochoa" userId="59124860-347a-40b0-a9d2-c7a2e55c2f94" providerId="ADAL" clId="{67A63A88-7D7A-7647-9E34-31F962E7FC9C}" dt="2023-12-17T14:29:20.288" v="1274" actId="478"/>
          <ac:grpSpMkLst>
            <pc:docMk/>
            <pc:sldMk cId="2920808942" sldId="267"/>
            <ac:grpSpMk id="38" creationId="{F17D933C-BDD1-6BEA-42B7-F0663844F378}"/>
          </ac:grpSpMkLst>
        </pc:grpChg>
        <pc:grpChg chg="mod">
          <ac:chgData name="Laura Ochoa" userId="59124860-347a-40b0-a9d2-c7a2e55c2f94" providerId="ADAL" clId="{67A63A88-7D7A-7647-9E34-31F962E7FC9C}" dt="2023-12-17T14:20:33.058" v="999"/>
          <ac:grpSpMkLst>
            <pc:docMk/>
            <pc:sldMk cId="2920808942" sldId="267"/>
            <ac:grpSpMk id="43" creationId="{96ED6CAF-4833-7E8D-7B5C-F27DB5C3A42A}"/>
          </ac:grpSpMkLst>
        </pc:grpChg>
        <pc:grpChg chg="mod">
          <ac:chgData name="Laura Ochoa" userId="59124860-347a-40b0-a9d2-c7a2e55c2f94" providerId="ADAL" clId="{67A63A88-7D7A-7647-9E34-31F962E7FC9C}" dt="2023-12-17T14:20:33.058" v="999"/>
          <ac:grpSpMkLst>
            <pc:docMk/>
            <pc:sldMk cId="2920808942" sldId="267"/>
            <ac:grpSpMk id="49" creationId="{C4FBBDA8-2A08-EFC5-FBD8-0C705F5F090B}"/>
          </ac:grpSpMkLst>
        </pc:grpChg>
        <pc:grpChg chg="del">
          <ac:chgData name="Laura Ochoa" userId="59124860-347a-40b0-a9d2-c7a2e55c2f94" providerId="ADAL" clId="{67A63A88-7D7A-7647-9E34-31F962E7FC9C}" dt="2023-12-17T14:18:36.890" v="968" actId="478"/>
          <ac:grpSpMkLst>
            <pc:docMk/>
            <pc:sldMk cId="2920808942" sldId="267"/>
            <ac:grpSpMk id="53" creationId="{3A62EA54-80D8-1943-6D41-7F3020AF6520}"/>
          </ac:grpSpMkLst>
        </pc:grpChg>
        <pc:grpChg chg="add del mod">
          <ac:chgData name="Laura Ochoa" userId="59124860-347a-40b0-a9d2-c7a2e55c2f94" providerId="ADAL" clId="{67A63A88-7D7A-7647-9E34-31F962E7FC9C}" dt="2023-12-17T14:29:28.205" v="1279" actId="478"/>
          <ac:grpSpMkLst>
            <pc:docMk/>
            <pc:sldMk cId="2920808942" sldId="267"/>
            <ac:grpSpMk id="59" creationId="{9C9B76A3-810B-D42C-1E44-E047A3105811}"/>
          </ac:grpSpMkLst>
        </pc:grpChg>
        <pc:grpChg chg="mod">
          <ac:chgData name="Laura Ochoa" userId="59124860-347a-40b0-a9d2-c7a2e55c2f94" providerId="ADAL" clId="{67A63A88-7D7A-7647-9E34-31F962E7FC9C}" dt="2023-12-17T14:23:54.473" v="1060"/>
          <ac:grpSpMkLst>
            <pc:docMk/>
            <pc:sldMk cId="2920808942" sldId="267"/>
            <ac:grpSpMk id="61" creationId="{FD408973-7156-9D88-C4D2-CF7265F1AE7C}"/>
          </ac:grpSpMkLst>
        </pc:grpChg>
        <pc:grpChg chg="mod">
          <ac:chgData name="Laura Ochoa" userId="59124860-347a-40b0-a9d2-c7a2e55c2f94" providerId="ADAL" clId="{67A63A88-7D7A-7647-9E34-31F962E7FC9C}" dt="2023-12-17T14:23:54.473" v="1060"/>
          <ac:grpSpMkLst>
            <pc:docMk/>
            <pc:sldMk cId="2920808942" sldId="267"/>
            <ac:grpSpMk id="62" creationId="{607C25F1-877A-5B7B-78B7-2C6E5C0C378E}"/>
          </ac:grpSpMkLst>
        </pc:grpChg>
        <pc:grpChg chg="add del mod">
          <ac:chgData name="Laura Ochoa" userId="59124860-347a-40b0-a9d2-c7a2e55c2f94" providerId="ADAL" clId="{67A63A88-7D7A-7647-9E34-31F962E7FC9C}" dt="2023-12-17T14:29:27.569" v="1278" actId="478"/>
          <ac:grpSpMkLst>
            <pc:docMk/>
            <pc:sldMk cId="2920808942" sldId="267"/>
            <ac:grpSpMk id="71" creationId="{E3E020FE-8DCD-7CD1-3613-D8A4F55FABFA}"/>
          </ac:grpSpMkLst>
        </pc:grpChg>
        <pc:grpChg chg="mod">
          <ac:chgData name="Laura Ochoa" userId="59124860-347a-40b0-a9d2-c7a2e55c2f94" providerId="ADAL" clId="{67A63A88-7D7A-7647-9E34-31F962E7FC9C}" dt="2023-12-17T14:28:35.531" v="1268"/>
          <ac:grpSpMkLst>
            <pc:docMk/>
            <pc:sldMk cId="2920808942" sldId="267"/>
            <ac:grpSpMk id="73" creationId="{363213CB-3709-A492-6C30-D8202836AEDF}"/>
          </ac:grpSpMkLst>
        </pc:grpChg>
        <pc:grpChg chg="mod">
          <ac:chgData name="Laura Ochoa" userId="59124860-347a-40b0-a9d2-c7a2e55c2f94" providerId="ADAL" clId="{67A63A88-7D7A-7647-9E34-31F962E7FC9C}" dt="2023-12-17T14:28:35.531" v="1268"/>
          <ac:grpSpMkLst>
            <pc:docMk/>
            <pc:sldMk cId="2920808942" sldId="267"/>
            <ac:grpSpMk id="74" creationId="{5A53788B-D8A3-2DE3-1BA1-4BB4C41F0F16}"/>
          </ac:grpSpMkLst>
        </pc:grpChg>
        <pc:grpChg chg="del">
          <ac:chgData name="Laura Ochoa" userId="59124860-347a-40b0-a9d2-c7a2e55c2f94" providerId="ADAL" clId="{67A63A88-7D7A-7647-9E34-31F962E7FC9C}" dt="2023-12-17T14:18:37.681" v="969" actId="478"/>
          <ac:grpSpMkLst>
            <pc:docMk/>
            <pc:sldMk cId="2920808942" sldId="267"/>
            <ac:grpSpMk id="76" creationId="{B9F3A558-3284-190E-4EEB-A841BEE02096}"/>
          </ac:grpSpMkLst>
        </pc:grpChg>
        <pc:grpChg chg="add mod">
          <ac:chgData name="Laura Ochoa" userId="59124860-347a-40b0-a9d2-c7a2e55c2f94" providerId="ADAL" clId="{67A63A88-7D7A-7647-9E34-31F962E7FC9C}" dt="2023-12-17T14:29:44.305" v="1282" actId="1076"/>
          <ac:grpSpMkLst>
            <pc:docMk/>
            <pc:sldMk cId="2920808942" sldId="267"/>
            <ac:grpSpMk id="108" creationId="{F5E28587-AA93-DF51-4319-310C30373BEF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10" creationId="{AF9F3462-6445-D48F-488E-D0F6E4688754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11" creationId="{B5D67188-A416-C224-3F91-18E5EB4B7086}"/>
          </ac:grpSpMkLst>
        </pc:grpChg>
        <pc:grpChg chg="add mod">
          <ac:chgData name="Laura Ochoa" userId="59124860-347a-40b0-a9d2-c7a2e55c2f94" providerId="ADAL" clId="{67A63A88-7D7A-7647-9E34-31F962E7FC9C}" dt="2023-12-17T14:29:31.704" v="1280" actId="1076"/>
          <ac:grpSpMkLst>
            <pc:docMk/>
            <pc:sldMk cId="2920808942" sldId="267"/>
            <ac:grpSpMk id="118" creationId="{36D5E7B9-D6E8-92C3-8BD9-747C3EE0307D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20" creationId="{47BFA4CD-AE5E-EDB8-43C7-163F50505362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21" creationId="{41116CE2-86C9-39DE-C8F5-96E17369FDFE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23" creationId="{DB84E9B2-9CB4-DA9C-D0A8-F99AFAD39B44}"/>
          </ac:grpSpMkLst>
        </pc:grpChg>
        <pc:grpChg chg="add mod">
          <ac:chgData name="Laura Ochoa" userId="59124860-347a-40b0-a9d2-c7a2e55c2f94" providerId="ADAL" clId="{67A63A88-7D7A-7647-9E34-31F962E7FC9C}" dt="2023-12-17T14:29:38.361" v="1281" actId="1076"/>
          <ac:grpSpMkLst>
            <pc:docMk/>
            <pc:sldMk cId="2920808942" sldId="267"/>
            <ac:grpSpMk id="130" creationId="{4243DB5D-B3FE-2FD8-279C-60CA3A17FB76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32" creationId="{899E42E6-05B0-EF4B-9A36-3CCDFBB16472}"/>
          </ac:grpSpMkLst>
        </pc:grpChg>
        <pc:grpChg chg="mod">
          <ac:chgData name="Laura Ochoa" userId="59124860-347a-40b0-a9d2-c7a2e55c2f94" providerId="ADAL" clId="{67A63A88-7D7A-7647-9E34-31F962E7FC9C}" dt="2023-12-17T14:29:22.141" v="1275"/>
          <ac:grpSpMkLst>
            <pc:docMk/>
            <pc:sldMk cId="2920808942" sldId="267"/>
            <ac:grpSpMk id="133" creationId="{54BDA97B-E99B-7F6A-E854-2956630DC274}"/>
          </ac:grpSpMkLst>
        </pc:grpChg>
        <pc:picChg chg="add del mod">
          <ac:chgData name="Laura Ochoa" userId="59124860-347a-40b0-a9d2-c7a2e55c2f94" providerId="ADAL" clId="{67A63A88-7D7A-7647-9E34-31F962E7FC9C}" dt="2023-12-17T14:26:56.585" v="1251" actId="478"/>
          <ac:picMkLst>
            <pc:docMk/>
            <pc:sldMk cId="2920808942" sldId="267"/>
            <ac:picMk id="70" creationId="{02DDC3B1-0372-B01D-35F5-E3DCF93EDFAE}"/>
          </ac:picMkLst>
        </pc:picChg>
      </pc:sldChg>
      <pc:sldChg chg="addSp delSp modSp add mod ord">
        <pc:chgData name="Laura Ochoa" userId="59124860-347a-40b0-a9d2-c7a2e55c2f94" providerId="ADAL" clId="{67A63A88-7D7A-7647-9E34-31F962E7FC9C}" dt="2023-12-19T02:05:16.453" v="2547" actId="20577"/>
        <pc:sldMkLst>
          <pc:docMk/>
          <pc:sldMk cId="1061097907" sldId="269"/>
        </pc:sldMkLst>
        <pc:spChg chg="add del mod">
          <ac:chgData name="Laura Ochoa" userId="59124860-347a-40b0-a9d2-c7a2e55c2f94" providerId="ADAL" clId="{67A63A88-7D7A-7647-9E34-31F962E7FC9C}" dt="2023-12-19T01:39:14.331" v="1400"/>
          <ac:spMkLst>
            <pc:docMk/>
            <pc:sldMk cId="1061097907" sldId="269"/>
            <ac:spMk id="3" creationId="{7DA48307-DED1-366E-44AA-D840C0699FA3}"/>
          </ac:spMkLst>
        </pc:spChg>
        <pc:spChg chg="mod">
          <ac:chgData name="Laura Ochoa" userId="59124860-347a-40b0-a9d2-c7a2e55c2f94" providerId="ADAL" clId="{67A63A88-7D7A-7647-9E34-31F962E7FC9C}" dt="2023-12-19T01:45:59.391" v="1657" actId="20577"/>
          <ac:spMkLst>
            <pc:docMk/>
            <pc:sldMk cId="1061097907" sldId="269"/>
            <ac:spMk id="4" creationId="{625361A5-B4DD-DBE6-FA4A-677CE41215B8}"/>
          </ac:spMkLst>
        </pc:spChg>
        <pc:spChg chg="add mod">
          <ac:chgData name="Laura Ochoa" userId="59124860-347a-40b0-a9d2-c7a2e55c2f94" providerId="ADAL" clId="{67A63A88-7D7A-7647-9E34-31F962E7FC9C}" dt="2023-12-19T01:52:42.263" v="2014" actId="14100"/>
          <ac:spMkLst>
            <pc:docMk/>
            <pc:sldMk cId="1061097907" sldId="269"/>
            <ac:spMk id="6" creationId="{2D4A3562-01A6-6BC3-79AE-7F65DEDA1E6D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8" creationId="{9DCB5C82-ABCE-4F58-6840-B68006E3CE33}"/>
          </ac:spMkLst>
        </pc:spChg>
        <pc:spChg chg="add del">
          <ac:chgData name="Laura Ochoa" userId="59124860-347a-40b0-a9d2-c7a2e55c2f94" providerId="ADAL" clId="{67A63A88-7D7A-7647-9E34-31F962E7FC9C}" dt="2023-12-19T01:41:00.196" v="1419" actId="478"/>
          <ac:spMkLst>
            <pc:docMk/>
            <pc:sldMk cId="1061097907" sldId="269"/>
            <ac:spMk id="11" creationId="{CBAE406D-BEA1-4A72-4ADB-03F4B5714A01}"/>
          </ac:spMkLst>
        </pc:spChg>
        <pc:spChg chg="add mod">
          <ac:chgData name="Laura Ochoa" userId="59124860-347a-40b0-a9d2-c7a2e55c2f94" providerId="ADAL" clId="{67A63A88-7D7A-7647-9E34-31F962E7FC9C}" dt="2023-12-19T01:41:31.480" v="1427" actId="1076"/>
          <ac:spMkLst>
            <pc:docMk/>
            <pc:sldMk cId="1061097907" sldId="269"/>
            <ac:spMk id="14" creationId="{D9455551-420B-5F27-03A7-08A42D48CE44}"/>
          </ac:spMkLst>
        </pc:spChg>
        <pc:spChg chg="add mod">
          <ac:chgData name="Laura Ochoa" userId="59124860-347a-40b0-a9d2-c7a2e55c2f94" providerId="ADAL" clId="{67A63A88-7D7A-7647-9E34-31F962E7FC9C}" dt="2023-12-19T01:52:47.613" v="2015" actId="14100"/>
          <ac:spMkLst>
            <pc:docMk/>
            <pc:sldMk cId="1061097907" sldId="269"/>
            <ac:spMk id="17" creationId="{3BC412CD-7ABF-0D13-8E3A-A47748A8FA4D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20" creationId="{7A9B7C27-05D1-3E5A-DD52-946D7E74FC2C}"/>
          </ac:spMkLst>
        </pc:spChg>
        <pc:spChg chg="add mod">
          <ac:chgData name="Laura Ochoa" userId="59124860-347a-40b0-a9d2-c7a2e55c2f94" providerId="ADAL" clId="{67A63A88-7D7A-7647-9E34-31F962E7FC9C}" dt="2023-12-19T01:44:56.758" v="1632" actId="1035"/>
          <ac:spMkLst>
            <pc:docMk/>
            <pc:sldMk cId="1061097907" sldId="269"/>
            <ac:spMk id="22" creationId="{120DA94E-AAFC-2BF9-8CFC-F95C39DC04E2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23" creationId="{E22EF6C9-7205-7292-7EC8-ADCB26C3DC96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26" creationId="{8BBC649C-C1E0-48D7-DD67-969621D7386E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29" creationId="{11BB7C8A-598B-22A8-6574-FD6F5D096521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32" creationId="{0BAB6074-433B-CE6B-7E2A-469D9CAB78AF}"/>
          </ac:spMkLst>
        </pc:spChg>
        <pc:spChg chg="mod">
          <ac:chgData name="Laura Ochoa" userId="59124860-347a-40b0-a9d2-c7a2e55c2f94" providerId="ADAL" clId="{67A63A88-7D7A-7647-9E34-31F962E7FC9C}" dt="2023-12-19T01:50:12.916" v="1993" actId="1036"/>
          <ac:spMkLst>
            <pc:docMk/>
            <pc:sldMk cId="1061097907" sldId="269"/>
            <ac:spMk id="34" creationId="{7917C2E4-0DEB-4F4A-ED6C-FA4C9CC70967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35" creationId="{964C837B-8FE6-A2D7-91B9-65FB2605C105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36" creationId="{A522DE97-5567-7424-2F82-F2E2412E5241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37" creationId="{91E2505B-FE47-C87D-D7AA-968BBE11D180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40" creationId="{23B5C67A-8349-EF33-51C2-2CB56E3EA6A3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45" creationId="{B55720EB-586E-A7D8-34E6-77B955A97793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46" creationId="{71538C0B-BD28-D99E-4575-EF5B1DEC5A82}"/>
          </ac:spMkLst>
        </pc:spChg>
        <pc:spChg chg="mod">
          <ac:chgData name="Laura Ochoa" userId="59124860-347a-40b0-a9d2-c7a2e55c2f94" providerId="ADAL" clId="{67A63A88-7D7A-7647-9E34-31F962E7FC9C}" dt="2023-12-19T01:45:20.881" v="1634" actId="1036"/>
          <ac:spMkLst>
            <pc:docMk/>
            <pc:sldMk cId="1061097907" sldId="269"/>
            <ac:spMk id="48" creationId="{C74D277D-12EF-3870-0FEF-F4A9C632A23D}"/>
          </ac:spMkLst>
        </pc:spChg>
        <pc:spChg chg="mod">
          <ac:chgData name="Laura Ochoa" userId="59124860-347a-40b0-a9d2-c7a2e55c2f94" providerId="ADAL" clId="{67A63A88-7D7A-7647-9E34-31F962E7FC9C}" dt="2023-12-19T01:49:39.368" v="1932" actId="1035"/>
          <ac:spMkLst>
            <pc:docMk/>
            <pc:sldMk cId="1061097907" sldId="269"/>
            <ac:spMk id="49" creationId="{3B26A0D3-A9F4-9AC2-1A99-7044FFF8C5DD}"/>
          </ac:spMkLst>
        </pc:spChg>
        <pc:spChg chg="mod">
          <ac:chgData name="Laura Ochoa" userId="59124860-347a-40b0-a9d2-c7a2e55c2f94" providerId="ADAL" clId="{67A63A88-7D7A-7647-9E34-31F962E7FC9C}" dt="2023-12-19T01:39:48.040" v="1413" actId="208"/>
          <ac:spMkLst>
            <pc:docMk/>
            <pc:sldMk cId="1061097907" sldId="269"/>
            <ac:spMk id="52" creationId="{A8AACA05-F9F5-DF93-6DE8-A454BF9F6CC5}"/>
          </ac:spMkLst>
        </pc:spChg>
        <pc:spChg chg="mod">
          <ac:chgData name="Laura Ochoa" userId="59124860-347a-40b0-a9d2-c7a2e55c2f94" providerId="ADAL" clId="{67A63A88-7D7A-7647-9E34-31F962E7FC9C}" dt="2023-12-19T01:50:54.950" v="1999" actId="404"/>
          <ac:spMkLst>
            <pc:docMk/>
            <pc:sldMk cId="1061097907" sldId="269"/>
            <ac:spMk id="54" creationId="{FCB24B1C-041A-DAAF-BCDF-48026E4ED7EC}"/>
          </ac:spMkLst>
        </pc:spChg>
        <pc:spChg chg="mod">
          <ac:chgData name="Laura Ochoa" userId="59124860-347a-40b0-a9d2-c7a2e55c2f94" providerId="ADAL" clId="{67A63A88-7D7A-7647-9E34-31F962E7FC9C}" dt="2023-12-19T01:50:27.722" v="1995" actId="1035"/>
          <ac:spMkLst>
            <pc:docMk/>
            <pc:sldMk cId="1061097907" sldId="269"/>
            <ac:spMk id="55" creationId="{0DC4F4BA-FC31-B084-0CF4-8870D045ABA1}"/>
          </ac:spMkLst>
        </pc:spChg>
        <pc:spChg chg="mod">
          <ac:chgData name="Laura Ochoa" userId="59124860-347a-40b0-a9d2-c7a2e55c2f94" providerId="ADAL" clId="{67A63A88-7D7A-7647-9E34-31F962E7FC9C}" dt="2023-12-19T01:50:26.503" v="1994" actId="1035"/>
          <ac:spMkLst>
            <pc:docMk/>
            <pc:sldMk cId="1061097907" sldId="269"/>
            <ac:spMk id="56" creationId="{B7643533-7E17-924C-8D7A-F05197137DDB}"/>
          </ac:spMkLst>
        </pc:spChg>
        <pc:spChg chg="mod">
          <ac:chgData name="Laura Ochoa" userId="59124860-347a-40b0-a9d2-c7a2e55c2f94" providerId="ADAL" clId="{67A63A88-7D7A-7647-9E34-31F962E7FC9C}" dt="2023-12-19T01:48:20.216" v="1749" actId="1038"/>
          <ac:spMkLst>
            <pc:docMk/>
            <pc:sldMk cId="1061097907" sldId="269"/>
            <ac:spMk id="57" creationId="{F96C380B-3C82-E92E-B037-90913D5FDF9F}"/>
          </ac:spMkLst>
        </pc:spChg>
        <pc:spChg chg="mod">
          <ac:chgData name="Laura Ochoa" userId="59124860-347a-40b0-a9d2-c7a2e55c2f94" providerId="ADAL" clId="{67A63A88-7D7A-7647-9E34-31F962E7FC9C}" dt="2023-12-19T01:48:28.392" v="1773" actId="1037"/>
          <ac:spMkLst>
            <pc:docMk/>
            <pc:sldMk cId="1061097907" sldId="269"/>
            <ac:spMk id="58" creationId="{94BD8F6B-9FD3-5ADE-D851-04259BE7B2D7}"/>
          </ac:spMkLst>
        </pc:spChg>
        <pc:spChg chg="mod">
          <ac:chgData name="Laura Ochoa" userId="59124860-347a-40b0-a9d2-c7a2e55c2f94" providerId="ADAL" clId="{67A63A88-7D7A-7647-9E34-31F962E7FC9C}" dt="2023-12-19T01:51:04.890" v="2000" actId="1076"/>
          <ac:spMkLst>
            <pc:docMk/>
            <pc:sldMk cId="1061097907" sldId="269"/>
            <ac:spMk id="59" creationId="{E913963E-3463-3A37-9513-4A12091CE393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0" creationId="{983F2ED8-82B2-813F-69C4-D0A55F31DD88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3" creationId="{C1B55D5A-B55A-9771-D90D-A45B23B90743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6" creationId="{9F2D294A-E570-7388-8394-1CEBA9B3D5BA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7" creationId="{764ED7F4-556E-9186-C07B-38457713F353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8" creationId="{031CC5BC-F75F-7DC6-0299-926B2EEA2F6A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69" creationId="{2516456F-8755-6136-B4FF-2103C20A2B87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70" creationId="{2775EE9D-49FA-9871-9509-3563502A978C}"/>
          </ac:spMkLst>
        </pc:spChg>
        <pc:spChg chg="mod">
          <ac:chgData name="Laura Ochoa" userId="59124860-347a-40b0-a9d2-c7a2e55c2f94" providerId="ADAL" clId="{67A63A88-7D7A-7647-9E34-31F962E7FC9C}" dt="2023-12-19T01:52:30.259" v="2012"/>
          <ac:spMkLst>
            <pc:docMk/>
            <pc:sldMk cId="1061097907" sldId="269"/>
            <ac:spMk id="71" creationId="{A942D92E-39B2-369F-2A5E-56E5CAC4DE9F}"/>
          </ac:spMkLst>
        </pc:spChg>
        <pc:spChg chg="add mod">
          <ac:chgData name="Laura Ochoa" userId="59124860-347a-40b0-a9d2-c7a2e55c2f94" providerId="ADAL" clId="{67A63A88-7D7A-7647-9E34-31F962E7FC9C}" dt="2023-12-19T02:05:16.453" v="2547" actId="20577"/>
          <ac:spMkLst>
            <pc:docMk/>
            <pc:sldMk cId="1061097907" sldId="269"/>
            <ac:spMk id="73" creationId="{AD25639C-994C-69F5-1E6E-55AE87EFF444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79" creationId="{06BA78B5-305A-5F90-8369-54111EA6C310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83" creationId="{3E0636C2-260C-033E-9924-2741F8EEFB28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85" creationId="{31C062C1-7387-9736-275D-CC9E1C6FAA73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87" creationId="{2C66B28D-B5AA-9762-F6F4-A16A4D39483A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89" creationId="{DFBE3EFF-3513-D8C3-DD07-38B72199981A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101" creationId="{D19977D6-CF0C-A695-44E3-4FAFCE56CE39}"/>
          </ac:spMkLst>
        </pc:spChg>
        <pc:spChg chg="mod">
          <ac:chgData name="Laura Ochoa" userId="59124860-347a-40b0-a9d2-c7a2e55c2f94" providerId="ADAL" clId="{67A63A88-7D7A-7647-9E34-31F962E7FC9C}" dt="2023-12-19T01:42:23.906" v="1431" actId="255"/>
          <ac:spMkLst>
            <pc:docMk/>
            <pc:sldMk cId="1061097907" sldId="269"/>
            <ac:spMk id="103" creationId="{DFD71DBE-9CDE-59A9-3D1C-3E2A38C1A347}"/>
          </ac:spMkLst>
        </pc:spChg>
        <pc:grpChg chg="add mod">
          <ac:chgData name="Laura Ochoa" userId="59124860-347a-40b0-a9d2-c7a2e55c2f94" providerId="ADAL" clId="{67A63A88-7D7A-7647-9E34-31F962E7FC9C}" dt="2023-12-19T01:41:48.581" v="1429" actId="1076"/>
          <ac:grpSpMkLst>
            <pc:docMk/>
            <pc:sldMk cId="1061097907" sldId="269"/>
            <ac:grpSpMk id="16" creationId="{B7479125-A159-5368-44C0-5C9CD14DF77B}"/>
          </ac:grpSpMkLst>
        </pc:grpChg>
        <pc:grpChg chg="add">
          <ac:chgData name="Laura Ochoa" userId="59124860-347a-40b0-a9d2-c7a2e55c2f94" providerId="ADAL" clId="{67A63A88-7D7A-7647-9E34-31F962E7FC9C}" dt="2023-12-19T01:45:04.369" v="1633" actId="164"/>
          <ac:grpSpMkLst>
            <pc:docMk/>
            <pc:sldMk cId="1061097907" sldId="269"/>
            <ac:grpSpMk id="25" creationId="{5AA7F7F1-E644-9691-E94D-1FADCFBE60F1}"/>
          </ac:grpSpMkLst>
        </pc:grpChg>
        <pc:grpChg chg="add">
          <ac:chgData name="Laura Ochoa" userId="59124860-347a-40b0-a9d2-c7a2e55c2f94" providerId="ADAL" clId="{67A63A88-7D7A-7647-9E34-31F962E7FC9C}" dt="2023-12-19T01:51:46.672" v="2005" actId="164"/>
          <ac:grpSpMkLst>
            <pc:docMk/>
            <pc:sldMk cId="1061097907" sldId="269"/>
            <ac:grpSpMk id="28" creationId="{0719C164-4CC7-DC96-7089-E00769B7BC2D}"/>
          </ac:grpSpMkLst>
        </pc:grpChg>
        <pc:grpChg chg="del mod">
          <ac:chgData name="Laura Ochoa" userId="59124860-347a-40b0-a9d2-c7a2e55c2f94" providerId="ADAL" clId="{67A63A88-7D7A-7647-9E34-31F962E7FC9C}" dt="2023-12-19T01:52:29.085" v="2011" actId="478"/>
          <ac:grpSpMkLst>
            <pc:docMk/>
            <pc:sldMk cId="1061097907" sldId="269"/>
            <ac:grpSpMk id="31" creationId="{630E7D5F-F89F-B8DE-6413-E418E9B68B31}"/>
          </ac:grpSpMkLst>
        </pc:grpChg>
        <pc:grpChg chg="add mod">
          <ac:chgData name="Laura Ochoa" userId="59124860-347a-40b0-a9d2-c7a2e55c2f94" providerId="ADAL" clId="{67A63A88-7D7A-7647-9E34-31F962E7FC9C}" dt="2023-12-19T01:52:52.295" v="2016" actId="1076"/>
          <ac:grpSpMkLst>
            <pc:docMk/>
            <pc:sldMk cId="1061097907" sldId="269"/>
            <ac:grpSpMk id="42" creationId="{BB2F568D-37F5-D9A0-B872-214AC7E78E90}"/>
          </ac:grpSpMkLst>
        </pc:grpChg>
        <pc:grpChg chg="mod">
          <ac:chgData name="Laura Ochoa" userId="59124860-347a-40b0-a9d2-c7a2e55c2f94" providerId="ADAL" clId="{67A63A88-7D7A-7647-9E34-31F962E7FC9C}" dt="2023-12-19T01:39:34.237" v="1411" actId="1036"/>
          <ac:grpSpMkLst>
            <pc:docMk/>
            <pc:sldMk cId="1061097907" sldId="269"/>
            <ac:grpSpMk id="53" creationId="{3A62EA54-80D8-1943-6D41-7F3020AF6520}"/>
          </ac:grpSpMkLst>
        </pc:grpChg>
        <pc:grpChg chg="mod">
          <ac:chgData name="Laura Ochoa" userId="59124860-347a-40b0-a9d2-c7a2e55c2f94" providerId="ADAL" clId="{67A63A88-7D7A-7647-9E34-31F962E7FC9C}" dt="2023-12-19T01:52:30.259" v="2012"/>
          <ac:grpSpMkLst>
            <pc:docMk/>
            <pc:sldMk cId="1061097907" sldId="269"/>
            <ac:grpSpMk id="61" creationId="{FACBB051-6085-3013-7B55-7D350CACCA59}"/>
          </ac:grpSpMkLst>
        </pc:grpChg>
        <pc:grpChg chg="mod">
          <ac:chgData name="Laura Ochoa" userId="59124860-347a-40b0-a9d2-c7a2e55c2f94" providerId="ADAL" clId="{67A63A88-7D7A-7647-9E34-31F962E7FC9C}" dt="2023-12-19T01:52:30.259" v="2012"/>
          <ac:grpSpMkLst>
            <pc:docMk/>
            <pc:sldMk cId="1061097907" sldId="269"/>
            <ac:grpSpMk id="62" creationId="{0684FC0E-41DC-10E3-77A3-6121A1A64BD7}"/>
          </ac:grpSpMkLst>
        </pc:grpChg>
        <pc:grpChg chg="mod">
          <ac:chgData name="Laura Ochoa" userId="59124860-347a-40b0-a9d2-c7a2e55c2f94" providerId="ADAL" clId="{67A63A88-7D7A-7647-9E34-31F962E7FC9C}" dt="2023-12-19T01:52:30.259" v="2012"/>
          <ac:grpSpMkLst>
            <pc:docMk/>
            <pc:sldMk cId="1061097907" sldId="269"/>
            <ac:grpSpMk id="65" creationId="{F735CA4E-458B-E636-2342-5EDF3ECE9B94}"/>
          </ac:grpSpMkLst>
        </pc:grpChg>
        <pc:grpChg chg="mod">
          <ac:chgData name="Laura Ochoa" userId="59124860-347a-40b0-a9d2-c7a2e55c2f94" providerId="ADAL" clId="{67A63A88-7D7A-7647-9E34-31F962E7FC9C}" dt="2023-12-19T01:42:46.366" v="1476" actId="1038"/>
          <ac:grpSpMkLst>
            <pc:docMk/>
            <pc:sldMk cId="1061097907" sldId="269"/>
            <ac:grpSpMk id="76" creationId="{B9F3A558-3284-190E-4EEB-A841BEE02096}"/>
          </ac:grpSpMkLst>
        </pc:grp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9" creationId="{6D7CD361-CF96-A170-8B8A-7F05C3F8272B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12" creationId="{A1287E4C-02B4-528F-0B86-22A2C955DD59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13" creationId="{BEC86A83-28B4-77E5-B552-EFE05C4E0FF5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15" creationId="{39E7A70A-F929-3FF2-36B0-73F74FF78B96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18" creationId="{4A49744E-40D9-E1B9-C5BB-A1DF4BA41ED5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21" creationId="{67B864D9-4D3C-CCD9-6EB0-34ABB17294E5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24" creationId="{07501995-B9CF-C14E-3CE6-4E637C920EA8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27" creationId="{658744B5-D6E8-6E15-F302-8C29B5E7FF6F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30" creationId="{191DDD50-5907-A2B9-3F1F-07E789266F75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33" creationId="{ACC8C61E-3231-E6D3-3C88-06610B064368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39" creationId="{74DAEC7D-0FB6-8DCB-FBC6-E7E743590303}"/>
          </ac:picMkLst>
        </pc:picChg>
        <pc:picChg chg="mod">
          <ac:chgData name="Laura Ochoa" userId="59124860-347a-40b0-a9d2-c7a2e55c2f94" providerId="ADAL" clId="{67A63A88-7D7A-7647-9E34-31F962E7FC9C}" dt="2023-12-19T01:39:48.040" v="1413" actId="208"/>
          <ac:picMkLst>
            <pc:docMk/>
            <pc:sldMk cId="1061097907" sldId="269"/>
            <ac:picMk id="44" creationId="{1918DC2A-0241-50AA-7D33-5F8AAF133E49}"/>
          </ac:picMkLst>
        </pc:picChg>
      </pc:sldChg>
      <pc:sldChg chg="addSp delSp modSp add del mod">
        <pc:chgData name="Laura Ochoa" userId="59124860-347a-40b0-a9d2-c7a2e55c2f94" providerId="ADAL" clId="{67A63A88-7D7A-7647-9E34-31F962E7FC9C}" dt="2023-12-19T02:05:25.129" v="2548" actId="2696"/>
        <pc:sldMkLst>
          <pc:docMk/>
          <pc:sldMk cId="3797446527" sldId="270"/>
        </pc:sldMkLst>
        <pc:spChg chg="del">
          <ac:chgData name="Laura Ochoa" userId="59124860-347a-40b0-a9d2-c7a2e55c2f94" providerId="ADAL" clId="{67A63A88-7D7A-7647-9E34-31F962E7FC9C}" dt="2023-12-19T01:51:34.701" v="2004" actId="478"/>
          <ac:spMkLst>
            <pc:docMk/>
            <pc:sldMk cId="3797446527" sldId="270"/>
            <ac:spMk id="17" creationId="{3BC412CD-7ABF-0D13-8E3A-A47748A8FA4D}"/>
          </ac:spMkLst>
        </pc:spChg>
        <pc:spChg chg="topLvl">
          <ac:chgData name="Laura Ochoa" userId="59124860-347a-40b0-a9d2-c7a2e55c2f94" providerId="ADAL" clId="{67A63A88-7D7A-7647-9E34-31F962E7FC9C}" dt="2023-12-19T01:51:59.133" v="2006" actId="165"/>
          <ac:spMkLst>
            <pc:docMk/>
            <pc:sldMk cId="3797446527" sldId="270"/>
            <ac:spMk id="34" creationId="{7917C2E4-0DEB-4F4A-ED6C-FA4C9CC70967}"/>
          </ac:spMkLst>
        </pc:spChg>
        <pc:grpChg chg="add del mod">
          <ac:chgData name="Laura Ochoa" userId="59124860-347a-40b0-a9d2-c7a2e55c2f94" providerId="ADAL" clId="{67A63A88-7D7A-7647-9E34-31F962E7FC9C}" dt="2023-12-19T01:52:24.567" v="2010" actId="21"/>
          <ac:grpSpMkLst>
            <pc:docMk/>
            <pc:sldMk cId="3797446527" sldId="270"/>
            <ac:grpSpMk id="3" creationId="{E528A44F-5E05-1E37-7DB5-5A37B4AAB0AA}"/>
          </ac:grpSpMkLst>
        </pc:grpChg>
        <pc:grpChg chg="del">
          <ac:chgData name="Laura Ochoa" userId="59124860-347a-40b0-a9d2-c7a2e55c2f94" providerId="ADAL" clId="{67A63A88-7D7A-7647-9E34-31F962E7FC9C}" dt="2023-12-19T01:51:32.695" v="2002" actId="478"/>
          <ac:grpSpMkLst>
            <pc:docMk/>
            <pc:sldMk cId="3797446527" sldId="270"/>
            <ac:grpSpMk id="16" creationId="{B7479125-A159-5368-44C0-5C9CD14DF77B}"/>
          </ac:grpSpMkLst>
        </pc:grpChg>
        <pc:grpChg chg="del">
          <ac:chgData name="Laura Ochoa" userId="59124860-347a-40b0-a9d2-c7a2e55c2f94" providerId="ADAL" clId="{67A63A88-7D7A-7647-9E34-31F962E7FC9C}" dt="2023-12-19T01:51:33.376" v="2003" actId="478"/>
          <ac:grpSpMkLst>
            <pc:docMk/>
            <pc:sldMk cId="3797446527" sldId="270"/>
            <ac:grpSpMk id="25" creationId="{5AA7F7F1-E644-9691-E94D-1FADCFBE60F1}"/>
          </ac:grpSpMkLst>
        </pc:grpChg>
        <pc:grpChg chg="del">
          <ac:chgData name="Laura Ochoa" userId="59124860-347a-40b0-a9d2-c7a2e55c2f94" providerId="ADAL" clId="{67A63A88-7D7A-7647-9E34-31F962E7FC9C}" dt="2023-12-19T01:51:59.133" v="2006" actId="165"/>
          <ac:grpSpMkLst>
            <pc:docMk/>
            <pc:sldMk cId="3797446527" sldId="270"/>
            <ac:grpSpMk id="31" creationId="{630E7D5F-F89F-B8DE-6413-E418E9B68B31}"/>
          </ac:grpSpMkLst>
        </pc:grpChg>
        <pc:grpChg chg="topLvl">
          <ac:chgData name="Laura Ochoa" userId="59124860-347a-40b0-a9d2-c7a2e55c2f94" providerId="ADAL" clId="{67A63A88-7D7A-7647-9E34-31F962E7FC9C}" dt="2023-12-19T01:51:59.133" v="2006" actId="165"/>
          <ac:grpSpMkLst>
            <pc:docMk/>
            <pc:sldMk cId="3797446527" sldId="270"/>
            <ac:grpSpMk id="38" creationId="{80C16FDB-AA97-54A1-EB6B-D029515AC5FA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4AE441-F27F-BF47-A095-FEA2E68FD07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028134-978A-C749-BBDB-4BB941A6D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39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028134-978A-C749-BBDB-4BB941A6D3F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033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3449C-9AF8-A6E7-A7C0-719CC94037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674F35-CCB1-42BD-8E13-8D45FAB9D3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CFF120-9178-4E03-17D3-D462A85DC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17F561-DDAD-BD08-354C-4D7DB6B84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1EA0D-E481-D917-F20B-E14324F36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871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CAD0D-6E73-B568-2144-7E6FB9367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23DF81-10F0-F611-1F61-41446A268D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1C06A5-6FDE-70F6-B708-C5DF16502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83BBF0-C90A-9E36-1626-B7D80842F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52D86-05C1-E1D2-878A-6B57187C6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122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D2F914-E223-565F-406B-AB1E91A352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82E13B-CA01-07A3-5FA5-CD26A64ABC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D08060-8C02-88B3-B91B-3A5D978A1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78EF7-0937-6A2C-4F9A-7593FAE78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08C7B-BAE5-7EFA-8177-CEA0EA963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18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54D2AA-4D3A-BA38-4446-EC577731C3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C75908-5085-1FAF-F27F-811D593C00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44416-1013-B6C5-F92B-8D99E0084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954635-A17A-D646-FDB0-D92F1EC1E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4B0EB-0C3E-5C8B-7B22-F2024E7F6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679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748C59-EC39-2186-8409-5EB718656E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E22C63-749F-FC91-8A8A-35639C007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61B313-757D-0296-48EA-99DCB02E3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F3947-8137-6286-514E-EA424E35D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A69F09-DB2D-E857-FEE9-30403E533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432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5CDCEA-9EF8-F7FE-A215-1793D2C73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936B88-E90B-2455-8F66-D5693496ED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97E1F8-4F33-E108-15D4-FA39110EAB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FBC3B0-51C7-0EB5-3E24-B28ED2C44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5EC751-9400-FA4D-F33F-850039BE2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F54847-BFBA-A1EF-4642-EA695C0A2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538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041D9-344E-1DDC-F963-0C65809A9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B46AE0-9D69-4C80-21E4-415B50225B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E2A9DE-BB28-2449-B555-26774552F7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02417E-0913-9072-3B60-13B50F26C4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A33062-CF8B-1D80-9E41-69DF016334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1D3717-FA51-9B5B-913C-DF31A79FA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9DFCBA-A0D3-5A0D-B2AE-1F46D2812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EF8853-140A-A6CA-5367-06D6CC824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576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320DA-2A56-4508-02B7-F9A2D3692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666F87-D3B3-CA93-2DC3-86B6B68CC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D5C695-7896-28DE-51BD-6D853C412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7CA231-3F58-DAEA-B17A-9782A3630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154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39BD35F-3228-9F32-A216-E41476D13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B0910F-2D8F-CEBC-7C16-B3CA7C9DB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B858F4-EC6C-012B-7452-43B43DEB3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910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88735-BF2B-B7F8-CF26-A17B6C29F8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19ECEB-46B6-C8BE-B32D-72AB6317A6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FB54EB-2B35-1FF2-361D-3480625342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423F5B-07BB-E86D-09B9-65E876D32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741EF4-EC23-09DC-5D7B-CDB551A98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B02A16-8AA2-A2AA-CDCD-E2FD59D67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58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33EEC-5335-081B-6877-5AE582E5B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8FF2B9-71C5-A222-3551-85FABAC1E1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8383F1-E8D3-51B8-CB2D-602D493B27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169671-8FD3-1F17-1333-E2F2C4B896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09FD05-38C0-5A7D-D9B0-B6CB9C7E0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5A238-25F9-6069-CBFD-36FCC33A9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83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F02EED-B63A-56AC-9009-30A413E3A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279C78-C43D-8449-1F4A-CBCC642E06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C945F0-2636-34F8-FF1B-9F388DADF3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C6BBA-2D31-934D-A837-91B40DCBC25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9F6EEB-D2C6-F93A-1CA4-0056333450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D49813-4C2B-5FAF-968D-5A91851903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E7CC1-3607-2046-AB7F-FDEE330CB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386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735267-8638-C76B-C22C-D2BD9C2638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BE136D85-C2A0-9855-36C9-E3354BFEC103}"/>
              </a:ext>
            </a:extLst>
          </p:cNvPr>
          <p:cNvGrpSpPr/>
          <p:nvPr/>
        </p:nvGrpSpPr>
        <p:grpSpPr>
          <a:xfrm>
            <a:off x="2044758" y="294138"/>
            <a:ext cx="7723702" cy="6244766"/>
            <a:chOff x="2044758" y="294138"/>
            <a:chExt cx="7723702" cy="624476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25361A5-B4DD-DBE6-FA4A-677CE41215B8}"/>
                </a:ext>
              </a:extLst>
            </p:cNvPr>
            <p:cNvSpPr txBox="1"/>
            <p:nvPr/>
          </p:nvSpPr>
          <p:spPr>
            <a:xfrm>
              <a:off x="2303689" y="294138"/>
              <a:ext cx="7464771" cy="307777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400" i="1">
                  <a:latin typeface="Arial"/>
                  <a:cs typeface="Arial"/>
                </a:rPr>
                <a:t>                D. melanogaster                                              D. </a:t>
              </a:r>
              <a:r>
                <a:rPr lang="en-US" sz="1400" i="1" err="1">
                  <a:latin typeface="Arial"/>
                  <a:cs typeface="Arial"/>
                </a:rPr>
                <a:t>simulans</a:t>
              </a:r>
              <a:endParaRPr lang="en-US" sz="1400" i="1">
                <a:latin typeface="Arial"/>
                <a:cs typeface="Arial"/>
              </a:endParaRP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B7479125-A159-5368-44C0-5C9CD14DF77B}"/>
                </a:ext>
              </a:extLst>
            </p:cNvPr>
            <p:cNvGrpSpPr/>
            <p:nvPr/>
          </p:nvGrpSpPr>
          <p:grpSpPr>
            <a:xfrm>
              <a:off x="2044758" y="598538"/>
              <a:ext cx="3478550" cy="4725807"/>
              <a:chOff x="2035012" y="653360"/>
              <a:chExt cx="3478550" cy="4725807"/>
            </a:xfrm>
          </p:grpSpPr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3A62EA54-80D8-1943-6D41-7F3020AF652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304987" y="796187"/>
                <a:ext cx="3208575" cy="4562850"/>
                <a:chOff x="1207940" y="626236"/>
                <a:chExt cx="4111198" cy="5846458"/>
              </a:xfrm>
            </p:grpSpPr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EC837DC9-158C-861D-0587-B6B976CBB516}"/>
                    </a:ext>
                  </a:extLst>
                </p:cNvPr>
                <p:cNvGrpSpPr/>
                <p:nvPr/>
              </p:nvGrpSpPr>
              <p:grpSpPr>
                <a:xfrm>
                  <a:off x="1207940" y="626236"/>
                  <a:ext cx="4111198" cy="5846458"/>
                  <a:chOff x="1207940" y="626236"/>
                  <a:chExt cx="4111198" cy="5846458"/>
                </a:xfrm>
              </p:grpSpPr>
              <p:grpSp>
                <p:nvGrpSpPr>
                  <p:cNvPr id="47" name="Group 46">
                    <a:extLst>
                      <a:ext uri="{FF2B5EF4-FFF2-40B4-BE49-F238E27FC236}">
                        <a16:creationId xmlns:a16="http://schemas.microsoft.com/office/drawing/2014/main" id="{F15C6E8B-AACA-74C4-C82F-7AF9FD5EBF38}"/>
                      </a:ext>
                    </a:extLst>
                  </p:cNvPr>
                  <p:cNvGrpSpPr/>
                  <p:nvPr/>
                </p:nvGrpSpPr>
                <p:grpSpPr>
                  <a:xfrm>
                    <a:off x="1207940" y="626236"/>
                    <a:ext cx="4111198" cy="5846458"/>
                    <a:chOff x="1207940" y="626236"/>
                    <a:chExt cx="4111198" cy="5846458"/>
                  </a:xfrm>
                </p:grpSpPr>
                <p:pic>
                  <p:nvPicPr>
                    <p:cNvPr id="13" name="Picture 12" descr="A screenshot of a computer&#10;&#10;Description automatically generated">
                      <a:extLst>
                        <a:ext uri="{FF2B5EF4-FFF2-40B4-BE49-F238E27FC236}">
                          <a16:creationId xmlns:a16="http://schemas.microsoft.com/office/drawing/2014/main" id="{BEC86A83-28B4-77E5-B552-EFE05C4E0FF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l="1856" t="-8230" r="728" b="31599"/>
                    <a:stretch/>
                  </p:blipFill>
                  <p:spPr>
                    <a:xfrm>
                      <a:off x="1655278" y="5524299"/>
                      <a:ext cx="3589811" cy="8128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6" name="Rectangle 45">
                      <a:extLst>
                        <a:ext uri="{FF2B5EF4-FFF2-40B4-BE49-F238E27FC236}">
                          <a16:creationId xmlns:a16="http://schemas.microsoft.com/office/drawing/2014/main" id="{71538C0B-BD28-D99E-4575-EF5B1DEC5A8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61404" y="6187818"/>
                      <a:ext cx="3557734" cy="28487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grpSp>
                  <p:nvGrpSpPr>
                    <p:cNvPr id="5" name="Group 4">
                      <a:extLst>
                        <a:ext uri="{FF2B5EF4-FFF2-40B4-BE49-F238E27FC236}">
                          <a16:creationId xmlns:a16="http://schemas.microsoft.com/office/drawing/2014/main" id="{3E77AA05-337C-5063-ADA4-D84BCECAF4D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207940" y="626236"/>
                      <a:ext cx="4006478" cy="5555445"/>
                      <a:chOff x="1256383" y="613569"/>
                      <a:chExt cx="4006478" cy="5555445"/>
                    </a:xfrm>
                  </p:grpSpPr>
                  <p:grpSp>
                    <p:nvGrpSpPr>
                      <p:cNvPr id="41" name="Group 40">
                        <a:extLst>
                          <a:ext uri="{FF2B5EF4-FFF2-40B4-BE49-F238E27FC236}">
                            <a16:creationId xmlns:a16="http://schemas.microsoft.com/office/drawing/2014/main" id="{DBD61ECB-2FEC-3F62-E908-04723359312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257775" y="613569"/>
                        <a:ext cx="4005086" cy="5054354"/>
                        <a:chOff x="1253817" y="820397"/>
                        <a:chExt cx="4005086" cy="5054354"/>
                      </a:xfrm>
                    </p:grpSpPr>
                    <p:grpSp>
                      <p:nvGrpSpPr>
                        <p:cNvPr id="2" name="Group 1">
                          <a:extLst>
                            <a:ext uri="{FF2B5EF4-FFF2-40B4-BE49-F238E27FC236}">
                              <a16:creationId xmlns:a16="http://schemas.microsoft.com/office/drawing/2014/main" id="{BD45C205-4531-A630-983C-C2797353DD1D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253817" y="820397"/>
                          <a:ext cx="4005086" cy="4545247"/>
                          <a:chOff x="1253817" y="1116786"/>
                          <a:chExt cx="4005086" cy="4545247"/>
                        </a:xfrm>
                      </p:grpSpPr>
                      <p:grpSp>
                        <p:nvGrpSpPr>
                          <p:cNvPr id="7" name="Group 6">
                            <a:extLst>
                              <a:ext uri="{FF2B5EF4-FFF2-40B4-BE49-F238E27FC236}">
                                <a16:creationId xmlns:a16="http://schemas.microsoft.com/office/drawing/2014/main" id="{1090D307-E7BC-30CD-8EC4-C7C16AEAEB65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253817" y="1116786"/>
                            <a:ext cx="4005086" cy="4545247"/>
                            <a:chOff x="1394539" y="512426"/>
                            <a:chExt cx="3627315" cy="3978748"/>
                          </a:xfrm>
                        </p:grpSpPr>
                        <p:pic>
                          <p:nvPicPr>
                            <p:cNvPr id="9" name="Picture 8" descr="A black dot on a white background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6D7CD361-CF96-A170-8B8A-7F05C3F8272B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54" y="512426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12" name="Picture 11">
                              <a:extLst>
                                <a:ext uri="{FF2B5EF4-FFF2-40B4-BE49-F238E27FC236}">
                                  <a16:creationId xmlns:a16="http://schemas.microsoft.com/office/drawing/2014/main" id="{A1287E4C-02B4-528F-0B86-22A2C955DD59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40" y="949177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15" name="Picture 14" descr="A black and white image of a couple of diamonds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39E7A70A-F929-3FF2-36B0-73F74FF78B96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40" y="1385965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18" name="Picture 17" descr="A group of black and white squares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4A49744E-40D9-E1B9-C5BB-A1DF4BA41ED5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40" y="1819743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21" name="Picture 20" descr="A black and white image of a couple of diamonds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67B864D9-4D3C-CCD9-6EB0-34ABB17294E5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40" y="2264730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24" name="Picture 23" descr="A black circle with a white background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07501995-B9CF-C14E-3CE6-4E637C920EA8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40" y="2712402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27" name="Picture 26" descr="A black circle with a white background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658744B5-D6E8-6E15-F302-8C29B5E7FF6F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39" y="3153963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30" name="Picture 29" descr="A black and white image of a couple of diamonds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191DDD50-5907-A2B9-3F1F-07E789266F75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39" y="3595294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33" name="Picture 32" descr="A black circle with a white background&#10;&#10;Description automatically generated">
                              <a:extLst>
                                <a:ext uri="{FF2B5EF4-FFF2-40B4-BE49-F238E27FC236}">
                                  <a16:creationId xmlns:a16="http://schemas.microsoft.com/office/drawing/2014/main" id="{ACC8C61E-3231-E6D3-3C88-06610B064368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94539" y="4037001"/>
                              <a:ext cx="3627300" cy="454173"/>
                            </a:xfrm>
                            <a:prstGeom prst="rect">
                              <a:avLst/>
                            </a:prstGeom>
                          </p:spPr>
                        </p:pic>
                      </p:grpSp>
                      <p:sp>
                        <p:nvSpPr>
                          <p:cNvPr id="8" name="TextBox 7">
                            <a:extLst>
                              <a:ext uri="{FF2B5EF4-FFF2-40B4-BE49-F238E27FC236}">
                                <a16:creationId xmlns:a16="http://schemas.microsoft.com/office/drawing/2014/main" id="{9DCB5C82-ABCE-4F58-6840-B68006E3CE3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31195" y="1241298"/>
                            <a:ext cx="1075706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Bortezomib</a:t>
                            </a:r>
                          </a:p>
                        </p:txBody>
                      </p:sp>
                      <p:sp>
                        <p:nvSpPr>
                          <p:cNvPr id="20" name="TextBox 19">
                            <a:extLst>
                              <a:ext uri="{FF2B5EF4-FFF2-40B4-BE49-F238E27FC236}">
                                <a16:creationId xmlns:a16="http://schemas.microsoft.com/office/drawing/2014/main" id="{7A9B7C27-05D1-3E5A-DD52-946D7E74FC2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31192" y="3242729"/>
                            <a:ext cx="1139841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Nicardipine</a:t>
                            </a:r>
                          </a:p>
                        </p:txBody>
                      </p:sp>
                      <p:sp>
                        <p:nvSpPr>
                          <p:cNvPr id="23" name="TextBox 22">
                            <a:extLst>
                              <a:ext uri="{FF2B5EF4-FFF2-40B4-BE49-F238E27FC236}">
                                <a16:creationId xmlns:a16="http://schemas.microsoft.com/office/drawing/2014/main" id="{E22EF6C9-7205-7292-7EC8-ADCB26C3DC9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25008" y="3763703"/>
                            <a:ext cx="1000387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M-3MFBS</a:t>
                            </a:r>
                          </a:p>
                        </p:txBody>
                      </p:sp>
                      <p:sp>
                        <p:nvSpPr>
                          <p:cNvPr id="26" name="TextBox 25">
                            <a:extLst>
                              <a:ext uri="{FF2B5EF4-FFF2-40B4-BE49-F238E27FC236}">
                                <a16:creationId xmlns:a16="http://schemas.microsoft.com/office/drawing/2014/main" id="{8BBC649C-C1E0-48D7-DD67-969621D7386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25008" y="4266372"/>
                            <a:ext cx="948794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SC76741</a:t>
                            </a:r>
                          </a:p>
                        </p:txBody>
                      </p:sp>
                      <p:sp>
                        <p:nvSpPr>
                          <p:cNvPr id="29" name="TextBox 28">
                            <a:extLst>
                              <a:ext uri="{FF2B5EF4-FFF2-40B4-BE49-F238E27FC236}">
                                <a16:creationId xmlns:a16="http://schemas.microsoft.com/office/drawing/2014/main" id="{11BB7C8A-598B-22A8-6574-FD6F5D09652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20304" y="4771434"/>
                            <a:ext cx="953498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CAY10512</a:t>
                            </a:r>
                          </a:p>
                        </p:txBody>
                      </p:sp>
                      <p:sp>
                        <p:nvSpPr>
                          <p:cNvPr id="32" name="TextBox 31">
                            <a:extLst>
                              <a:ext uri="{FF2B5EF4-FFF2-40B4-BE49-F238E27FC236}">
                                <a16:creationId xmlns:a16="http://schemas.microsoft.com/office/drawing/2014/main" id="{0BAB6074-433B-CE6B-7E2A-469D9CAB78A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20304" y="5274064"/>
                            <a:ext cx="998159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 err="1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Roscovitine</a:t>
                            </a:r>
                          </a:p>
                        </p:txBody>
                      </p:sp>
                      <p:sp>
                        <p:nvSpPr>
                          <p:cNvPr id="35" name="TextBox 34">
                            <a:extLst>
                              <a:ext uri="{FF2B5EF4-FFF2-40B4-BE49-F238E27FC236}">
                                <a16:creationId xmlns:a16="http://schemas.microsoft.com/office/drawing/2014/main" id="{964C837B-8FE6-A2D7-91B9-65FB2605C10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31193" y="1745467"/>
                            <a:ext cx="1075706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WR-1</a:t>
                            </a:r>
                          </a:p>
                        </p:txBody>
                      </p:sp>
                      <p:sp>
                        <p:nvSpPr>
                          <p:cNvPr id="36" name="TextBox 35">
                            <a:extLst>
                              <a:ext uri="{FF2B5EF4-FFF2-40B4-BE49-F238E27FC236}">
                                <a16:creationId xmlns:a16="http://schemas.microsoft.com/office/drawing/2014/main" id="{A522DE97-5567-7424-2F82-F2E2412E524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31193" y="2237209"/>
                            <a:ext cx="1075706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L-NAME</a:t>
                            </a:r>
                          </a:p>
                        </p:txBody>
                      </p:sp>
                      <p:sp>
                        <p:nvSpPr>
                          <p:cNvPr id="37" name="TextBox 36">
                            <a:extLst>
                              <a:ext uri="{FF2B5EF4-FFF2-40B4-BE49-F238E27FC236}">
                                <a16:creationId xmlns:a16="http://schemas.microsoft.com/office/drawing/2014/main" id="{91E2505B-FE47-C87D-D7AA-968BBE11D18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31192" y="2741970"/>
                            <a:ext cx="1075706" cy="2760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Erlotinib</a:t>
                            </a:r>
                          </a:p>
                        </p:txBody>
                      </p:sp>
                    </p:grpSp>
                    <p:pic>
                      <p:nvPicPr>
                        <p:cNvPr id="39" name="Picture 38" descr="A white rectangular object with black border&#10;&#10;Description automatically generated">
                          <a:extLst>
                            <a:ext uri="{FF2B5EF4-FFF2-40B4-BE49-F238E27FC236}">
                              <a16:creationId xmlns:a16="http://schemas.microsoft.com/office/drawing/2014/main" id="{74DAEC7D-0FB6-8DCB-FBC6-E7E74359030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253818" y="5355912"/>
                          <a:ext cx="4005072" cy="51883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40" name="TextBox 39">
                          <a:extLst>
                            <a:ext uri="{FF2B5EF4-FFF2-40B4-BE49-F238E27FC236}">
                              <a16:creationId xmlns:a16="http://schemas.microsoft.com/office/drawing/2014/main" id="{23B5C67A-8349-EF33-51C2-2CB56E3EA6A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320303" y="5485245"/>
                          <a:ext cx="998159" cy="27605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800"/>
                            <a:t>Rapamycin </a:t>
                          </a:r>
                        </a:p>
                      </p:txBody>
                    </p:sp>
                  </p:grpSp>
                  <p:pic>
                    <p:nvPicPr>
                      <p:cNvPr id="44" name="Picture 43" descr="A black and grey diamond shapes&#10;&#10;Description automatically generated">
                        <a:extLst>
                          <a:ext uri="{FF2B5EF4-FFF2-40B4-BE49-F238E27FC236}">
                            <a16:creationId xmlns:a16="http://schemas.microsoft.com/office/drawing/2014/main" id="{1918DC2A-0241-50AA-7D33-5F8AAF133E4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256383" y="5650175"/>
                        <a:ext cx="4005072" cy="51883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B55720EB-586E-A7D8-34E6-77B955A9779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35151" y="5783708"/>
                        <a:ext cx="1075707" cy="2760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/>
                          <a:t>Staurosporine</a:t>
                        </a:r>
                      </a:p>
                    </p:txBody>
                  </p:sp>
                </p:grpSp>
              </p:grp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C74D277D-12EF-3870-0FEF-F4A9C632A23D}"/>
                      </a:ext>
                    </a:extLst>
                  </p:cNvPr>
                  <p:cNvSpPr txBox="1"/>
                  <p:nvPr/>
                </p:nvSpPr>
                <p:spPr>
                  <a:xfrm>
                    <a:off x="1318784" y="6175494"/>
                    <a:ext cx="3926305" cy="2760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/>
                      <a:t>Flies dead:               0        2         4        6        8       10      12</a:t>
                    </a:r>
                  </a:p>
                </p:txBody>
              </p:sp>
            </p:grpSp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A8AACA05-F9F5-DF93-6DE8-A454BF9F6CC5}"/>
                    </a:ext>
                  </a:extLst>
                </p:cNvPr>
                <p:cNvSpPr/>
                <p:nvPr/>
              </p:nvSpPr>
              <p:spPr>
                <a:xfrm>
                  <a:off x="5219149" y="5609138"/>
                  <a:ext cx="88980" cy="71188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2D4A3562-01A6-6BC3-79AE-7F65DEDA1E6D}"/>
                  </a:ext>
                </a:extLst>
              </p:cNvPr>
              <p:cNvSpPr/>
              <p:nvPr/>
            </p:nvSpPr>
            <p:spPr>
              <a:xfrm>
                <a:off x="2057460" y="657289"/>
                <a:ext cx="3421174" cy="4721878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9455551-420B-5F27-03A7-08A42D48CE44}"/>
                  </a:ext>
                </a:extLst>
              </p:cNvPr>
              <p:cNvSpPr txBox="1"/>
              <p:nvPr/>
            </p:nvSpPr>
            <p:spPr>
              <a:xfrm>
                <a:off x="2035012" y="653360"/>
                <a:ext cx="294341" cy="3050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/>
                  <a:t>A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0719C164-4CC7-DC96-7089-E00769B7BC2D}"/>
                </a:ext>
              </a:extLst>
            </p:cNvPr>
            <p:cNvGrpSpPr/>
            <p:nvPr/>
          </p:nvGrpSpPr>
          <p:grpSpPr>
            <a:xfrm>
              <a:off x="5611082" y="604805"/>
              <a:ext cx="3449640" cy="2745012"/>
              <a:chOff x="5908875" y="762461"/>
              <a:chExt cx="3449640" cy="2745012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5AA7F7F1-E644-9691-E94D-1FADCFBE60F1}"/>
                  </a:ext>
                </a:extLst>
              </p:cNvPr>
              <p:cNvGrpSpPr/>
              <p:nvPr/>
            </p:nvGrpSpPr>
            <p:grpSpPr>
              <a:xfrm>
                <a:off x="5908875" y="770242"/>
                <a:ext cx="3449640" cy="2715349"/>
                <a:chOff x="5908875" y="770242"/>
                <a:chExt cx="3449640" cy="2715349"/>
              </a:xfrm>
            </p:grpSpPr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B9F3A558-3284-190E-4EEB-A841BEE02096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6158115" y="896098"/>
                  <a:ext cx="3200400" cy="2589493"/>
                  <a:chOff x="6890008" y="659320"/>
                  <a:chExt cx="4101572" cy="3318644"/>
                </a:xfrm>
              </p:grpSpPr>
              <p:grpSp>
                <p:nvGrpSpPr>
                  <p:cNvPr id="77" name="Group 76">
                    <a:extLst>
                      <a:ext uri="{FF2B5EF4-FFF2-40B4-BE49-F238E27FC236}">
                        <a16:creationId xmlns:a16="http://schemas.microsoft.com/office/drawing/2014/main" id="{37E32308-6ED8-2AE9-212A-295B5CCE8639}"/>
                      </a:ext>
                    </a:extLst>
                  </p:cNvPr>
                  <p:cNvGrpSpPr/>
                  <p:nvPr/>
                </p:nvGrpSpPr>
                <p:grpSpPr>
                  <a:xfrm>
                    <a:off x="6890008" y="659320"/>
                    <a:ext cx="4006874" cy="3000731"/>
                    <a:chOff x="6890008" y="659320"/>
                    <a:chExt cx="4006874" cy="3000731"/>
                  </a:xfrm>
                </p:grpSpPr>
                <p:grpSp>
                  <p:nvGrpSpPr>
                    <p:cNvPr id="81" name="Group 80">
                      <a:extLst>
                        <a:ext uri="{FF2B5EF4-FFF2-40B4-BE49-F238E27FC236}">
                          <a16:creationId xmlns:a16="http://schemas.microsoft.com/office/drawing/2014/main" id="{C97BAC72-D90C-F9CE-6C35-4B7C9299028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90008" y="659320"/>
                      <a:ext cx="4006874" cy="2487554"/>
                      <a:chOff x="3396518" y="1385045"/>
                      <a:chExt cx="4006874" cy="2487554"/>
                    </a:xfrm>
                  </p:grpSpPr>
                  <p:pic>
                    <p:nvPicPr>
                      <p:cNvPr id="84" name="Picture 83" descr="A number on a white background&#10;&#10;Description automatically generated">
                        <a:extLst>
                          <a:ext uri="{FF2B5EF4-FFF2-40B4-BE49-F238E27FC236}">
                            <a16:creationId xmlns:a16="http://schemas.microsoft.com/office/drawing/2014/main" id="{385F3CD4-185D-5EB0-2298-CFBC88D520E1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396519" y="1385045"/>
                        <a:ext cx="4006873" cy="51907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5" name="TextBox 84">
                        <a:extLst>
                          <a:ext uri="{FF2B5EF4-FFF2-40B4-BE49-F238E27FC236}">
                            <a16:creationId xmlns:a16="http://schemas.microsoft.com/office/drawing/2014/main" id="{31C062C1-7387-9736-275D-CC9E1C6FAA7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59050" y="1513148"/>
                        <a:ext cx="1075705" cy="276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ortezomib</a:t>
                        </a:r>
                      </a:p>
                    </p:txBody>
                  </p:sp>
                  <p:pic>
                    <p:nvPicPr>
                      <p:cNvPr id="86" name="Picture 85" descr="A black and white image of a shoe&#10;&#10;Description automatically generated">
                        <a:extLst>
                          <a:ext uri="{FF2B5EF4-FFF2-40B4-BE49-F238E27FC236}">
                            <a16:creationId xmlns:a16="http://schemas.microsoft.com/office/drawing/2014/main" id="{8074F386-72AB-42FF-D8B8-3BBA903FFC1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396518" y="1890817"/>
                        <a:ext cx="4006873" cy="51907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7" name="TextBox 86">
                        <a:extLst>
                          <a:ext uri="{FF2B5EF4-FFF2-40B4-BE49-F238E27FC236}">
                            <a16:creationId xmlns:a16="http://schemas.microsoft.com/office/drawing/2014/main" id="{2C66B28D-B5AA-9762-F6F4-A16A4D39483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54096" y="2022433"/>
                        <a:ext cx="1075705" cy="276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WR-1</a:t>
                        </a:r>
                      </a:p>
                    </p:txBody>
                  </p:sp>
                  <p:pic>
                    <p:nvPicPr>
                      <p:cNvPr id="88" name="Picture 87" descr="A number on a white background&#10;&#10;Description automatically generated">
                        <a:extLst>
                          <a:ext uri="{FF2B5EF4-FFF2-40B4-BE49-F238E27FC236}">
                            <a16:creationId xmlns:a16="http://schemas.microsoft.com/office/drawing/2014/main" id="{DA2553D4-BBBD-5441-D8DD-CACC4F4F94B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396518" y="2397846"/>
                        <a:ext cx="4006873" cy="51907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9" name="TextBox 88">
                        <a:extLst>
                          <a:ext uri="{FF2B5EF4-FFF2-40B4-BE49-F238E27FC236}">
                            <a16:creationId xmlns:a16="http://schemas.microsoft.com/office/drawing/2014/main" id="{DFBE3EFF-3513-D8C3-DD07-38B72199981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68312" y="2527243"/>
                        <a:ext cx="1075705" cy="276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rlotinib</a:t>
                        </a:r>
                      </a:p>
                    </p:txBody>
                  </p:sp>
                  <p:pic>
                    <p:nvPicPr>
                      <p:cNvPr id="90" name="Picture 89" descr="A number on a white background&#10;&#10;Description automatically generated">
                        <a:extLst>
                          <a:ext uri="{FF2B5EF4-FFF2-40B4-BE49-F238E27FC236}">
                            <a16:creationId xmlns:a16="http://schemas.microsoft.com/office/drawing/2014/main" id="{6FEA68BC-FCC2-0DBF-B8B1-8456048631E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396518" y="2902014"/>
                        <a:ext cx="4005072" cy="51883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01" name="TextBox 100">
                        <a:extLst>
                          <a:ext uri="{FF2B5EF4-FFF2-40B4-BE49-F238E27FC236}">
                            <a16:creationId xmlns:a16="http://schemas.microsoft.com/office/drawing/2014/main" id="{D19977D6-CF0C-A695-44E3-4FAFCE56CE3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68312" y="3004535"/>
                        <a:ext cx="1139841" cy="276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icardipine</a:t>
                        </a:r>
                      </a:p>
                    </p:txBody>
                  </p:sp>
                  <p:pic>
                    <p:nvPicPr>
                      <p:cNvPr id="102" name="Picture 101" descr="A number on a white background&#10;&#10;Description automatically generated">
                        <a:extLst>
                          <a:ext uri="{FF2B5EF4-FFF2-40B4-BE49-F238E27FC236}">
                            <a16:creationId xmlns:a16="http://schemas.microsoft.com/office/drawing/2014/main" id="{1577E202-10CF-9F5B-41CE-8741101D458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396518" y="3353760"/>
                        <a:ext cx="4005072" cy="51883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03" name="TextBox 102">
                        <a:extLst>
                          <a:ext uri="{FF2B5EF4-FFF2-40B4-BE49-F238E27FC236}">
                            <a16:creationId xmlns:a16="http://schemas.microsoft.com/office/drawing/2014/main" id="{DFD71DBE-9CDE-59A9-3D1C-3E2A38C1A34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68312" y="3484791"/>
                        <a:ext cx="953498" cy="2761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AY10512</a:t>
                        </a:r>
                      </a:p>
                    </p:txBody>
                  </p:sp>
                </p:grpSp>
                <p:pic>
                  <p:nvPicPr>
                    <p:cNvPr id="82" name="Picture 81" descr="A white rectangular object with black border&#10;&#10;Description automatically generated">
                      <a:extLst>
                        <a:ext uri="{FF2B5EF4-FFF2-40B4-BE49-F238E27FC236}">
                          <a16:creationId xmlns:a16="http://schemas.microsoft.com/office/drawing/2014/main" id="{884D5405-6032-88CC-36FD-5F5D4911890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6890503" y="3141212"/>
                      <a:ext cx="4005072" cy="51883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83" name="TextBox 82">
                      <a:extLst>
                        <a:ext uri="{FF2B5EF4-FFF2-40B4-BE49-F238E27FC236}">
                          <a16:creationId xmlns:a16="http://schemas.microsoft.com/office/drawing/2014/main" id="{3E0636C2-260C-033E-9924-2741F8EEFB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61802" y="3272243"/>
                      <a:ext cx="953498" cy="2761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amycin</a:t>
                      </a:r>
                    </a:p>
                  </p:txBody>
                </p:sp>
              </p:grpSp>
              <p:sp>
                <p:nvSpPr>
                  <p:cNvPr id="78" name="Rectangle 77">
                    <a:extLst>
                      <a:ext uri="{FF2B5EF4-FFF2-40B4-BE49-F238E27FC236}">
                        <a16:creationId xmlns:a16="http://schemas.microsoft.com/office/drawing/2014/main" id="{158C262F-1594-FA97-0E04-8E3A3F2CC30D}"/>
                      </a:ext>
                    </a:extLst>
                  </p:cNvPr>
                  <p:cNvSpPr/>
                  <p:nvPr/>
                </p:nvSpPr>
                <p:spPr>
                  <a:xfrm>
                    <a:off x="7338729" y="3693088"/>
                    <a:ext cx="3557734" cy="28487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06BA78B5-305A-5F90-8369-54111EA6C310}"/>
                      </a:ext>
                    </a:extLst>
                  </p:cNvPr>
                  <p:cNvSpPr txBox="1"/>
                  <p:nvPr/>
                </p:nvSpPr>
                <p:spPr>
                  <a:xfrm>
                    <a:off x="7012745" y="3665932"/>
                    <a:ext cx="3926306" cy="2761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/>
                      <a:t>Flies dead:               0        2         4        6        8       10      12</a:t>
                    </a:r>
                  </a:p>
                </p:txBody>
              </p:sp>
              <p:sp>
                <p:nvSpPr>
                  <p:cNvPr id="80" name="Rectangle 79">
                    <a:extLst>
                      <a:ext uri="{FF2B5EF4-FFF2-40B4-BE49-F238E27FC236}">
                        <a16:creationId xmlns:a16="http://schemas.microsoft.com/office/drawing/2014/main" id="{A4837E06-AF60-B213-90EF-17CA93594A84}"/>
                      </a:ext>
                    </a:extLst>
                  </p:cNvPr>
                  <p:cNvSpPr/>
                  <p:nvPr/>
                </p:nvSpPr>
                <p:spPr>
                  <a:xfrm>
                    <a:off x="10902600" y="3114408"/>
                    <a:ext cx="88980" cy="71188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120DA94E-AAFC-2BF9-8CFC-F95C39DC04E2}"/>
                    </a:ext>
                  </a:extLst>
                </p:cNvPr>
                <p:cNvSpPr txBox="1"/>
                <p:nvPr/>
              </p:nvSpPr>
              <p:spPr>
                <a:xfrm>
                  <a:off x="5908875" y="770242"/>
                  <a:ext cx="302322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400"/>
                    <a:t>B</a:t>
                  </a:r>
                  <a:endParaRPr lang="en-US" sz="1800"/>
                </a:p>
              </p:txBody>
            </p:sp>
          </p:grp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BC412CD-7ABF-0D13-8E3A-A47748A8FA4D}"/>
                  </a:ext>
                </a:extLst>
              </p:cNvPr>
              <p:cNvSpPr/>
              <p:nvPr/>
            </p:nvSpPr>
            <p:spPr>
              <a:xfrm>
                <a:off x="5918114" y="762461"/>
                <a:ext cx="3412415" cy="274501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BB2F568D-37F5-D9A0-B872-214AC7E78E90}"/>
                </a:ext>
              </a:extLst>
            </p:cNvPr>
            <p:cNvGrpSpPr/>
            <p:nvPr/>
          </p:nvGrpSpPr>
          <p:grpSpPr>
            <a:xfrm>
              <a:off x="5562515" y="3822385"/>
              <a:ext cx="4059720" cy="788804"/>
              <a:chOff x="6216575" y="4296538"/>
              <a:chExt cx="4059720" cy="788804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83F2ED8-82B2-813F-69C4-D0A55F31DD88}"/>
                  </a:ext>
                </a:extLst>
              </p:cNvPr>
              <p:cNvSpPr txBox="1"/>
              <p:nvPr/>
            </p:nvSpPr>
            <p:spPr>
              <a:xfrm>
                <a:off x="6965290" y="4341091"/>
                <a:ext cx="3284502" cy="326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2140"/>
                  </a:lnSpc>
                </a:pPr>
                <a:r>
                  <a:rPr lang="en-US" sz="900">
                    <a:latin typeface="Arial" panose="020B0604020202020204" pitchFamily="34" charset="0"/>
                    <a:cs typeface="Arial" panose="020B0604020202020204" pitchFamily="34" charset="0"/>
                  </a:rPr>
                  <a:t>DMSO:                    </a:t>
                </a:r>
                <a:r>
                  <a:rPr lang="en-US" sz="900" err="1">
                    <a:latin typeface="Arial" panose="020B0604020202020204" pitchFamily="34" charset="0"/>
                    <a:cs typeface="Arial" panose="020B0604020202020204" pitchFamily="34" charset="0"/>
                  </a:rPr>
                  <a:t>Repl</a:t>
                </a:r>
                <a:r>
                  <a:rPr lang="en-US" sz="900">
                    <a:latin typeface="Arial" panose="020B0604020202020204" pitchFamily="34" charset="0"/>
                    <a:cs typeface="Arial" panose="020B0604020202020204" pitchFamily="34" charset="0"/>
                  </a:rPr>
                  <a:t> 1              </a:t>
                </a:r>
                <a:r>
                  <a:rPr lang="en-US" sz="900" err="1">
                    <a:latin typeface="Arial" panose="020B0604020202020204" pitchFamily="34" charset="0"/>
                    <a:cs typeface="Arial" panose="020B0604020202020204" pitchFamily="34" charset="0"/>
                  </a:rPr>
                  <a:t>Repl</a:t>
                </a:r>
                <a:r>
                  <a:rPr lang="en-US" sz="900">
                    <a:latin typeface="Arial" panose="020B0604020202020204" pitchFamily="34" charset="0"/>
                    <a:cs typeface="Arial" panose="020B0604020202020204" pitchFamily="34" charset="0"/>
                  </a:rPr>
                  <a:t> 2	</a:t>
                </a:r>
              </a:p>
            </p:txBody>
          </p:sp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FACBB051-6085-3013-7B55-7D350CACCA59}"/>
                  </a:ext>
                </a:extLst>
              </p:cNvPr>
              <p:cNvGrpSpPr/>
              <p:nvPr/>
            </p:nvGrpSpPr>
            <p:grpSpPr>
              <a:xfrm>
                <a:off x="6216575" y="4296538"/>
                <a:ext cx="4059720" cy="788804"/>
                <a:chOff x="5469684" y="4647473"/>
                <a:chExt cx="4059720" cy="788804"/>
              </a:xfrm>
            </p:grpSpPr>
            <p:grpSp>
              <p:nvGrpSpPr>
                <p:cNvPr id="62" name="Group 61">
                  <a:extLst>
                    <a:ext uri="{FF2B5EF4-FFF2-40B4-BE49-F238E27FC236}">
                      <a16:creationId xmlns:a16="http://schemas.microsoft.com/office/drawing/2014/main" id="{0684FC0E-41DC-10E3-77A3-6121A1A64BD7}"/>
                    </a:ext>
                  </a:extLst>
                </p:cNvPr>
                <p:cNvGrpSpPr/>
                <p:nvPr/>
              </p:nvGrpSpPr>
              <p:grpSpPr>
                <a:xfrm>
                  <a:off x="5469684" y="4647473"/>
                  <a:ext cx="3234789" cy="788804"/>
                  <a:chOff x="3135739" y="6077932"/>
                  <a:chExt cx="3234789" cy="788804"/>
                </a:xfrm>
              </p:grpSpPr>
              <p:grpSp>
                <p:nvGrpSpPr>
                  <p:cNvPr id="65" name="Group 64">
                    <a:extLst>
                      <a:ext uri="{FF2B5EF4-FFF2-40B4-BE49-F238E27FC236}">
                        <a16:creationId xmlns:a16="http://schemas.microsoft.com/office/drawing/2014/main" id="{F735CA4E-458B-E636-2342-5EDF3ECE9B94}"/>
                      </a:ext>
                    </a:extLst>
                  </p:cNvPr>
                  <p:cNvGrpSpPr/>
                  <p:nvPr/>
                </p:nvGrpSpPr>
                <p:grpSpPr>
                  <a:xfrm>
                    <a:off x="3843752" y="6077932"/>
                    <a:ext cx="2526776" cy="788804"/>
                    <a:chOff x="2207992" y="3416542"/>
                    <a:chExt cx="2526776" cy="788804"/>
                  </a:xfrm>
                </p:grpSpPr>
                <p:sp>
                  <p:nvSpPr>
                    <p:cNvPr id="67" name="Oval 66">
                      <a:extLst>
                        <a:ext uri="{FF2B5EF4-FFF2-40B4-BE49-F238E27FC236}">
                          <a16:creationId xmlns:a16="http://schemas.microsoft.com/office/drawing/2014/main" id="{764ED7F4-556E-9186-C07B-38457713F3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896527" y="3606525"/>
                      <a:ext cx="129069" cy="129070"/>
                    </a:xfrm>
                    <a:prstGeom prst="ellipse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15875"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200"/>
                    </a:p>
                  </p:txBody>
                </p:sp>
                <p:sp>
                  <p:nvSpPr>
                    <p:cNvPr id="68" name="Oval 67">
                      <a:extLst>
                        <a:ext uri="{FF2B5EF4-FFF2-40B4-BE49-F238E27FC236}">
                          <a16:creationId xmlns:a16="http://schemas.microsoft.com/office/drawing/2014/main" id="{031CC5BC-F75F-7DC6-0299-926B2EEA2F6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98759" y="3602386"/>
                      <a:ext cx="129069" cy="129070"/>
                    </a:xfrm>
                    <a:prstGeom prst="ellipse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15875"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200"/>
                    </a:p>
                  </p:txBody>
                </p:sp>
                <p:sp>
                  <p:nvSpPr>
                    <p:cNvPr id="69" name="Diamond 68">
                      <a:extLst>
                        <a:ext uri="{FF2B5EF4-FFF2-40B4-BE49-F238E27FC236}">
                          <a16:creationId xmlns:a16="http://schemas.microsoft.com/office/drawing/2014/main" id="{2516456F-8755-6136-B4FF-2103C20A2B8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94643" y="3849271"/>
                      <a:ext cx="147508" cy="156727"/>
                    </a:xfrm>
                    <a:prstGeom prst="diamond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15875"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200"/>
                    </a:p>
                  </p:txBody>
                </p:sp>
                <p:sp>
                  <p:nvSpPr>
                    <p:cNvPr id="70" name="Diamond 69">
                      <a:extLst>
                        <a:ext uri="{FF2B5EF4-FFF2-40B4-BE49-F238E27FC236}">
                          <a16:creationId xmlns:a16="http://schemas.microsoft.com/office/drawing/2014/main" id="{2775EE9D-49FA-9871-9509-3563502A978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882251" y="3845884"/>
                      <a:ext cx="147508" cy="156727"/>
                    </a:xfrm>
                    <a:prstGeom prst="diamond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15875"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200"/>
                    </a:p>
                  </p:txBody>
                </p: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A942D92E-39B2-369F-2A5E-56E5CAC4DE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07992" y="3416542"/>
                      <a:ext cx="2526776" cy="788804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US" sz="1200"/>
                    </a:p>
                  </p:txBody>
                </p:sp>
              </p:grp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9F2D294A-E570-7388-8394-1CEBA9B3D5BA}"/>
                      </a:ext>
                    </a:extLst>
                  </p:cNvPr>
                  <p:cNvSpPr txBox="1"/>
                  <p:nvPr/>
                </p:nvSpPr>
                <p:spPr>
                  <a:xfrm>
                    <a:off x="3135739" y="6250491"/>
                    <a:ext cx="551754" cy="415498"/>
                  </a:xfrm>
                  <a:prstGeom prst="rect">
                    <a:avLst/>
                  </a:prstGeom>
                  <a:noFill/>
                </p:spPr>
                <p:txBody>
                  <a:bodyPr wrap="none" lIns="91440" tIns="45720" rIns="91440" bIns="45720" rtlCol="0" anchor="t">
                    <a:spAutoFit/>
                  </a:bodyPr>
                  <a:lstStyle/>
                  <a:p>
                    <a:pPr algn="ctr"/>
                    <a:r>
                      <a:rPr lang="en-US" sz="1050">
                        <a:latin typeface="Arial"/>
                        <a:cs typeface="Arial"/>
                      </a:rPr>
                      <a:t>Chart </a:t>
                    </a:r>
                    <a:endParaRPr lang="en-US">
                      <a:latin typeface="Arial"/>
                      <a:cs typeface="Arial"/>
                    </a:endParaRPr>
                  </a:p>
                  <a:p>
                    <a:pPr algn="ctr"/>
                    <a:r>
                      <a:rPr lang="en-US" sz="1050">
                        <a:latin typeface="Arial"/>
                        <a:cs typeface="Arial"/>
                      </a:rPr>
                      <a:t>key</a:t>
                    </a:r>
                    <a:endParaRPr lang="en-US">
                      <a:cs typeface="Arial"/>
                    </a:endParaRPr>
                  </a:p>
                </p:txBody>
              </p:sp>
            </p:grp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C1B55D5A-B55A-9771-D90D-A45B23B90743}"/>
                    </a:ext>
                  </a:extLst>
                </p:cNvPr>
                <p:cNvSpPr txBox="1"/>
                <p:nvPr/>
              </p:nvSpPr>
              <p:spPr>
                <a:xfrm>
                  <a:off x="6200193" y="4956373"/>
                  <a:ext cx="3329211" cy="3293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2140"/>
                    </a:lnSpc>
                  </a:pPr>
                  <a:r>
                    <a:rPr lang="en-US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Treatment:               </a:t>
                  </a:r>
                  <a:r>
                    <a:rPr lang="en-US" sz="90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epl</a:t>
                  </a:r>
                  <a:r>
                    <a:rPr lang="en-US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 1              </a:t>
                  </a:r>
                  <a:r>
                    <a:rPr lang="en-US" sz="90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epl</a:t>
                  </a:r>
                  <a:r>
                    <a:rPr lang="en-US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</a:p>
              </p:txBody>
            </p:sp>
          </p:grp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D25639C-994C-69F5-1E6E-55AE87EFF444}"/>
                </a:ext>
              </a:extLst>
            </p:cNvPr>
            <p:cNvSpPr txBox="1"/>
            <p:nvPr/>
          </p:nvSpPr>
          <p:spPr>
            <a:xfrm>
              <a:off x="2166313" y="5523241"/>
              <a:ext cx="6942688" cy="1015663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r>
                <a:rPr lang="en-US" sz="1200">
                  <a:latin typeface="Arial"/>
                  <a:ea typeface="Times New Roman" panose="02020603050405020304" pitchFamily="18" charset="0"/>
                  <a:cs typeface="Arial"/>
                </a:rPr>
                <a:t>Figure S1. Representative figure showing lethality data at day 12 for “hit” compounds.</a:t>
              </a:r>
              <a:r>
                <a:rPr lang="en-US" sz="1200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  A) Lethality data for </a:t>
              </a:r>
              <a:r>
                <a:rPr lang="en-US" sz="1200" i="1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D. melanogaster </a:t>
              </a:r>
              <a:r>
                <a:rPr lang="en-US" sz="1200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for 11 “hit” compounds.  B) Lethality data for </a:t>
              </a:r>
              <a:r>
                <a:rPr lang="en-US" sz="1200" i="1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D. </a:t>
              </a:r>
              <a:r>
                <a:rPr lang="en-US" sz="1200" i="1" err="1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simulans</a:t>
              </a:r>
              <a:r>
                <a:rPr lang="en-US" sz="1200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 for 6 retested “hit” compounds.</a:t>
              </a:r>
              <a:r>
                <a:rPr lang="en-US" sz="1200" i="1">
                  <a:solidFill>
                    <a:srgbClr val="000000"/>
                  </a:solidFill>
                  <a:latin typeface="Arial"/>
                  <a:ea typeface="Times New Roman" panose="02020603050405020304" pitchFamily="18" charset="0"/>
                  <a:cs typeface="Arial"/>
                </a:rPr>
                <a:t> </a:t>
              </a:r>
              <a:r>
                <a:rPr lang="en-US" sz="1200">
                  <a:latin typeface="Arial"/>
                  <a:ea typeface="+mn-lt"/>
                  <a:cs typeface="+mn-lt"/>
                </a:rPr>
                <a:t>Each panel shows the number of dead flies at day 12 following exposure across two independent replicates. </a:t>
              </a:r>
              <a:r>
                <a:rPr lang="en-US" sz="1200">
                  <a:latin typeface="Arial"/>
                  <a:ea typeface="+mn-lt"/>
                  <a:cs typeface="Arial"/>
                </a:rPr>
                <a:t>Circles: Control groups treated with 1% DMSO vehicle only. Diamonds: Experimental groups at the concentrations as described in the methods. </a:t>
              </a:r>
              <a:endParaRPr lang="en-US" sz="120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1097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BC5BDE-B6C6-4F66-93E0-4EE83F8ED1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710104E2-3FF4-202A-ED36-D7246BD5D190}"/>
              </a:ext>
            </a:extLst>
          </p:cNvPr>
          <p:cNvGrpSpPr/>
          <p:nvPr/>
        </p:nvGrpSpPr>
        <p:grpSpPr>
          <a:xfrm>
            <a:off x="2860948" y="1025426"/>
            <a:ext cx="6054811" cy="4516052"/>
            <a:chOff x="2860948" y="1025426"/>
            <a:chExt cx="6054811" cy="4516052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7A5D05F-AEB4-DC99-2268-DD3EC015FCC0}"/>
                </a:ext>
              </a:extLst>
            </p:cNvPr>
            <p:cNvGrpSpPr/>
            <p:nvPr/>
          </p:nvGrpSpPr>
          <p:grpSpPr>
            <a:xfrm>
              <a:off x="2860948" y="1025426"/>
              <a:ext cx="6054811" cy="4516052"/>
              <a:chOff x="2860948" y="1025426"/>
              <a:chExt cx="6054811" cy="4516052"/>
            </a:xfrm>
          </p:grpSpPr>
          <p:sp>
            <p:nvSpPr>
              <p:cNvPr id="3" name="Text Box 43">
                <a:extLst>
                  <a:ext uri="{FF2B5EF4-FFF2-40B4-BE49-F238E27FC236}">
                    <a16:creationId xmlns:a16="http://schemas.microsoft.com/office/drawing/2014/main" id="{5254275A-054E-318F-51F7-92B30E9E9856}"/>
                  </a:ext>
                </a:extLst>
              </p:cNvPr>
              <p:cNvSpPr txBox="1"/>
              <p:nvPr/>
            </p:nvSpPr>
            <p:spPr>
              <a:xfrm>
                <a:off x="2860948" y="4581756"/>
                <a:ext cx="6054811" cy="959722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>
                    <a:latin typeface="Arial"/>
                    <a:ea typeface="Times New Roman" panose="02020603050405020304" pitchFamily="18" charset="0"/>
                    <a:cs typeface="Arial"/>
                  </a:rPr>
                  <a:t>Figure S2. W</a:t>
                </a:r>
                <a:r>
                  <a:rPr lang="en-US" sz="1200">
                    <a:latin typeface="Arial"/>
                    <a:cs typeface="Arial"/>
                  </a:rPr>
                  <a:t>hole body </a:t>
                </a:r>
                <a:r>
                  <a:rPr lang="en-US" sz="1200" i="1" err="1">
                    <a:latin typeface="Arial"/>
                    <a:cs typeface="Arial"/>
                  </a:rPr>
                  <a:t>wsp</a:t>
                </a:r>
                <a:r>
                  <a:rPr lang="en-US" sz="1200" i="1">
                    <a:latin typeface="Arial"/>
                    <a:cs typeface="Arial"/>
                  </a:rPr>
                  <a:t> </a:t>
                </a:r>
                <a:r>
                  <a:rPr lang="en-US" sz="1200">
                    <a:latin typeface="Arial"/>
                    <a:cs typeface="Arial"/>
                  </a:rPr>
                  <a:t>abundance in </a:t>
                </a:r>
                <a:r>
                  <a:rPr lang="en-US" sz="1200">
                    <a:latin typeface="Arial"/>
                    <a:ea typeface="Times New Roman" panose="02020603050405020304" pitchFamily="18" charset="0"/>
                    <a:cs typeface="Arial"/>
                  </a:rPr>
                  <a:t>control vs. </a:t>
                </a:r>
                <a:r>
                  <a:rPr lang="en-US" sz="1200" i="1">
                    <a:latin typeface="Arial"/>
                    <a:ea typeface="Times New Roman" panose="02020603050405020304" pitchFamily="18" charset="0"/>
                    <a:cs typeface="Arial"/>
                  </a:rPr>
                  <a:t>da-GAL4:UAS-RNAi </a:t>
                </a:r>
                <a:r>
                  <a:rPr lang="en-US" sz="1200">
                    <a:latin typeface="Arial"/>
                    <a:ea typeface="Times New Roman" panose="02020603050405020304" pitchFamily="18" charset="0"/>
                    <a:cs typeface="Arial"/>
                  </a:rPr>
                  <a:t>knockdown flies. </a:t>
                </a:r>
                <a:r>
                  <a:rPr lang="en-US" sz="1200">
                    <a:solidFill>
                      <a:srgbClr val="000000"/>
                    </a:solidFill>
                    <a:latin typeface="Arial"/>
                    <a:ea typeface="Times New Roman" panose="02020603050405020304" pitchFamily="18" charset="0"/>
                    <a:cs typeface="Arial"/>
                  </a:rPr>
                  <a:t>Panels show data from 2 independent biological replicates.  A) Body-wide </a:t>
                </a:r>
                <a:r>
                  <a:rPr lang="en-US" sz="1200" i="1" err="1">
                    <a:solidFill>
                      <a:srgbClr val="000000"/>
                    </a:solidFill>
                    <a:latin typeface="Arial"/>
                    <a:ea typeface="Times New Roman" panose="02020603050405020304" pitchFamily="18" charset="0"/>
                    <a:cs typeface="Arial"/>
                  </a:rPr>
                  <a:t>wsp</a:t>
                </a:r>
                <a:r>
                  <a:rPr lang="en-US" sz="1200" i="1">
                    <a:solidFill>
                      <a:srgbClr val="000000"/>
                    </a:solidFill>
                    <a:latin typeface="Arial"/>
                    <a:ea typeface="Times New Roman" panose="02020603050405020304" pitchFamily="18" charset="0"/>
                    <a:cs typeface="Arial"/>
                  </a:rPr>
                  <a:t> </a:t>
                </a:r>
                <a:r>
                  <a:rPr lang="en-US" sz="1200">
                    <a:solidFill>
                      <a:srgbClr val="000000"/>
                    </a:solidFill>
                    <a:latin typeface="Arial"/>
                    <a:ea typeface="Times New Roman" panose="02020603050405020304" pitchFamily="18" charset="0"/>
                    <a:cs typeface="Arial"/>
                  </a:rPr>
                  <a:t>abundance in flies exposed to carrier DMSO versus Mifepristone solubilized in DMSO.  B) Power analysis, testing the likelihood of significance as a function of sample size in Panel A.  </a:t>
                </a:r>
                <a:r>
                  <a:rPr lang="en-US" sz="1200">
                    <a:latin typeface="Arial"/>
                    <a:ea typeface="Times New Roman" panose="02020603050405020304" pitchFamily="18" charset="0"/>
                    <a:cs typeface="Arial"/>
                  </a:rPr>
                  <a:t>Significance was set at * p &lt; 0.05.</a:t>
                </a:r>
              </a:p>
            </p:txBody>
          </p: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89608B4F-95CD-044E-4750-FDC0FBE03215}"/>
                  </a:ext>
                </a:extLst>
              </p:cNvPr>
              <p:cNvGrpSpPr/>
              <p:nvPr/>
            </p:nvGrpSpPr>
            <p:grpSpPr>
              <a:xfrm>
                <a:off x="5886985" y="1025426"/>
                <a:ext cx="2535353" cy="3127841"/>
                <a:chOff x="4015116" y="1870253"/>
                <a:chExt cx="2535353" cy="3127841"/>
              </a:xfrm>
            </p:grpSpPr>
            <p:sp>
              <p:nvSpPr>
                <p:cNvPr id="94" name="TextBox 3">
                  <a:extLst>
                    <a:ext uri="{FF2B5EF4-FFF2-40B4-BE49-F238E27FC236}">
                      <a16:creationId xmlns:a16="http://schemas.microsoft.com/office/drawing/2014/main" id="{C373EB85-48A5-8476-A071-F2803D4DA8B5}"/>
                    </a:ext>
                  </a:extLst>
                </p:cNvPr>
                <p:cNvSpPr txBox="1"/>
                <p:nvPr/>
              </p:nvSpPr>
              <p:spPr>
                <a:xfrm>
                  <a:off x="4032224" y="1907422"/>
                  <a:ext cx="2450592" cy="3090672"/>
                </a:xfrm>
                <a:prstGeom prst="rect">
                  <a:avLst/>
                </a:prstGeom>
                <a:noFill/>
                <a:ln w="12700" cmpd="sng">
                  <a:solidFill>
                    <a:srgbClr val="000000"/>
                  </a:solidFill>
                </a:ln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endParaRPr lang="en-US"/>
                </a:p>
              </p:txBody>
            </p:sp>
            <p:pic>
              <p:nvPicPr>
                <p:cNvPr id="95" name="Picture 94" descr="Scatter chart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EBA53448-2C79-3442-15F9-12AC5E9B6EE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alphaModFix/>
                </a:blip>
                <a:stretch>
                  <a:fillRect/>
                </a:stretch>
              </p:blipFill>
              <p:spPr>
                <a:xfrm>
                  <a:off x="4556628" y="2127390"/>
                  <a:ext cx="1914341" cy="2267712"/>
                </a:xfrm>
                <a:prstGeom prst="rect">
                  <a:avLst/>
                </a:prstGeom>
              </p:spPr>
            </p:pic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54FABF9C-D61B-F78B-FA98-7FA1AF738314}"/>
                    </a:ext>
                  </a:extLst>
                </p:cNvPr>
                <p:cNvGrpSpPr/>
                <p:nvPr/>
              </p:nvGrpSpPr>
              <p:grpSpPr>
                <a:xfrm>
                  <a:off x="4109610" y="2132927"/>
                  <a:ext cx="551967" cy="2313060"/>
                  <a:chOff x="4109610" y="2132927"/>
                  <a:chExt cx="551967" cy="2313060"/>
                </a:xfrm>
              </p:grpSpPr>
              <p:sp>
                <p:nvSpPr>
                  <p:cNvPr id="112" name="TextBox 18">
                    <a:extLst>
                      <a:ext uri="{FF2B5EF4-FFF2-40B4-BE49-F238E27FC236}">
                        <a16:creationId xmlns:a16="http://schemas.microsoft.com/office/drawing/2014/main" id="{44FAC97F-523E-19BD-879F-AEDCF561ED2A}"/>
                      </a:ext>
                    </a:extLst>
                  </p:cNvPr>
                  <p:cNvSpPr txBox="1"/>
                  <p:nvPr/>
                </p:nvSpPr>
                <p:spPr>
                  <a:xfrm>
                    <a:off x="4356010" y="4199766"/>
                    <a:ext cx="2767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0</a:t>
                    </a:r>
                  </a:p>
                </p:txBody>
              </p:sp>
              <p:sp>
                <p:nvSpPr>
                  <p:cNvPr id="113" name="TextBox 19">
                    <a:extLst>
                      <a:ext uri="{FF2B5EF4-FFF2-40B4-BE49-F238E27FC236}">
                        <a16:creationId xmlns:a16="http://schemas.microsoft.com/office/drawing/2014/main" id="{59D820BC-1581-6A59-4B0A-B44117633BD1}"/>
                      </a:ext>
                    </a:extLst>
                  </p:cNvPr>
                  <p:cNvSpPr txBox="1"/>
                  <p:nvPr/>
                </p:nvSpPr>
                <p:spPr>
                  <a:xfrm>
                    <a:off x="4113061" y="2132927"/>
                    <a:ext cx="544799" cy="2205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015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1.00</a:t>
                    </a:r>
                  </a:p>
                </p:txBody>
              </p:sp>
              <p:sp>
                <p:nvSpPr>
                  <p:cNvPr id="114" name="TextBox 20">
                    <a:extLst>
                      <a:ext uri="{FF2B5EF4-FFF2-40B4-BE49-F238E27FC236}">
                        <a16:creationId xmlns:a16="http://schemas.microsoft.com/office/drawing/2014/main" id="{F4908D36-28A7-1EDC-79A7-C140CD85869F}"/>
                      </a:ext>
                    </a:extLst>
                  </p:cNvPr>
                  <p:cNvSpPr txBox="1"/>
                  <p:nvPr/>
                </p:nvSpPr>
                <p:spPr>
                  <a:xfrm>
                    <a:off x="4109610" y="2648836"/>
                    <a:ext cx="544799" cy="2205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015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0.75</a:t>
                    </a:r>
                  </a:p>
                </p:txBody>
              </p:sp>
              <p:sp>
                <p:nvSpPr>
                  <p:cNvPr id="115" name="TextBox 21">
                    <a:extLst>
                      <a:ext uri="{FF2B5EF4-FFF2-40B4-BE49-F238E27FC236}">
                        <a16:creationId xmlns:a16="http://schemas.microsoft.com/office/drawing/2014/main" id="{04933CE0-7834-228E-7312-40D5413BAC82}"/>
                      </a:ext>
                    </a:extLst>
                  </p:cNvPr>
                  <p:cNvSpPr txBox="1"/>
                  <p:nvPr/>
                </p:nvSpPr>
                <p:spPr>
                  <a:xfrm>
                    <a:off x="4116778" y="3165010"/>
                    <a:ext cx="544799" cy="2205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015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0.50</a:t>
                    </a:r>
                  </a:p>
                </p:txBody>
              </p:sp>
              <p:sp>
                <p:nvSpPr>
                  <p:cNvPr id="116" name="TextBox 22">
                    <a:extLst>
                      <a:ext uri="{FF2B5EF4-FFF2-40B4-BE49-F238E27FC236}">
                        <a16:creationId xmlns:a16="http://schemas.microsoft.com/office/drawing/2014/main" id="{8AE9A655-1CA1-9C73-C0BF-09F6E4A6C94A}"/>
                      </a:ext>
                    </a:extLst>
                  </p:cNvPr>
                  <p:cNvSpPr txBox="1"/>
                  <p:nvPr/>
                </p:nvSpPr>
                <p:spPr>
                  <a:xfrm>
                    <a:off x="4113327" y="3691805"/>
                    <a:ext cx="544799" cy="2205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015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0.25</a:t>
                    </a:r>
                  </a:p>
                </p:txBody>
              </p:sp>
            </p:grpSp>
            <p:sp>
              <p:nvSpPr>
                <p:cNvPr id="97" name="TextBox 6">
                  <a:extLst>
                    <a:ext uri="{FF2B5EF4-FFF2-40B4-BE49-F238E27FC236}">
                      <a16:creationId xmlns:a16="http://schemas.microsoft.com/office/drawing/2014/main" id="{B26044A9-F71E-FE8A-1C66-09665DE9CE44}"/>
                    </a:ext>
                  </a:extLst>
                </p:cNvPr>
                <p:cNvSpPr txBox="1"/>
                <p:nvPr/>
              </p:nvSpPr>
              <p:spPr>
                <a:xfrm>
                  <a:off x="4015116" y="1870253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40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98" name="TextBox 7">
                  <a:extLst>
                    <a:ext uri="{FF2B5EF4-FFF2-40B4-BE49-F238E27FC236}">
                      <a16:creationId xmlns:a16="http://schemas.microsoft.com/office/drawing/2014/main" id="{31743183-E175-2637-8672-09B38A12806B}"/>
                    </a:ext>
                  </a:extLst>
                </p:cNvPr>
                <p:cNvSpPr txBox="1"/>
                <p:nvPr/>
              </p:nvSpPr>
              <p:spPr>
                <a:xfrm>
                  <a:off x="4242655" y="1914973"/>
                  <a:ext cx="22427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10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Whole-body </a:t>
                  </a:r>
                  <a:r>
                    <a:rPr lang="en-US" sz="1100" i="1" err="1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wsp</a:t>
                  </a:r>
                  <a:r>
                    <a:rPr lang="en-US" sz="1100" i="1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: </a:t>
                  </a:r>
                  <a:r>
                    <a:rPr lang="en-US" sz="110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mifepristone</a:t>
                  </a:r>
                </a:p>
              </p:txBody>
            </p:sp>
            <p:sp>
              <p:nvSpPr>
                <p:cNvPr id="99" name="TextBox 8">
                  <a:extLst>
                    <a:ext uri="{FF2B5EF4-FFF2-40B4-BE49-F238E27FC236}">
                      <a16:creationId xmlns:a16="http://schemas.microsoft.com/office/drawing/2014/main" id="{7C36451F-ADE6-3AFD-82D8-143C9AD9CE32}"/>
                    </a:ext>
                  </a:extLst>
                </p:cNvPr>
                <p:cNvSpPr txBox="1"/>
                <p:nvPr/>
              </p:nvSpPr>
              <p:spPr>
                <a:xfrm>
                  <a:off x="4353542" y="4616275"/>
                  <a:ext cx="204279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en-US" sz="1100">
                      <a:latin typeface="Arial"/>
                      <a:ea typeface="Arial" charset="0"/>
                      <a:cs typeface="Arial"/>
                    </a:rPr>
                    <a:t>randomly sub-sampled “n”</a:t>
                  </a:r>
                  <a:endParaRPr lang="en-US" sz="1100" baseline="-25000">
                    <a:latin typeface="Arial"/>
                    <a:ea typeface="Arial" charset="0"/>
                    <a:cs typeface="Arial"/>
                  </a:endParaRPr>
                </a:p>
              </p:txBody>
            </p:sp>
            <p:grpSp>
              <p:nvGrpSpPr>
                <p:cNvPr id="100" name="Group 99">
                  <a:extLst>
                    <a:ext uri="{FF2B5EF4-FFF2-40B4-BE49-F238E27FC236}">
                      <a16:creationId xmlns:a16="http://schemas.microsoft.com/office/drawing/2014/main" id="{C3660A72-57BA-BB5F-5B27-710B2AF5D3A1}"/>
                    </a:ext>
                  </a:extLst>
                </p:cNvPr>
                <p:cNvGrpSpPr/>
                <p:nvPr/>
              </p:nvGrpSpPr>
              <p:grpSpPr>
                <a:xfrm>
                  <a:off x="4458922" y="4297304"/>
                  <a:ext cx="2091547" cy="253655"/>
                  <a:chOff x="4458922" y="4297304"/>
                  <a:chExt cx="2091547" cy="253655"/>
                </a:xfrm>
              </p:grpSpPr>
              <p:sp>
                <p:nvSpPr>
                  <p:cNvPr id="105" name="TextBox 11">
                    <a:extLst>
                      <a:ext uri="{FF2B5EF4-FFF2-40B4-BE49-F238E27FC236}">
                        <a16:creationId xmlns:a16="http://schemas.microsoft.com/office/drawing/2014/main" id="{8B8C34E1-80AA-AE43-FF03-F901CB02E801}"/>
                      </a:ext>
                    </a:extLst>
                  </p:cNvPr>
                  <p:cNvSpPr txBox="1"/>
                  <p:nvPr/>
                </p:nvSpPr>
                <p:spPr>
                  <a:xfrm>
                    <a:off x="4458922" y="4297304"/>
                    <a:ext cx="2767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0</a:t>
                    </a:r>
                  </a:p>
                </p:txBody>
              </p:sp>
              <p:sp>
                <p:nvSpPr>
                  <p:cNvPr id="106" name="TextBox 12">
                    <a:extLst>
                      <a:ext uri="{FF2B5EF4-FFF2-40B4-BE49-F238E27FC236}">
                        <a16:creationId xmlns:a16="http://schemas.microsoft.com/office/drawing/2014/main" id="{E62EFC7F-AE4D-05DC-4B0F-E1DD1A1238A9}"/>
                      </a:ext>
                    </a:extLst>
                  </p:cNvPr>
                  <p:cNvSpPr txBox="1"/>
                  <p:nvPr/>
                </p:nvSpPr>
                <p:spPr>
                  <a:xfrm>
                    <a:off x="5045424" y="4304738"/>
                    <a:ext cx="2767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6</a:t>
                    </a:r>
                  </a:p>
                </p:txBody>
              </p:sp>
              <p:sp>
                <p:nvSpPr>
                  <p:cNvPr id="107" name="TextBox 13">
                    <a:extLst>
                      <a:ext uri="{FF2B5EF4-FFF2-40B4-BE49-F238E27FC236}">
                        <a16:creationId xmlns:a16="http://schemas.microsoft.com/office/drawing/2014/main" id="{E43E3E2C-74B8-8290-90D5-C2C4B7B4B1C5}"/>
                      </a:ext>
                    </a:extLst>
                  </p:cNvPr>
                  <p:cNvSpPr txBox="1"/>
                  <p:nvPr/>
                </p:nvSpPr>
                <p:spPr>
                  <a:xfrm>
                    <a:off x="5543486" y="4301021"/>
                    <a:ext cx="3763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12</a:t>
                    </a:r>
                  </a:p>
                </p:txBody>
              </p:sp>
              <p:sp>
                <p:nvSpPr>
                  <p:cNvPr id="108" name="TextBox 14">
                    <a:extLst>
                      <a:ext uri="{FF2B5EF4-FFF2-40B4-BE49-F238E27FC236}">
                        <a16:creationId xmlns:a16="http://schemas.microsoft.com/office/drawing/2014/main" id="{839BA826-83C9-6364-0F48-297FBCC7A0C6}"/>
                      </a:ext>
                    </a:extLst>
                  </p:cNvPr>
                  <p:cNvSpPr txBox="1"/>
                  <p:nvPr/>
                </p:nvSpPr>
                <p:spPr>
                  <a:xfrm>
                    <a:off x="6174117" y="4297304"/>
                    <a:ext cx="3763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18</a:t>
                    </a:r>
                  </a:p>
                </p:txBody>
              </p:sp>
              <p:sp>
                <p:nvSpPr>
                  <p:cNvPr id="109" name="TextBox 15">
                    <a:extLst>
                      <a:ext uri="{FF2B5EF4-FFF2-40B4-BE49-F238E27FC236}">
                        <a16:creationId xmlns:a16="http://schemas.microsoft.com/office/drawing/2014/main" id="{92438155-4C5D-106A-F69E-BAAEA7DED291}"/>
                      </a:ext>
                    </a:extLst>
                  </p:cNvPr>
                  <p:cNvSpPr txBox="1"/>
                  <p:nvPr/>
                </p:nvSpPr>
                <p:spPr>
                  <a:xfrm>
                    <a:off x="4740624" y="4304738"/>
                    <a:ext cx="2767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3</a:t>
                    </a:r>
                  </a:p>
                </p:txBody>
              </p:sp>
              <p:sp>
                <p:nvSpPr>
                  <p:cNvPr id="110" name="TextBox 16">
                    <a:extLst>
                      <a:ext uri="{FF2B5EF4-FFF2-40B4-BE49-F238E27FC236}">
                        <a16:creationId xmlns:a16="http://schemas.microsoft.com/office/drawing/2014/main" id="{0F268F30-85ED-11FE-AF4B-9D8E0B5EA464}"/>
                      </a:ext>
                    </a:extLst>
                  </p:cNvPr>
                  <p:cNvSpPr txBox="1"/>
                  <p:nvPr/>
                </p:nvSpPr>
                <p:spPr>
                  <a:xfrm>
                    <a:off x="5339338" y="4304738"/>
                    <a:ext cx="2767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9</a:t>
                    </a:r>
                  </a:p>
                </p:txBody>
              </p:sp>
              <p:sp>
                <p:nvSpPr>
                  <p:cNvPr id="111" name="TextBox 17">
                    <a:extLst>
                      <a:ext uri="{FF2B5EF4-FFF2-40B4-BE49-F238E27FC236}">
                        <a16:creationId xmlns:a16="http://schemas.microsoft.com/office/drawing/2014/main" id="{05E366E8-8945-5004-DA25-9F7551FD7AD8}"/>
                      </a:ext>
                    </a:extLst>
                  </p:cNvPr>
                  <p:cNvSpPr txBox="1"/>
                  <p:nvPr/>
                </p:nvSpPr>
                <p:spPr>
                  <a:xfrm>
                    <a:off x="5870057" y="4301021"/>
                    <a:ext cx="3763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>
                      <a:lnSpc>
                        <a:spcPts val="1200"/>
                      </a:lnSpc>
                    </a:pPr>
                    <a:r>
                      <a:rPr lang="en-US" sz="1000">
                        <a:latin typeface="Arial"/>
                        <a:cs typeface="Arial"/>
                      </a:rPr>
                      <a:t>15</a:t>
                    </a:r>
                  </a:p>
                </p:txBody>
              </p:sp>
            </p:grpSp>
            <mc:AlternateContent xmlns:mc="http://schemas.openxmlformats.org/markup-compatibility/2006">
              <mc:Choice xmlns:a14="http://schemas.microsoft.com/office/drawing/2010/main" Requires="a14">
                <p:sp>
                  <p:nvSpPr>
                    <p:cNvPr id="104" name="TextBox 10">
                      <a:extLst>
                        <a:ext uri="{FF2B5EF4-FFF2-40B4-BE49-F238E27FC236}">
                          <a16:creationId xmlns:a16="http://schemas.microsoft.com/office/drawing/2014/main" id="{E4BB542C-F8A7-C00E-0EF2-D02AD77F5760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987495" y="3234221"/>
                      <a:ext cx="2351696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en-US" sz="1100">
                          <a:latin typeface="Arial"/>
                          <a:ea typeface="Arial" charset="0"/>
                          <a:cs typeface="Arial"/>
                        </a:rPr>
                        <a:t> Probability of rejecting H</a:t>
                      </a:r>
                      <a:r>
                        <a:rPr lang="en-US" sz="1100" baseline="-25000">
                          <a:latin typeface="Arial"/>
                          <a:ea typeface="Arial" charset="0"/>
                          <a:cs typeface="Arial"/>
                        </a:rPr>
                        <a:t>0</a:t>
                      </a:r>
                      <a:r>
                        <a:rPr lang="en-US" sz="1100">
                          <a:latin typeface="Arial"/>
                          <a:ea typeface="Arial" charset="0"/>
                          <a:cs typeface="Arial"/>
                        </a:rPr>
                        <a:t> (1 - </a:t>
                      </a:r>
                      <a14:m>
                        <m:oMath xmlns:m="http://schemas.openxmlformats.org/officeDocument/2006/math">
                          <m:r>
                            <a:rPr lang="en-US" sz="1100" i="1">
                              <a:latin typeface="Cambria Math" panose="02040503050406030204" pitchFamily="18" charset="0"/>
                              <a:ea typeface="Cambria Math" panose="02040503050406030204" pitchFamily="18" charset="0"/>
                              <a:cs typeface="Arial"/>
                            </a:rPr>
                            <m:t>𝛽</m:t>
                          </m:r>
                        </m:oMath>
                      </a14:m>
                      <a:r>
                        <a:rPr lang="en-US" sz="1100">
                          <a:latin typeface="Arial"/>
                          <a:ea typeface="Arial" charset="0"/>
                          <a:cs typeface="Arial"/>
                        </a:rPr>
                        <a:t>)</a:t>
                      </a:r>
                    </a:p>
                  </p:txBody>
                </p:sp>
              </mc:Choice>
              <mc:Fallback>
                <p:sp>
                  <p:nvSpPr>
                    <p:cNvPr id="104" name="TextBox 10">
                      <a:extLst>
                        <a:ext uri="{FF2B5EF4-FFF2-40B4-BE49-F238E27FC236}">
                          <a16:creationId xmlns:a16="http://schemas.microsoft.com/office/drawing/2014/main" id="{E4BB542C-F8A7-C00E-0EF2-D02AD77F5760}"/>
                        </a:ext>
                      </a:extLst>
                    </p:cNvPr>
                    <p:cNvSpPr txBox="1">
                      <a:spLocks noRot="1" noChangeAspect="1" noMove="1" noResize="1" noEditPoints="1" noAdjustHandles="1" noChangeArrowheads="1" noChangeShapeType="1" noTextEdit="1"/>
                    </p:cNvSpPr>
                    <p:nvPr/>
                  </p:nvSpPr>
                  <p:spPr>
                    <a:xfrm rot="16200000">
                      <a:off x="2987495" y="3234221"/>
                      <a:ext cx="2351696" cy="261610"/>
                    </a:xfrm>
                    <a:prstGeom prst="rect">
                      <a:avLst/>
                    </a:prstGeom>
                    <a:blipFill>
                      <a:blip r:embed="rId3"/>
                      <a:stretch>
                        <a:fillRect l="-2381" r="-16667"/>
                      </a:stretch>
                    </a:blipFill>
                  </p:spPr>
                  <p:txBody>
                    <a:bodyPr/>
                    <a:lstStyle/>
                    <a:p>
                      <a:r>
                        <a:rPr lang="en-US">
                          <a:noFill/>
                        </a:rPr>
                        <a:t> </a:t>
                      </a:r>
                    </a:p>
                  </p:txBody>
                </p:sp>
              </mc:Fallback>
            </mc:AlternateContent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BA6D7284-626D-E9AE-B6FB-2104210F8C68}"/>
                  </a:ext>
                </a:extLst>
              </p:cNvPr>
              <p:cNvGrpSpPr/>
              <p:nvPr/>
            </p:nvGrpSpPr>
            <p:grpSpPr>
              <a:xfrm>
                <a:off x="3312495" y="1029312"/>
                <a:ext cx="2570897" cy="3228216"/>
                <a:chOff x="1440626" y="1874138"/>
                <a:chExt cx="2570897" cy="3228216"/>
              </a:xfrm>
            </p:grpSpPr>
            <p:pic>
              <p:nvPicPr>
                <p:cNvPr id="11" name="Picture 10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303B9EBA-BDF9-9442-C07A-A6AEDD3B10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alphaModFix/>
                </a:blip>
                <a:srcRect l="14263"/>
                <a:stretch/>
              </p:blipFill>
              <p:spPr>
                <a:xfrm>
                  <a:off x="2085791" y="2121204"/>
                  <a:ext cx="1812568" cy="2261233"/>
                </a:xfrm>
                <a:prstGeom prst="rect">
                  <a:avLst/>
                </a:prstGeom>
              </p:spPr>
            </p:pic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847FAE20-2F48-32D4-A3B1-36B135FE6D7B}"/>
                    </a:ext>
                  </a:extLst>
                </p:cNvPr>
                <p:cNvGrpSpPr/>
                <p:nvPr/>
              </p:nvGrpSpPr>
              <p:grpSpPr>
                <a:xfrm>
                  <a:off x="1440626" y="1874138"/>
                  <a:ext cx="2570897" cy="3228216"/>
                  <a:chOff x="1440626" y="1874138"/>
                  <a:chExt cx="2570897" cy="3228216"/>
                </a:xfrm>
              </p:grpSpPr>
              <p:sp>
                <p:nvSpPr>
                  <p:cNvPr id="16" name="TextBox 26">
                    <a:extLst>
                      <a:ext uri="{FF2B5EF4-FFF2-40B4-BE49-F238E27FC236}">
                        <a16:creationId xmlns:a16="http://schemas.microsoft.com/office/drawing/2014/main" id="{09B6987C-496D-B33B-8F3C-5E069B5A7F9E}"/>
                      </a:ext>
                    </a:extLst>
                  </p:cNvPr>
                  <p:cNvSpPr txBox="1"/>
                  <p:nvPr/>
                </p:nvSpPr>
                <p:spPr>
                  <a:xfrm>
                    <a:off x="1468537" y="1902232"/>
                    <a:ext cx="2487168" cy="3090672"/>
                  </a:xfrm>
                  <a:prstGeom prst="rect">
                    <a:avLst/>
                  </a:prstGeom>
                  <a:noFill/>
                  <a:ln w="12700" cmpd="sng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endParaRPr lang="en-US"/>
                  </a:p>
                </p:txBody>
              </p:sp>
              <p:sp>
                <p:nvSpPr>
                  <p:cNvPr id="17" name="TextBox 27">
                    <a:extLst>
                      <a:ext uri="{FF2B5EF4-FFF2-40B4-BE49-F238E27FC236}">
                        <a16:creationId xmlns:a16="http://schemas.microsoft.com/office/drawing/2014/main" id="{D0702D34-7D39-7E98-DB17-128A1DAAED1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84681" y="3105409"/>
                    <a:ext cx="2055239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1100" i="1">
                        <a:latin typeface="Arial"/>
                        <a:cs typeface="Arial"/>
                      </a:rPr>
                      <a:t>wsp</a:t>
                    </a:r>
                    <a:r>
                      <a:rPr lang="en-US" sz="1100">
                        <a:latin typeface="Arial"/>
                        <a:cs typeface="Arial"/>
                      </a:rPr>
                      <a:t> copy #</a:t>
                    </a:r>
                  </a:p>
                </p:txBody>
              </p:sp>
              <p:sp>
                <p:nvSpPr>
                  <p:cNvPr id="19" name="TextBox 28">
                    <a:extLst>
                      <a:ext uri="{FF2B5EF4-FFF2-40B4-BE49-F238E27FC236}">
                        <a16:creationId xmlns:a16="http://schemas.microsoft.com/office/drawing/2014/main" id="{0E5F7868-6CA0-59FA-04B1-E16426D6461B}"/>
                      </a:ext>
                    </a:extLst>
                  </p:cNvPr>
                  <p:cNvSpPr txBox="1"/>
                  <p:nvPr/>
                </p:nvSpPr>
                <p:spPr>
                  <a:xfrm>
                    <a:off x="1440626" y="1874138"/>
                    <a:ext cx="30489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400">
                        <a:latin typeface="Arial"/>
                        <a:cs typeface="Arial"/>
                      </a:rPr>
                      <a:t>A</a:t>
                    </a:r>
                  </a:p>
                </p:txBody>
              </p:sp>
              <p:sp>
                <p:nvSpPr>
                  <p:cNvPr id="93" name="TextBox 50">
                    <a:extLst>
                      <a:ext uri="{FF2B5EF4-FFF2-40B4-BE49-F238E27FC236}">
                        <a16:creationId xmlns:a16="http://schemas.microsoft.com/office/drawing/2014/main" id="{84EF83F8-3B79-822D-9C24-93DF3F9279F2}"/>
                      </a:ext>
                    </a:extLst>
                  </p:cNvPr>
                  <p:cNvSpPr txBox="1"/>
                  <p:nvPr/>
                </p:nvSpPr>
                <p:spPr>
                  <a:xfrm>
                    <a:off x="1777168" y="4180908"/>
                    <a:ext cx="41739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/>
                    <a:r>
                      <a:rPr lang="en-US" sz="1000"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rPr>
                      <a:t>0 -</a:t>
                    </a:r>
                  </a:p>
                </p:txBody>
              </p:sp>
              <p:sp>
                <p:nvSpPr>
                  <p:cNvPr id="25" name="TextBox 30">
                    <a:extLst>
                      <a:ext uri="{FF2B5EF4-FFF2-40B4-BE49-F238E27FC236}">
                        <a16:creationId xmlns:a16="http://schemas.microsoft.com/office/drawing/2014/main" id="{1837A272-7A56-0146-2BA1-F4177CFB6451}"/>
                      </a:ext>
                    </a:extLst>
                  </p:cNvPr>
                  <p:cNvSpPr txBox="1"/>
                  <p:nvPr/>
                </p:nvSpPr>
                <p:spPr>
                  <a:xfrm rot="3582193">
                    <a:off x="2403603" y="4533153"/>
                    <a:ext cx="88036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0">
                        <a:latin typeface="Arial"/>
                        <a:cs typeface="Arial"/>
                      </a:rPr>
                      <a:t>mifepristone</a:t>
                    </a:r>
                  </a:p>
                </p:txBody>
              </p:sp>
              <p:sp>
                <p:nvSpPr>
                  <p:cNvPr id="28" name="TextBox 31">
                    <a:extLst>
                      <a:ext uri="{FF2B5EF4-FFF2-40B4-BE49-F238E27FC236}">
                        <a16:creationId xmlns:a16="http://schemas.microsoft.com/office/drawing/2014/main" id="{B1D0C04E-3B9C-55FE-8421-8567D856EF56}"/>
                      </a:ext>
                    </a:extLst>
                  </p:cNvPr>
                  <p:cNvSpPr txBox="1"/>
                  <p:nvPr/>
                </p:nvSpPr>
                <p:spPr>
                  <a:xfrm rot="3582193">
                    <a:off x="3284019" y="4539059"/>
                    <a:ext cx="88036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0">
                        <a:latin typeface="Arial"/>
                        <a:cs typeface="Arial"/>
                      </a:rPr>
                      <a:t>mifepristone</a:t>
                    </a:r>
                  </a:p>
                </p:txBody>
              </p:sp>
              <p:sp>
                <p:nvSpPr>
                  <p:cNvPr id="42" name="TextBox 32">
                    <a:extLst>
                      <a:ext uri="{FF2B5EF4-FFF2-40B4-BE49-F238E27FC236}">
                        <a16:creationId xmlns:a16="http://schemas.microsoft.com/office/drawing/2014/main" id="{6269C562-A05E-5B8D-3D4A-2610387ACB21}"/>
                      </a:ext>
                    </a:extLst>
                  </p:cNvPr>
                  <p:cNvSpPr txBox="1"/>
                  <p:nvPr/>
                </p:nvSpPr>
                <p:spPr>
                  <a:xfrm rot="3582193">
                    <a:off x="2152934" y="4396648"/>
                    <a:ext cx="5693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0">
                        <a:latin typeface="Arial"/>
                        <a:cs typeface="Arial"/>
                      </a:rPr>
                      <a:t>DMSO</a:t>
                    </a:r>
                  </a:p>
                </p:txBody>
              </p:sp>
              <p:sp>
                <p:nvSpPr>
                  <p:cNvPr id="60" name="TextBox 33">
                    <a:extLst>
                      <a:ext uri="{FF2B5EF4-FFF2-40B4-BE49-F238E27FC236}">
                        <a16:creationId xmlns:a16="http://schemas.microsoft.com/office/drawing/2014/main" id="{0A0A78FB-E380-D463-C786-5F2BB9AABC45}"/>
                      </a:ext>
                    </a:extLst>
                  </p:cNvPr>
                  <p:cNvSpPr txBox="1"/>
                  <p:nvPr/>
                </p:nvSpPr>
                <p:spPr>
                  <a:xfrm rot="3582193">
                    <a:off x="3037642" y="4400193"/>
                    <a:ext cx="5693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0">
                        <a:latin typeface="Arial"/>
                        <a:cs typeface="Arial"/>
                      </a:rPr>
                      <a:t>DMSO</a:t>
                    </a:r>
                  </a:p>
                </p:txBody>
              </p:sp>
              <p:sp>
                <p:nvSpPr>
                  <p:cNvPr id="61" name="TextBox 34">
                    <a:extLst>
                      <a:ext uri="{FF2B5EF4-FFF2-40B4-BE49-F238E27FC236}">
                        <a16:creationId xmlns:a16="http://schemas.microsoft.com/office/drawing/2014/main" id="{C7C20C50-53D8-7B42-93D5-AC6FBCCDE302}"/>
                      </a:ext>
                    </a:extLst>
                  </p:cNvPr>
                  <p:cNvSpPr txBox="1"/>
                  <p:nvPr/>
                </p:nvSpPr>
                <p:spPr>
                  <a:xfrm>
                    <a:off x="2056683" y="2191018"/>
                    <a:ext cx="180226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800">
                        <a:latin typeface="Arial"/>
                        <a:cs typeface="Arial"/>
                      </a:rPr>
                      <a:t>n=  18       18              18       18             </a:t>
                    </a:r>
                  </a:p>
                </p:txBody>
              </p:sp>
              <p:grpSp>
                <p:nvGrpSpPr>
                  <p:cNvPr id="62" name="Group 61">
                    <a:extLst>
                      <a:ext uri="{FF2B5EF4-FFF2-40B4-BE49-F238E27FC236}">
                        <a16:creationId xmlns:a16="http://schemas.microsoft.com/office/drawing/2014/main" id="{0A0DDA90-D5B6-18DE-2660-67B45CD9A49E}"/>
                      </a:ext>
                    </a:extLst>
                  </p:cNvPr>
                  <p:cNvGrpSpPr/>
                  <p:nvPr/>
                </p:nvGrpSpPr>
                <p:grpSpPr>
                  <a:xfrm>
                    <a:off x="2373889" y="2377417"/>
                    <a:ext cx="365760" cy="264013"/>
                    <a:chOff x="2373889" y="2377417"/>
                    <a:chExt cx="365760" cy="264013"/>
                  </a:xfrm>
                </p:grpSpPr>
                <p:sp>
                  <p:nvSpPr>
                    <p:cNvPr id="72" name="Left Bracket 71">
                      <a:extLst>
                        <a:ext uri="{FF2B5EF4-FFF2-40B4-BE49-F238E27FC236}">
                          <a16:creationId xmlns:a16="http://schemas.microsoft.com/office/drawing/2014/main" id="{C2987138-8F87-59CC-A2DF-0558493D6B27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2517440" y="2355293"/>
                      <a:ext cx="78658" cy="365760"/>
                    </a:xfrm>
                    <a:prstGeom prst="leftBracket">
                      <a:avLst/>
                    </a:prstGeom>
                    <a:ln w="952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grpSp>
                  <p:nvGrpSpPr>
                    <p:cNvPr id="73" name="Group 72">
                      <a:extLst>
                        <a:ext uri="{FF2B5EF4-FFF2-40B4-BE49-F238E27FC236}">
                          <a16:creationId xmlns:a16="http://schemas.microsoft.com/office/drawing/2014/main" id="{9A529C47-CF28-F762-23ED-0938D8B4248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428239" y="2377417"/>
                      <a:ext cx="218341" cy="264013"/>
                      <a:chOff x="2428239" y="2377417"/>
                      <a:chExt cx="218341" cy="264013"/>
                    </a:xfrm>
                  </p:grpSpPr>
                  <p:sp>
                    <p:nvSpPr>
                      <p:cNvPr id="74" name="TextBox 46">
                        <a:extLst>
                          <a:ext uri="{FF2B5EF4-FFF2-40B4-BE49-F238E27FC236}">
                            <a16:creationId xmlns:a16="http://schemas.microsoft.com/office/drawing/2014/main" id="{EFF17CD4-9606-B189-F219-EA7A8F2ACCB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95533" y="2424199"/>
                        <a:ext cx="113815" cy="16260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endParaRPr lang="en-US"/>
                      </a:p>
                    </p:txBody>
                  </p:sp>
                  <p:sp>
                    <p:nvSpPr>
                      <p:cNvPr id="75" name="TextBox 47">
                        <a:extLst>
                          <a:ext uri="{FF2B5EF4-FFF2-40B4-BE49-F238E27FC236}">
                            <a16:creationId xmlns:a16="http://schemas.microsoft.com/office/drawing/2014/main" id="{E31E43CF-6D3C-E332-72D6-7F8FF709D30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28239" y="2377417"/>
                        <a:ext cx="218341" cy="264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r>
                          <a:rPr lang="en-US" sz="1400">
                            <a:latin typeface="Arial"/>
                            <a:cs typeface="Arial"/>
                          </a:rPr>
                          <a:t>*</a:t>
                        </a:r>
                      </a:p>
                    </p:txBody>
                  </p:sp>
                </p:grpSp>
              </p:grpSp>
              <p:grpSp>
                <p:nvGrpSpPr>
                  <p:cNvPr id="63" name="Group 62">
                    <a:extLst>
                      <a:ext uri="{FF2B5EF4-FFF2-40B4-BE49-F238E27FC236}">
                        <a16:creationId xmlns:a16="http://schemas.microsoft.com/office/drawing/2014/main" id="{6D6EA85D-0710-A7F3-348C-C2EE70542C99}"/>
                      </a:ext>
                    </a:extLst>
                  </p:cNvPr>
                  <p:cNvGrpSpPr/>
                  <p:nvPr/>
                </p:nvGrpSpPr>
                <p:grpSpPr>
                  <a:xfrm>
                    <a:off x="3190524" y="2375504"/>
                    <a:ext cx="365760" cy="264013"/>
                    <a:chOff x="3190524" y="2375504"/>
                    <a:chExt cx="365760" cy="264013"/>
                  </a:xfrm>
                </p:grpSpPr>
                <p:sp>
                  <p:nvSpPr>
                    <p:cNvPr id="68" name="Left Bracket 67">
                      <a:extLst>
                        <a:ext uri="{FF2B5EF4-FFF2-40B4-BE49-F238E27FC236}">
                          <a16:creationId xmlns:a16="http://schemas.microsoft.com/office/drawing/2014/main" id="{502C93D2-8DF4-D3EA-95D6-F6E89796E82D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3334075" y="2353380"/>
                      <a:ext cx="78658" cy="365760"/>
                    </a:xfrm>
                    <a:prstGeom prst="leftBracket">
                      <a:avLst/>
                    </a:prstGeom>
                    <a:ln w="952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>
                      <a:defPPr>
                        <a:defRPr lang="en-US"/>
                      </a:defPPr>
                      <a:lvl1pPr marL="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endParaRPr lang="en-US"/>
                    </a:p>
                  </p:txBody>
                </p:sp>
                <p:grpSp>
                  <p:nvGrpSpPr>
                    <p:cNvPr id="69" name="Group 68">
                      <a:extLst>
                        <a:ext uri="{FF2B5EF4-FFF2-40B4-BE49-F238E27FC236}">
                          <a16:creationId xmlns:a16="http://schemas.microsoft.com/office/drawing/2014/main" id="{27E8902E-E852-AD40-75A4-D70428CD390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244874" y="2375504"/>
                      <a:ext cx="218341" cy="264013"/>
                      <a:chOff x="3244874" y="2375504"/>
                      <a:chExt cx="218341" cy="264013"/>
                    </a:xfrm>
                  </p:grpSpPr>
                  <p:sp>
                    <p:nvSpPr>
                      <p:cNvPr id="70" name="TextBox 42">
                        <a:extLst>
                          <a:ext uri="{FF2B5EF4-FFF2-40B4-BE49-F238E27FC236}">
                            <a16:creationId xmlns:a16="http://schemas.microsoft.com/office/drawing/2014/main" id="{DE66FBC9-AA66-9023-F8F7-4B4159FAB59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312168" y="2422286"/>
                        <a:ext cx="113815" cy="16260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endParaRPr lang="en-US"/>
                      </a:p>
                    </p:txBody>
                  </p:sp>
                  <p:sp>
                    <p:nvSpPr>
                      <p:cNvPr id="71" name="TextBox 43">
                        <a:extLst>
                          <a:ext uri="{FF2B5EF4-FFF2-40B4-BE49-F238E27FC236}">
                            <a16:creationId xmlns:a16="http://schemas.microsoft.com/office/drawing/2014/main" id="{F08E3C50-F219-C5AE-D448-64713439770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44874" y="2375504"/>
                        <a:ext cx="218341" cy="264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r>
                          <a:rPr lang="en-US" sz="1400">
                            <a:latin typeface="Arial"/>
                            <a:cs typeface="Arial"/>
                          </a:rPr>
                          <a:t>*</a:t>
                        </a:r>
                      </a:p>
                    </p:txBody>
                  </p:sp>
                </p:grpSp>
              </p:grpSp>
              <p:sp>
                <p:nvSpPr>
                  <p:cNvPr id="67" name="TextBox 39">
                    <a:extLst>
                      <a:ext uri="{FF2B5EF4-FFF2-40B4-BE49-F238E27FC236}">
                        <a16:creationId xmlns:a16="http://schemas.microsoft.com/office/drawing/2014/main" id="{1D3177F4-BA01-4A5C-0899-D0DC1FCF6AAC}"/>
                      </a:ext>
                    </a:extLst>
                  </p:cNvPr>
                  <p:cNvSpPr txBox="1"/>
                  <p:nvPr/>
                </p:nvSpPr>
                <p:spPr>
                  <a:xfrm>
                    <a:off x="1845225" y="1910801"/>
                    <a:ext cx="216629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1100">
                        <a:latin typeface="Arial"/>
                        <a:cs typeface="Arial"/>
                      </a:rPr>
                      <a:t>Whole-body</a:t>
                    </a:r>
                    <a:r>
                      <a:rPr lang="en-US" sz="1100" i="1">
                        <a:latin typeface="Arial"/>
                        <a:cs typeface="Arial"/>
                      </a:rPr>
                      <a:t> </a:t>
                    </a:r>
                    <a:r>
                      <a:rPr lang="en-US" sz="1100" i="1" err="1">
                        <a:latin typeface="Arial"/>
                        <a:cs typeface="Arial"/>
                      </a:rPr>
                      <a:t>wsp</a:t>
                    </a:r>
                    <a:r>
                      <a:rPr lang="en-US" sz="1100" i="1">
                        <a:latin typeface="Arial"/>
                        <a:cs typeface="Arial"/>
                      </a:rPr>
                      <a:t>: </a:t>
                    </a:r>
                    <a:r>
                      <a:rPr lang="en-US" sz="1100">
                        <a:latin typeface="Arial"/>
                        <a:cs typeface="Arial"/>
                      </a:rPr>
                      <a:t>mifepristone</a:t>
                    </a:r>
                  </a:p>
                </p:txBody>
              </p:sp>
            </p:grpSp>
          </p:grp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34DA111-F84F-D436-6DF5-2A9B7C0837FF}"/>
                </a:ext>
              </a:extLst>
            </p:cNvPr>
            <p:cNvSpPr txBox="1"/>
            <p:nvPr/>
          </p:nvSpPr>
          <p:spPr>
            <a:xfrm>
              <a:off x="3478970" y="1211508"/>
              <a:ext cx="813374" cy="2051524"/>
            </a:xfrm>
            <a:prstGeom prst="rect">
              <a:avLst/>
            </a:prstGeom>
            <a:noFill/>
          </p:spPr>
          <p:txBody>
            <a:bodyPr wrap="square" spcCol="548640" rtlCol="0">
              <a:spAutoFit/>
            </a:bodyPr>
            <a:lstStyle/>
            <a:p>
              <a:pPr>
                <a:lnSpc>
                  <a:spcPts val="1350"/>
                </a:lnSpc>
              </a:pPr>
              <a:r>
                <a:rPr lang="en-US" sz="1000"/>
                <a:t>2.0 e</a:t>
              </a:r>
              <a:r>
                <a:rPr lang="en-US" sz="1000" baseline="30000"/>
                <a:t>7</a:t>
              </a:r>
              <a:r>
                <a:rPr lang="en-US" sz="1000"/>
                <a:t> -</a:t>
              </a:r>
              <a:endParaRPr lang="en-US" sz="1000" baseline="30000"/>
            </a:p>
            <a:p>
              <a:pPr>
                <a:lnSpc>
                  <a:spcPts val="1350"/>
                </a:lnSpc>
              </a:pPr>
              <a:endParaRPr lang="en-US" sz="1000"/>
            </a:p>
            <a:p>
              <a:pPr>
                <a:lnSpc>
                  <a:spcPts val="1350"/>
                </a:lnSpc>
              </a:pPr>
              <a:endParaRPr lang="en-US" sz="1000"/>
            </a:p>
            <a:p>
              <a:pPr>
                <a:lnSpc>
                  <a:spcPts val="1350"/>
                </a:lnSpc>
              </a:pPr>
              <a:r>
                <a:rPr lang="en-US" sz="1000"/>
                <a:t>1.5 e</a:t>
              </a:r>
              <a:r>
                <a:rPr lang="en-US" sz="1000" baseline="30000"/>
                <a:t>7</a:t>
              </a:r>
              <a:r>
                <a:rPr lang="en-US" sz="1000"/>
                <a:t> -</a:t>
              </a:r>
              <a:endParaRPr lang="en-US" sz="1000" baseline="30000"/>
            </a:p>
            <a:p>
              <a:pPr>
                <a:lnSpc>
                  <a:spcPts val="1350"/>
                </a:lnSpc>
              </a:pPr>
              <a:endParaRPr lang="en-US" sz="1000" baseline="30000"/>
            </a:p>
            <a:p>
              <a:pPr>
                <a:lnSpc>
                  <a:spcPts val="1350"/>
                </a:lnSpc>
              </a:pPr>
              <a:endParaRPr lang="en-US" sz="1000"/>
            </a:p>
            <a:p>
              <a:pPr>
                <a:lnSpc>
                  <a:spcPts val="1350"/>
                </a:lnSpc>
              </a:pPr>
              <a:r>
                <a:rPr lang="en-US" sz="1000"/>
                <a:t>1.0 e</a:t>
              </a:r>
              <a:r>
                <a:rPr lang="en-US" sz="1000" baseline="30000"/>
                <a:t>7</a:t>
              </a:r>
              <a:r>
                <a:rPr lang="en-US" sz="1000"/>
                <a:t> -</a:t>
              </a:r>
              <a:endParaRPr lang="en-US" sz="1000" baseline="30000"/>
            </a:p>
            <a:p>
              <a:pPr>
                <a:lnSpc>
                  <a:spcPts val="1350"/>
                </a:lnSpc>
              </a:pPr>
              <a:endParaRPr lang="en-US" sz="1000"/>
            </a:p>
            <a:p>
              <a:pPr>
                <a:lnSpc>
                  <a:spcPts val="1350"/>
                </a:lnSpc>
              </a:pPr>
              <a:endParaRPr lang="en-US" sz="1000"/>
            </a:p>
            <a:p>
              <a:pPr>
                <a:lnSpc>
                  <a:spcPts val="1350"/>
                </a:lnSpc>
              </a:pPr>
              <a:r>
                <a:rPr lang="en-US" sz="1000"/>
                <a:t>5.0 e</a:t>
              </a:r>
              <a:r>
                <a:rPr lang="en-US" sz="1000" baseline="30000"/>
                <a:t>6</a:t>
              </a:r>
              <a:r>
                <a:rPr lang="en-US" sz="1000"/>
                <a:t> -</a:t>
              </a:r>
            </a:p>
            <a:p>
              <a:pPr>
                <a:lnSpc>
                  <a:spcPts val="1350"/>
                </a:lnSpc>
              </a:pPr>
              <a:r>
                <a:rPr lang="en-US" sz="1000"/>
                <a:t> </a:t>
              </a:r>
              <a:endParaRPr lang="en-US" sz="1000" baseline="30000"/>
            </a:p>
          </p:txBody>
        </p:sp>
      </p:grpSp>
    </p:spTree>
    <p:extLst>
      <p:ext uri="{BB962C8B-B14F-4D97-AF65-F5344CB8AC3E}">
        <p14:creationId xmlns:p14="http://schemas.microsoft.com/office/powerpoint/2010/main" val="1756382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Application>Microsoft Office PowerPoint</Application>
  <PresentationFormat>Widescreen</PresentationFormat>
  <Slides>2</Slides>
  <Notes>1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Laura Ochoa</dc:creator>
  <cp:keywords/>
  <dc:description/>
  <cp:revision>1</cp:revision>
  <dcterms:created xsi:type="dcterms:W3CDTF">2023-12-14T00:31:33Z</dcterms:created>
  <dcterms:modified xsi:type="dcterms:W3CDTF">2023-12-19T02:58:18Z</dcterms:modified>
  <cp:category/>
</cp:coreProperties>
</file>